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  <p:sldMasterId id="2147483660" r:id="rId2"/>
    <p:sldMasterId id="2147483732" r:id="rId3"/>
  </p:sldMasterIdLst>
  <p:notesMasterIdLst>
    <p:notesMasterId r:id="rId13"/>
  </p:notesMasterIdLst>
  <p:sldIdLst>
    <p:sldId id="257" r:id="rId4"/>
    <p:sldId id="261" r:id="rId5"/>
    <p:sldId id="1811" r:id="rId6"/>
    <p:sldId id="1809" r:id="rId7"/>
    <p:sldId id="1806" r:id="rId8"/>
    <p:sldId id="263" r:id="rId9"/>
    <p:sldId id="264" r:id="rId10"/>
    <p:sldId id="1807" r:id="rId11"/>
    <p:sldId id="1813" r:id="rId12"/>
  </p:sldIdLst>
  <p:sldSz cx="9144000" cy="7315200"/>
  <p:notesSz cx="68580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52" userDrawn="1">
          <p15:clr>
            <a:srgbClr val="A4A3A4"/>
          </p15:clr>
        </p15:guide>
        <p15:guide id="2" pos="319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6132"/>
  </p:normalViewPr>
  <p:slideViewPr>
    <p:cSldViewPr snapToGrid="0" snapToObjects="1" showGuides="1">
      <p:cViewPr varScale="1">
        <p:scale>
          <a:sx n="93" d="100"/>
          <a:sy n="93" d="100"/>
        </p:scale>
        <p:origin x="426" y="78"/>
      </p:cViewPr>
      <p:guideLst>
        <p:guide orient="horz" pos="4152"/>
        <p:guide pos="319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notesMaster" Target="notesMasters/notesMaster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5" Type="http://schemas.openxmlformats.org/officeDocument/2006/relationships/slide" Target="slides/slide2.xml"/><Relationship Id="rId15" Type="http://schemas.openxmlformats.org/officeDocument/2006/relationships/viewProps" Target="view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9D1885-5B48-4876-B258-66C764D1682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79550" y="1154113"/>
            <a:ext cx="3898900" cy="31178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45000"/>
            <a:ext cx="5486400" cy="36369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525"/>
            <a:ext cx="2971800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772525"/>
            <a:ext cx="2971800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69C7E3-DA37-45B3-847F-7A32FDC897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208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544638" y="1162050"/>
            <a:ext cx="39211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6BDF09-B30E-4734-90A9-1414F9AF441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723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97187"/>
            <a:ext cx="7772400" cy="254677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842174"/>
            <a:ext cx="6858000" cy="1766146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772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163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89467"/>
            <a:ext cx="1971675" cy="61992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89467"/>
            <a:ext cx="5800725" cy="619929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68479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69C9E-62E5-4784-ABA8-5B4D93D42B64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C22B9-E797-4D80-9F68-3FFE71611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4544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2D774-4008-4F47-A137-3E7661B8AE96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E55A-83DA-C543-B4B7-9B56F5735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82890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2D774-4008-4F47-A137-3E7661B8AE96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E55A-83DA-C543-B4B7-9B56F5735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596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77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823722"/>
            <a:ext cx="7886700" cy="304291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895429"/>
            <a:ext cx="7886700" cy="16001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798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947333"/>
            <a:ext cx="3886200" cy="46414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947333"/>
            <a:ext cx="3886200" cy="46414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82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89468"/>
            <a:ext cx="7886700" cy="14139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793241"/>
            <a:ext cx="3868340" cy="87883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672080"/>
            <a:ext cx="3868340" cy="39302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793241"/>
            <a:ext cx="3887391" cy="87883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672080"/>
            <a:ext cx="3887391" cy="39302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748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481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683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87680"/>
            <a:ext cx="2949178" cy="17068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053255"/>
            <a:ext cx="4629150" cy="519853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194560"/>
            <a:ext cx="2949178" cy="406569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244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87680"/>
            <a:ext cx="2949178" cy="17068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053255"/>
            <a:ext cx="4629150" cy="5198533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194560"/>
            <a:ext cx="2949178" cy="4065694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25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2" Type="http://schemas.openxmlformats.org/officeDocument/2006/relationships/theme" Target="../theme/theme2.xml"/><Relationship Id="rId1" Type="http://schemas.openxmlformats.org/officeDocument/2006/relationships/slideLayout" Target="../slideLayouts/slideLayout12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theme" Target="../theme/theme3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89468"/>
            <a:ext cx="7886700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947333"/>
            <a:ext cx="7886700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780108"/>
            <a:ext cx="20574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FEE5B0-0CC3-DA4E-8ECA-5747D7C3AC87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780108"/>
            <a:ext cx="30861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780108"/>
            <a:ext cx="20574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296CF-481E-3F44-8717-D91EBFED9C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612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89468"/>
            <a:ext cx="7886700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947333"/>
            <a:ext cx="7886700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780108"/>
            <a:ext cx="20574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69C9E-62E5-4784-ABA8-5B4D93D42B64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780108"/>
            <a:ext cx="30861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780108"/>
            <a:ext cx="20574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C22B9-E797-4D80-9F68-3FFE716117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293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89468"/>
            <a:ext cx="7886700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947334"/>
            <a:ext cx="7886700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780109"/>
            <a:ext cx="20574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2D774-4008-4F47-A137-3E7661B8AE96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780109"/>
            <a:ext cx="30861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780109"/>
            <a:ext cx="20574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0E55A-83DA-C543-B4B7-9B56F5735C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400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9" r:id="rId1"/>
    <p:sldLayoutId id="2147483738" r:id="rId2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ti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11" Type="http://schemas.openxmlformats.org/officeDocument/2006/relationships/image" Target="../media/image11.ti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tif"/><Relationship Id="rId4" Type="http://schemas.openxmlformats.org/officeDocument/2006/relationships/image" Target="../media/image4.tif"/><Relationship Id="rId9" Type="http://schemas.openxmlformats.org/officeDocument/2006/relationships/image" Target="../media/image9.tif"/><Relationship Id="rId14" Type="http://schemas.openxmlformats.org/officeDocument/2006/relationships/image" Target="../media/image1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Relationship Id="rId9" Type="http://schemas.openxmlformats.org/officeDocument/2006/relationships/image" Target="../media/image2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emf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emf"/><Relationship Id="rId13" Type="http://schemas.openxmlformats.org/officeDocument/2006/relationships/image" Target="../media/image42.emf"/><Relationship Id="rId3" Type="http://schemas.openxmlformats.org/officeDocument/2006/relationships/image" Target="../media/image32.emf"/><Relationship Id="rId7" Type="http://schemas.openxmlformats.org/officeDocument/2006/relationships/image" Target="../media/image36.emf"/><Relationship Id="rId12" Type="http://schemas.openxmlformats.org/officeDocument/2006/relationships/image" Target="../media/image41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emf"/><Relationship Id="rId11" Type="http://schemas.openxmlformats.org/officeDocument/2006/relationships/image" Target="../media/image40.emf"/><Relationship Id="rId5" Type="http://schemas.openxmlformats.org/officeDocument/2006/relationships/image" Target="../media/image34.emf"/><Relationship Id="rId10" Type="http://schemas.openxmlformats.org/officeDocument/2006/relationships/image" Target="../media/image39.emf"/><Relationship Id="rId4" Type="http://schemas.openxmlformats.org/officeDocument/2006/relationships/image" Target="../media/image33.emf"/><Relationship Id="rId9" Type="http://schemas.openxmlformats.org/officeDocument/2006/relationships/image" Target="../media/image38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1661106-37B0-DF4F-8997-319BF30AE7E0}"/>
              </a:ext>
            </a:extLst>
          </p:cNvPr>
          <p:cNvSpPr txBox="1"/>
          <p:nvPr/>
        </p:nvSpPr>
        <p:spPr>
          <a:xfrm>
            <a:off x="123891" y="114300"/>
            <a:ext cx="18734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C7C4022-605F-FDA2-A5A0-B1264027E105}"/>
              </a:ext>
            </a:extLst>
          </p:cNvPr>
          <p:cNvGrpSpPr/>
          <p:nvPr/>
        </p:nvGrpSpPr>
        <p:grpSpPr>
          <a:xfrm>
            <a:off x="445643" y="1049733"/>
            <a:ext cx="7812652" cy="4839917"/>
            <a:chOff x="445643" y="473263"/>
            <a:chExt cx="7812652" cy="4839917"/>
          </a:xfrm>
        </p:grpSpPr>
        <p:pic>
          <p:nvPicPr>
            <p:cNvPr id="7" name="図 15" descr="スクリーンショットの画面&#10;&#10;自動的に生成された説明">
              <a:extLst>
                <a:ext uri="{FF2B5EF4-FFF2-40B4-BE49-F238E27FC236}">
                  <a16:creationId xmlns:a16="http://schemas.microsoft.com/office/drawing/2014/main" id="{FBBDA430-1680-CA4B-BFAF-462E867560D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084" t="2486" r="24516" b="70048"/>
            <a:stretch/>
          </p:blipFill>
          <p:spPr>
            <a:xfrm>
              <a:off x="875752" y="907514"/>
              <a:ext cx="1371600" cy="1371600"/>
            </a:xfrm>
            <a:prstGeom prst="rect">
              <a:avLst/>
            </a:prstGeom>
          </p:spPr>
        </p:pic>
        <p:pic>
          <p:nvPicPr>
            <p:cNvPr id="8" name="図 15" descr="スクリーンショットの画面&#10;&#10;自動的に生成された説明">
              <a:extLst>
                <a:ext uri="{FF2B5EF4-FFF2-40B4-BE49-F238E27FC236}">
                  <a16:creationId xmlns:a16="http://schemas.microsoft.com/office/drawing/2014/main" id="{C502127F-4762-4243-B429-C1D9E4B7F4A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599" t="2167" r="998" b="69985"/>
            <a:stretch/>
          </p:blipFill>
          <p:spPr>
            <a:xfrm>
              <a:off x="2861069" y="907514"/>
              <a:ext cx="1371600" cy="1371600"/>
            </a:xfrm>
            <a:prstGeom prst="rect">
              <a:avLst/>
            </a:prstGeom>
          </p:spPr>
        </p:pic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5D085014-6B99-9148-B7EF-CECAA1B66AAA}"/>
                </a:ext>
              </a:extLst>
            </p:cNvPr>
            <p:cNvGrpSpPr/>
            <p:nvPr/>
          </p:nvGrpSpPr>
          <p:grpSpPr>
            <a:xfrm>
              <a:off x="588436" y="985156"/>
              <a:ext cx="990951" cy="1275839"/>
              <a:chOff x="588436" y="985156"/>
              <a:chExt cx="990951" cy="1275839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319B7FC7-604E-8440-A5DF-74F83447A669}"/>
                  </a:ext>
                </a:extLst>
              </p:cNvPr>
              <p:cNvSpPr txBox="1"/>
              <p:nvPr/>
            </p:nvSpPr>
            <p:spPr>
              <a:xfrm>
                <a:off x="588436" y="2045551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EF3786E3-3A5A-BD43-95F2-F417FC8AA901}"/>
                  </a:ext>
                </a:extLst>
              </p:cNvPr>
              <p:cNvSpPr txBox="1"/>
              <p:nvPr/>
            </p:nvSpPr>
            <p:spPr>
              <a:xfrm>
                <a:off x="713165" y="1841917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511C1F05-610C-ED44-8C68-2F19E0C799BD}"/>
                  </a:ext>
                </a:extLst>
              </p:cNvPr>
              <p:cNvSpPr txBox="1"/>
              <p:nvPr/>
            </p:nvSpPr>
            <p:spPr>
              <a:xfrm>
                <a:off x="635897" y="1631157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25AB6F3C-CE56-1C4E-91F3-308C11EE4FC0}"/>
                  </a:ext>
                </a:extLst>
              </p:cNvPr>
              <p:cNvSpPr txBox="1"/>
              <p:nvPr/>
            </p:nvSpPr>
            <p:spPr>
              <a:xfrm>
                <a:off x="627366" y="1278980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F875F5E-8C0C-7B48-A110-82BA9299510E}"/>
                  </a:ext>
                </a:extLst>
              </p:cNvPr>
              <p:cNvSpPr txBox="1"/>
              <p:nvPr/>
            </p:nvSpPr>
            <p:spPr>
              <a:xfrm>
                <a:off x="633462" y="985156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41AC2DE0-93F0-1742-ACBF-81FA76A1BA11}"/>
                </a:ext>
              </a:extLst>
            </p:cNvPr>
            <p:cNvGrpSpPr/>
            <p:nvPr/>
          </p:nvGrpSpPr>
          <p:grpSpPr>
            <a:xfrm>
              <a:off x="824227" y="2206213"/>
              <a:ext cx="1599306" cy="227298"/>
              <a:chOff x="824227" y="2206213"/>
              <a:chExt cx="1599306" cy="227298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AD00CC9-3A24-8E4F-812D-CC9F4A54C5C2}"/>
                  </a:ext>
                </a:extLst>
              </p:cNvPr>
              <p:cNvSpPr txBox="1"/>
              <p:nvPr/>
            </p:nvSpPr>
            <p:spPr>
              <a:xfrm>
                <a:off x="1747003" y="2211297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K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961EB009-6702-8F46-970C-40D8DB6858A4}"/>
                  </a:ext>
                </a:extLst>
              </p:cNvPr>
              <p:cNvSpPr txBox="1"/>
              <p:nvPr/>
            </p:nvSpPr>
            <p:spPr>
              <a:xfrm>
                <a:off x="999775" y="2213965"/>
                <a:ext cx="433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3D0E68F-AD46-E74E-978B-067143E15B83}"/>
                  </a:ext>
                </a:extLst>
              </p:cNvPr>
              <p:cNvSpPr txBox="1"/>
              <p:nvPr/>
            </p:nvSpPr>
            <p:spPr>
              <a:xfrm>
                <a:off x="824227" y="2218067"/>
                <a:ext cx="1973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210CF46C-4FD5-D146-8C35-499C581A744E}"/>
                  </a:ext>
                </a:extLst>
              </p:cNvPr>
              <p:cNvSpPr txBox="1"/>
              <p:nvPr/>
            </p:nvSpPr>
            <p:spPr>
              <a:xfrm>
                <a:off x="1224680" y="2213965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K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55C6C855-ED79-5142-A6F6-46E2877B279E}"/>
                  </a:ext>
                </a:extLst>
              </p:cNvPr>
              <p:cNvSpPr txBox="1"/>
              <p:nvPr/>
            </p:nvSpPr>
            <p:spPr>
              <a:xfrm>
                <a:off x="1490224" y="2215450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K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C57693A8-C59F-F345-BB71-C60EA9AAEC46}"/>
                  </a:ext>
                </a:extLst>
              </p:cNvPr>
              <p:cNvSpPr txBox="1"/>
              <p:nvPr/>
            </p:nvSpPr>
            <p:spPr>
              <a:xfrm>
                <a:off x="1997377" y="2206213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0K</a:t>
                </a:r>
              </a:p>
            </p:txBody>
          </p:sp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D757424-1629-404D-BF72-E5C068AE0AF4}"/>
                </a:ext>
              </a:extLst>
            </p:cNvPr>
            <p:cNvSpPr txBox="1"/>
            <p:nvPr/>
          </p:nvSpPr>
          <p:spPr>
            <a:xfrm>
              <a:off x="1646223" y="1025889"/>
              <a:ext cx="400062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ive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4.8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03C52B1-EA13-4C47-9164-8DC1688A61E7}"/>
                </a:ext>
              </a:extLst>
            </p:cNvPr>
            <p:cNvSpPr txBox="1"/>
            <p:nvPr/>
          </p:nvSpPr>
          <p:spPr>
            <a:xfrm rot="16200000">
              <a:off x="-194166" y="1347246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VDeFluor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506-A::Live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88C7EBC-54EE-C842-A4B1-4B2B14318A4F}"/>
                </a:ext>
              </a:extLst>
            </p:cNvPr>
            <p:cNvSpPr txBox="1"/>
            <p:nvPr/>
          </p:nvSpPr>
          <p:spPr>
            <a:xfrm>
              <a:off x="1334306" y="2361870"/>
              <a:ext cx="534681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E315BDE4-5D42-854F-B7AD-BCDC493F8BCB}"/>
                </a:ext>
              </a:extLst>
            </p:cNvPr>
            <p:cNvGrpSpPr/>
            <p:nvPr/>
          </p:nvGrpSpPr>
          <p:grpSpPr>
            <a:xfrm>
              <a:off x="2538484" y="908258"/>
              <a:ext cx="493512" cy="1416300"/>
              <a:chOff x="2538484" y="908258"/>
              <a:chExt cx="493512" cy="1416300"/>
            </a:xfrm>
          </p:grpSpPr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F4F5EB8C-8DF1-B14B-9298-4BD44987281A}"/>
                  </a:ext>
                </a:extLst>
              </p:cNvPr>
              <p:cNvSpPr txBox="1"/>
              <p:nvPr/>
            </p:nvSpPr>
            <p:spPr>
              <a:xfrm>
                <a:off x="2716781" y="2109114"/>
                <a:ext cx="1973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5B75736-4BE0-AC4F-93E7-FE24072EDF54}"/>
                  </a:ext>
                </a:extLst>
              </p:cNvPr>
              <p:cNvSpPr txBox="1"/>
              <p:nvPr/>
            </p:nvSpPr>
            <p:spPr>
              <a:xfrm>
                <a:off x="2598885" y="1877340"/>
                <a:ext cx="433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02EBFAB3-E0B9-2A4C-A6C4-3DFF9853B599}"/>
                  </a:ext>
                </a:extLst>
              </p:cNvPr>
              <p:cNvSpPr txBox="1"/>
              <p:nvPr/>
            </p:nvSpPr>
            <p:spPr>
              <a:xfrm>
                <a:off x="2541440" y="1636599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K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FC146BF-D949-DB4A-956B-7EF84347DF5A}"/>
                  </a:ext>
                </a:extLst>
              </p:cNvPr>
              <p:cNvSpPr txBox="1"/>
              <p:nvPr/>
            </p:nvSpPr>
            <p:spPr>
              <a:xfrm>
                <a:off x="2548165" y="1398863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K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8DB217EA-54D0-F44E-81C0-67C3090A6364}"/>
                  </a:ext>
                </a:extLst>
              </p:cNvPr>
              <p:cNvSpPr txBox="1"/>
              <p:nvPr/>
            </p:nvSpPr>
            <p:spPr>
              <a:xfrm>
                <a:off x="2538484" y="1148999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K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89D65703-FC29-7B44-8D38-82A0FC5CA2E5}"/>
                  </a:ext>
                </a:extLst>
              </p:cNvPr>
              <p:cNvSpPr txBox="1"/>
              <p:nvPr/>
            </p:nvSpPr>
            <p:spPr>
              <a:xfrm>
                <a:off x="2548165" y="908258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0K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6052C88B-9E88-4D47-813F-0E4A3CE669BE}"/>
                </a:ext>
              </a:extLst>
            </p:cNvPr>
            <p:cNvGrpSpPr/>
            <p:nvPr/>
          </p:nvGrpSpPr>
          <p:grpSpPr>
            <a:xfrm>
              <a:off x="2780317" y="2217099"/>
              <a:ext cx="1599306" cy="227298"/>
              <a:chOff x="824227" y="2206213"/>
              <a:chExt cx="1599306" cy="227298"/>
            </a:xfrm>
          </p:grpSpPr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8241F533-74D6-A440-A2F8-3B1E96647997}"/>
                  </a:ext>
                </a:extLst>
              </p:cNvPr>
              <p:cNvSpPr txBox="1"/>
              <p:nvPr/>
            </p:nvSpPr>
            <p:spPr>
              <a:xfrm>
                <a:off x="1747003" y="2211297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K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4368019-EE16-F04E-86C6-8C98191640E2}"/>
                  </a:ext>
                </a:extLst>
              </p:cNvPr>
              <p:cNvSpPr txBox="1"/>
              <p:nvPr/>
            </p:nvSpPr>
            <p:spPr>
              <a:xfrm>
                <a:off x="999775" y="2213965"/>
                <a:ext cx="433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85C5C61-5DD1-E24E-841A-9215EC21EB31}"/>
                  </a:ext>
                </a:extLst>
              </p:cNvPr>
              <p:cNvSpPr txBox="1"/>
              <p:nvPr/>
            </p:nvSpPr>
            <p:spPr>
              <a:xfrm>
                <a:off x="824227" y="2218067"/>
                <a:ext cx="1973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1CEC3517-9C94-4D4C-8948-FDFDF34C7EDE}"/>
                  </a:ext>
                </a:extLst>
              </p:cNvPr>
              <p:cNvSpPr txBox="1"/>
              <p:nvPr/>
            </p:nvSpPr>
            <p:spPr>
              <a:xfrm>
                <a:off x="1224680" y="2213965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K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CC85D878-EEA7-0A41-B074-7FB670D784A2}"/>
                  </a:ext>
                </a:extLst>
              </p:cNvPr>
              <p:cNvSpPr txBox="1"/>
              <p:nvPr/>
            </p:nvSpPr>
            <p:spPr>
              <a:xfrm>
                <a:off x="1490224" y="2215450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K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EE072AAF-C052-EF4F-B32B-9EE7F6F23067}"/>
                  </a:ext>
                </a:extLst>
              </p:cNvPr>
              <p:cNvSpPr txBox="1"/>
              <p:nvPr/>
            </p:nvSpPr>
            <p:spPr>
              <a:xfrm>
                <a:off x="1997377" y="2206213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0K</a:t>
                </a:r>
              </a:p>
            </p:txBody>
          </p:sp>
        </p:grpSp>
        <p:pic>
          <p:nvPicPr>
            <p:cNvPr id="43" name="図 15" descr="スクリーンショットの画面&#10;&#10;自動的に生成された説明">
              <a:extLst>
                <a:ext uri="{FF2B5EF4-FFF2-40B4-BE49-F238E27FC236}">
                  <a16:creationId xmlns:a16="http://schemas.microsoft.com/office/drawing/2014/main" id="{467FD69C-8475-8F4B-8A56-515E49C0671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068" t="34828" r="24277" b="37918"/>
            <a:stretch/>
          </p:blipFill>
          <p:spPr>
            <a:xfrm>
              <a:off x="4823151" y="928507"/>
              <a:ext cx="1371600" cy="1371600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56EA506-9D95-5341-943C-2076A097E9B8}"/>
                </a:ext>
              </a:extLst>
            </p:cNvPr>
            <p:cNvSpPr txBox="1"/>
            <p:nvPr/>
          </p:nvSpPr>
          <p:spPr>
            <a:xfrm>
              <a:off x="2942789" y="1008363"/>
              <a:ext cx="65787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A SSC-A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bset 98.1 </a:t>
              </a:r>
            </a:p>
          </p:txBody>
        </p: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4BE6CBA4-CF2E-AF48-A788-A22F78CC5AA1}"/>
                </a:ext>
              </a:extLst>
            </p:cNvPr>
            <p:cNvGrpSpPr/>
            <p:nvPr/>
          </p:nvGrpSpPr>
          <p:grpSpPr>
            <a:xfrm>
              <a:off x="4750418" y="2240675"/>
              <a:ext cx="1599306" cy="227298"/>
              <a:chOff x="824227" y="2206213"/>
              <a:chExt cx="1599306" cy="227298"/>
            </a:xfrm>
          </p:grpSpPr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AC81FDEF-567C-F74F-A83D-75C71AF5CF5E}"/>
                  </a:ext>
                </a:extLst>
              </p:cNvPr>
              <p:cNvSpPr txBox="1"/>
              <p:nvPr/>
            </p:nvSpPr>
            <p:spPr>
              <a:xfrm>
                <a:off x="1747003" y="2211297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K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186AAEC6-D474-8C49-B9B5-E7C24710A47D}"/>
                  </a:ext>
                </a:extLst>
              </p:cNvPr>
              <p:cNvSpPr txBox="1"/>
              <p:nvPr/>
            </p:nvSpPr>
            <p:spPr>
              <a:xfrm>
                <a:off x="999775" y="2213965"/>
                <a:ext cx="433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3B2A24B2-1F52-F04F-89E8-1FBC258BDCFD}"/>
                  </a:ext>
                </a:extLst>
              </p:cNvPr>
              <p:cNvSpPr txBox="1"/>
              <p:nvPr/>
            </p:nvSpPr>
            <p:spPr>
              <a:xfrm>
                <a:off x="824227" y="2218067"/>
                <a:ext cx="1973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E5CCDBA0-E482-E647-B317-3C28AD59BDED}"/>
                  </a:ext>
                </a:extLst>
              </p:cNvPr>
              <p:cNvSpPr txBox="1"/>
              <p:nvPr/>
            </p:nvSpPr>
            <p:spPr>
              <a:xfrm>
                <a:off x="1224680" y="2213965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K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E2A0622D-2DBC-CF4B-9B9A-93DD76499A94}"/>
                  </a:ext>
                </a:extLst>
              </p:cNvPr>
              <p:cNvSpPr txBox="1"/>
              <p:nvPr/>
            </p:nvSpPr>
            <p:spPr>
              <a:xfrm>
                <a:off x="1490224" y="2215450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K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800CC02B-0D40-C047-9201-214B5EC6AEEE}"/>
                  </a:ext>
                </a:extLst>
              </p:cNvPr>
              <p:cNvSpPr txBox="1"/>
              <p:nvPr/>
            </p:nvSpPr>
            <p:spPr>
              <a:xfrm>
                <a:off x="1997377" y="2206213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0K</a:t>
                </a:r>
              </a:p>
            </p:txBody>
          </p: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9BE0050F-F323-6945-9D73-4671C0EBF77D}"/>
                </a:ext>
              </a:extLst>
            </p:cNvPr>
            <p:cNvGrpSpPr/>
            <p:nvPr/>
          </p:nvGrpSpPr>
          <p:grpSpPr>
            <a:xfrm>
              <a:off x="4487787" y="928507"/>
              <a:ext cx="493512" cy="1416300"/>
              <a:chOff x="2538484" y="908258"/>
              <a:chExt cx="493512" cy="1416300"/>
            </a:xfrm>
          </p:grpSpPr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791651B8-6C46-3046-A945-F53DDC323177}"/>
                  </a:ext>
                </a:extLst>
              </p:cNvPr>
              <p:cNvSpPr txBox="1"/>
              <p:nvPr/>
            </p:nvSpPr>
            <p:spPr>
              <a:xfrm>
                <a:off x="2716781" y="2109114"/>
                <a:ext cx="1973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4B020E6B-1D80-6745-8B5F-E2016C433D28}"/>
                  </a:ext>
                </a:extLst>
              </p:cNvPr>
              <p:cNvSpPr txBox="1"/>
              <p:nvPr/>
            </p:nvSpPr>
            <p:spPr>
              <a:xfrm>
                <a:off x="2598885" y="1877340"/>
                <a:ext cx="433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CCA6AAF3-8389-0648-BC56-CD6DAAB18D0B}"/>
                  </a:ext>
                </a:extLst>
              </p:cNvPr>
              <p:cNvSpPr txBox="1"/>
              <p:nvPr/>
            </p:nvSpPr>
            <p:spPr>
              <a:xfrm>
                <a:off x="2541440" y="1636599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K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7A46762E-C145-B143-8DBE-96FCD58745A0}"/>
                  </a:ext>
                </a:extLst>
              </p:cNvPr>
              <p:cNvSpPr txBox="1"/>
              <p:nvPr/>
            </p:nvSpPr>
            <p:spPr>
              <a:xfrm>
                <a:off x="2548165" y="1398863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K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6C42FB8C-50A5-4347-B8B3-91665BAE9996}"/>
                  </a:ext>
                </a:extLst>
              </p:cNvPr>
              <p:cNvSpPr txBox="1"/>
              <p:nvPr/>
            </p:nvSpPr>
            <p:spPr>
              <a:xfrm>
                <a:off x="2538484" y="1148999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K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C58E5FDF-BD04-0A42-A4B7-7AE20892624E}"/>
                  </a:ext>
                </a:extLst>
              </p:cNvPr>
              <p:cNvSpPr txBox="1"/>
              <p:nvPr/>
            </p:nvSpPr>
            <p:spPr>
              <a:xfrm>
                <a:off x="2548165" y="908258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0K</a:t>
                </a:r>
              </a:p>
            </p:txBody>
          </p:sp>
        </p:grp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9CD5510-2AE8-744C-B56A-61608AAF6152}"/>
                </a:ext>
              </a:extLst>
            </p:cNvPr>
            <p:cNvSpPr txBox="1"/>
            <p:nvPr/>
          </p:nvSpPr>
          <p:spPr>
            <a:xfrm>
              <a:off x="5301365" y="1082954"/>
              <a:ext cx="72331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6.8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E31E242-09C3-054D-83CE-DC9A296AC274}"/>
                </a:ext>
              </a:extLst>
            </p:cNvPr>
            <p:cNvSpPr txBox="1"/>
            <p:nvPr/>
          </p:nvSpPr>
          <p:spPr>
            <a:xfrm>
              <a:off x="5348388" y="2388317"/>
              <a:ext cx="5346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F106D8F-8E12-0C40-8718-0E77F1AB12D7}"/>
                </a:ext>
              </a:extLst>
            </p:cNvPr>
            <p:cNvSpPr txBox="1"/>
            <p:nvPr/>
          </p:nvSpPr>
          <p:spPr>
            <a:xfrm rot="16200000">
              <a:off x="2293779" y="1496384"/>
              <a:ext cx="534681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9FC170C-B05A-C640-B17C-DBD0E5808147}"/>
                </a:ext>
              </a:extLst>
            </p:cNvPr>
            <p:cNvSpPr txBox="1"/>
            <p:nvPr/>
          </p:nvSpPr>
          <p:spPr>
            <a:xfrm>
              <a:off x="3388414" y="2378157"/>
              <a:ext cx="5346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DD71915-3E5D-3841-A8AE-F5DD05399397}"/>
                </a:ext>
              </a:extLst>
            </p:cNvPr>
            <p:cNvSpPr txBox="1"/>
            <p:nvPr/>
          </p:nvSpPr>
          <p:spPr>
            <a:xfrm rot="16200000">
              <a:off x="4230062" y="1504675"/>
              <a:ext cx="5346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SC-W</a:t>
              </a:r>
            </a:p>
          </p:txBody>
        </p:sp>
        <p:pic>
          <p:nvPicPr>
            <p:cNvPr id="67" name="図 15" descr="スクリーンショットの画面&#10;&#10;自動的に生成された説明">
              <a:extLst>
                <a:ext uri="{FF2B5EF4-FFF2-40B4-BE49-F238E27FC236}">
                  <a16:creationId xmlns:a16="http://schemas.microsoft.com/office/drawing/2014/main" id="{618258D4-9EA5-F943-ADBD-522C0377F4F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441" t="34589" r="971" b="37831"/>
            <a:stretch/>
          </p:blipFill>
          <p:spPr>
            <a:xfrm>
              <a:off x="6713362" y="930228"/>
              <a:ext cx="1371600" cy="1371600"/>
            </a:xfrm>
            <a:prstGeom prst="rect">
              <a:avLst/>
            </a:prstGeom>
          </p:spPr>
        </p:pic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AB63BDA9-7DE4-F144-AEA3-ED2100E696D5}"/>
                </a:ext>
              </a:extLst>
            </p:cNvPr>
            <p:cNvSpPr/>
            <p:nvPr/>
          </p:nvSpPr>
          <p:spPr>
            <a:xfrm>
              <a:off x="6906900" y="1215901"/>
              <a:ext cx="358746" cy="17322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A425B6D6-6566-D848-B8E8-8519E11F0DB2}"/>
                </a:ext>
              </a:extLst>
            </p:cNvPr>
            <p:cNvSpPr txBox="1"/>
            <p:nvPr/>
          </p:nvSpPr>
          <p:spPr>
            <a:xfrm>
              <a:off x="6794132" y="1097254"/>
              <a:ext cx="9100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5.3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F2D85A66-8CC5-6449-B346-FF6598A7842F}"/>
                </a:ext>
              </a:extLst>
            </p:cNvPr>
            <p:cNvSpPr txBox="1"/>
            <p:nvPr/>
          </p:nvSpPr>
          <p:spPr>
            <a:xfrm>
              <a:off x="7204301" y="2376088"/>
              <a:ext cx="5346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</a:p>
          </p:txBody>
        </p:sp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id="{5A1F62D6-9BF3-7D43-B985-5F384166021B}"/>
                </a:ext>
              </a:extLst>
            </p:cNvPr>
            <p:cNvGrpSpPr/>
            <p:nvPr/>
          </p:nvGrpSpPr>
          <p:grpSpPr>
            <a:xfrm>
              <a:off x="6658989" y="2237117"/>
              <a:ext cx="1599306" cy="227298"/>
              <a:chOff x="824227" y="2206213"/>
              <a:chExt cx="1599306" cy="227298"/>
            </a:xfrm>
          </p:grpSpPr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8AE86BBC-C2BC-9D47-9B3D-6CE554CA80A2}"/>
                  </a:ext>
                </a:extLst>
              </p:cNvPr>
              <p:cNvSpPr txBox="1"/>
              <p:nvPr/>
            </p:nvSpPr>
            <p:spPr>
              <a:xfrm>
                <a:off x="1747003" y="2211297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K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DF47270B-39A5-1B40-91A8-38F1834A6BCE}"/>
                  </a:ext>
                </a:extLst>
              </p:cNvPr>
              <p:cNvSpPr txBox="1"/>
              <p:nvPr/>
            </p:nvSpPr>
            <p:spPr>
              <a:xfrm>
                <a:off x="999775" y="2213965"/>
                <a:ext cx="433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D2B519BD-318C-6D47-8143-B50D090697F8}"/>
                  </a:ext>
                </a:extLst>
              </p:cNvPr>
              <p:cNvSpPr txBox="1"/>
              <p:nvPr/>
            </p:nvSpPr>
            <p:spPr>
              <a:xfrm>
                <a:off x="824227" y="2218067"/>
                <a:ext cx="1973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DC4596EF-E501-8248-A3CB-2F49709A1C03}"/>
                  </a:ext>
                </a:extLst>
              </p:cNvPr>
              <p:cNvSpPr txBox="1"/>
              <p:nvPr/>
            </p:nvSpPr>
            <p:spPr>
              <a:xfrm>
                <a:off x="1224680" y="2213965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K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40E2FFF5-14D1-3246-AD44-FDBAA7C94D96}"/>
                  </a:ext>
                </a:extLst>
              </p:cNvPr>
              <p:cNvSpPr txBox="1"/>
              <p:nvPr/>
            </p:nvSpPr>
            <p:spPr>
              <a:xfrm>
                <a:off x="1490224" y="2215450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K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4A0940B4-C330-E741-A85C-EE905721459B}"/>
                  </a:ext>
                </a:extLst>
              </p:cNvPr>
              <p:cNvSpPr txBox="1"/>
              <p:nvPr/>
            </p:nvSpPr>
            <p:spPr>
              <a:xfrm>
                <a:off x="1997377" y="2206213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0K</a:t>
                </a:r>
              </a:p>
            </p:txBody>
          </p:sp>
        </p:grp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25495277-6D8E-2240-AAD7-8D433D58A742}"/>
                </a:ext>
              </a:extLst>
            </p:cNvPr>
            <p:cNvGrpSpPr/>
            <p:nvPr/>
          </p:nvGrpSpPr>
          <p:grpSpPr>
            <a:xfrm>
              <a:off x="6395823" y="925101"/>
              <a:ext cx="493512" cy="1416300"/>
              <a:chOff x="2538484" y="908258"/>
              <a:chExt cx="493512" cy="1416300"/>
            </a:xfrm>
          </p:grpSpPr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A4D1C639-A6F9-6A40-BDB1-B274E8628B9A}"/>
                  </a:ext>
                </a:extLst>
              </p:cNvPr>
              <p:cNvSpPr txBox="1"/>
              <p:nvPr/>
            </p:nvSpPr>
            <p:spPr>
              <a:xfrm>
                <a:off x="2716781" y="2109114"/>
                <a:ext cx="1973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94AB204E-72DB-FB44-88C9-209EFAF7C135}"/>
                  </a:ext>
                </a:extLst>
              </p:cNvPr>
              <p:cNvSpPr txBox="1"/>
              <p:nvPr/>
            </p:nvSpPr>
            <p:spPr>
              <a:xfrm>
                <a:off x="2598885" y="1877340"/>
                <a:ext cx="4331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8613C845-E838-8A44-B2AD-385A900D4FE8}"/>
                  </a:ext>
                </a:extLst>
              </p:cNvPr>
              <p:cNvSpPr txBox="1"/>
              <p:nvPr/>
            </p:nvSpPr>
            <p:spPr>
              <a:xfrm>
                <a:off x="2541440" y="1636599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K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26AB66C9-8215-5544-B0C8-FECF08DBD1C6}"/>
                  </a:ext>
                </a:extLst>
              </p:cNvPr>
              <p:cNvSpPr txBox="1"/>
              <p:nvPr/>
            </p:nvSpPr>
            <p:spPr>
              <a:xfrm>
                <a:off x="2548165" y="1398863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K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DF86AD09-189C-9A4B-8D21-69FD30EEC96A}"/>
                  </a:ext>
                </a:extLst>
              </p:cNvPr>
              <p:cNvSpPr txBox="1"/>
              <p:nvPr/>
            </p:nvSpPr>
            <p:spPr>
              <a:xfrm>
                <a:off x="2538484" y="1148999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K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7F8A3B4D-11A7-7847-AC7A-F9061DDF78A7}"/>
                  </a:ext>
                </a:extLst>
              </p:cNvPr>
              <p:cNvSpPr txBox="1"/>
              <p:nvPr/>
            </p:nvSpPr>
            <p:spPr>
              <a:xfrm>
                <a:off x="2548165" y="908258"/>
                <a:ext cx="4261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0K</a:t>
                </a:r>
              </a:p>
            </p:txBody>
          </p:sp>
        </p:grp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9FC75917-8BA1-8B47-AD15-E50B358EBFAD}"/>
                </a:ext>
              </a:extLst>
            </p:cNvPr>
            <p:cNvSpPr txBox="1"/>
            <p:nvPr/>
          </p:nvSpPr>
          <p:spPr>
            <a:xfrm rot="16200000">
              <a:off x="6155039" y="1501248"/>
              <a:ext cx="5346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SC-W</a:t>
              </a:r>
            </a:p>
          </p:txBody>
        </p:sp>
        <p:cxnSp>
          <p:nvCxnSpPr>
            <p:cNvPr id="86" name="Straight Arrow Connector 85">
              <a:extLst>
                <a:ext uri="{FF2B5EF4-FFF2-40B4-BE49-F238E27FC236}">
                  <a16:creationId xmlns:a16="http://schemas.microsoft.com/office/drawing/2014/main" id="{88E5D88C-4222-9249-8724-9654219E2272}"/>
                </a:ext>
              </a:extLst>
            </p:cNvPr>
            <p:cNvCxnSpPr/>
            <p:nvPr/>
          </p:nvCxnSpPr>
          <p:spPr>
            <a:xfrm>
              <a:off x="2183806" y="1825408"/>
              <a:ext cx="4572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Arrow Connector 86">
              <a:extLst>
                <a:ext uri="{FF2B5EF4-FFF2-40B4-BE49-F238E27FC236}">
                  <a16:creationId xmlns:a16="http://schemas.microsoft.com/office/drawing/2014/main" id="{A09E89D8-CCCA-4F4F-AC69-E801BEE93CB0}"/>
                </a:ext>
              </a:extLst>
            </p:cNvPr>
            <p:cNvCxnSpPr/>
            <p:nvPr/>
          </p:nvCxnSpPr>
          <p:spPr>
            <a:xfrm>
              <a:off x="4004069" y="1824189"/>
              <a:ext cx="4572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Arrow Connector 87">
              <a:extLst>
                <a:ext uri="{FF2B5EF4-FFF2-40B4-BE49-F238E27FC236}">
                  <a16:creationId xmlns:a16="http://schemas.microsoft.com/office/drawing/2014/main" id="{855D92A3-465A-CC49-AB95-C1E8E881AF6A}"/>
                </a:ext>
              </a:extLst>
            </p:cNvPr>
            <p:cNvCxnSpPr/>
            <p:nvPr/>
          </p:nvCxnSpPr>
          <p:spPr>
            <a:xfrm>
              <a:off x="5654469" y="1785504"/>
              <a:ext cx="4572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0" name="図 15" descr="スクリーンショットの画面&#10;&#10;自動的に生成された説明">
              <a:extLst>
                <a:ext uri="{FF2B5EF4-FFF2-40B4-BE49-F238E27FC236}">
                  <a16:creationId xmlns:a16="http://schemas.microsoft.com/office/drawing/2014/main" id="{A71D1E5E-FF08-E346-8CA0-CF0F5F5A724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118" t="67242" r="24636" b="5800"/>
            <a:stretch/>
          </p:blipFill>
          <p:spPr>
            <a:xfrm>
              <a:off x="855257" y="2987495"/>
              <a:ext cx="1371600" cy="1371600"/>
            </a:xfrm>
            <a:prstGeom prst="rect">
              <a:avLst/>
            </a:prstGeom>
          </p:spPr>
        </p:pic>
        <p:pic>
          <p:nvPicPr>
            <p:cNvPr id="92" name="図 15" descr="スクリーンショットの画面&#10;&#10;自動的に生成された説明">
              <a:extLst>
                <a:ext uri="{FF2B5EF4-FFF2-40B4-BE49-F238E27FC236}">
                  <a16:creationId xmlns:a16="http://schemas.microsoft.com/office/drawing/2014/main" id="{33CA8E9B-E1FB-C34D-8E78-AB1B40B8B78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61" t="66837" r="76238" b="5861"/>
            <a:stretch/>
          </p:blipFill>
          <p:spPr>
            <a:xfrm>
              <a:off x="2794945" y="2983723"/>
              <a:ext cx="1371600" cy="1371600"/>
            </a:xfrm>
            <a:prstGeom prst="rect">
              <a:avLst/>
            </a:prstGeom>
          </p:spPr>
        </p:pic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7F30FF4C-614D-EB41-A92B-3A7DC38E2648}"/>
                </a:ext>
              </a:extLst>
            </p:cNvPr>
            <p:cNvGrpSpPr/>
            <p:nvPr/>
          </p:nvGrpSpPr>
          <p:grpSpPr>
            <a:xfrm>
              <a:off x="565001" y="3152201"/>
              <a:ext cx="990951" cy="1205499"/>
              <a:chOff x="588436" y="1055496"/>
              <a:chExt cx="990951" cy="1205499"/>
            </a:xfrm>
          </p:grpSpPr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C89E8016-24A8-9A4B-8D50-98AFF856BF74}"/>
                  </a:ext>
                </a:extLst>
              </p:cNvPr>
              <p:cNvSpPr txBox="1"/>
              <p:nvPr/>
            </p:nvSpPr>
            <p:spPr>
              <a:xfrm>
                <a:off x="588436" y="2045551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47643B22-8F34-7547-BA5B-E59AC05AAE1F}"/>
                  </a:ext>
                </a:extLst>
              </p:cNvPr>
              <p:cNvSpPr txBox="1"/>
              <p:nvPr/>
            </p:nvSpPr>
            <p:spPr>
              <a:xfrm>
                <a:off x="713165" y="1841917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93118922-E825-2A40-95D3-0E3E584D2B49}"/>
                  </a:ext>
                </a:extLst>
              </p:cNvPr>
              <p:cNvSpPr txBox="1"/>
              <p:nvPr/>
            </p:nvSpPr>
            <p:spPr>
              <a:xfrm>
                <a:off x="635897" y="1673361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AF000E13-CFA4-574D-80E1-02550F9EEFAC}"/>
                  </a:ext>
                </a:extLst>
              </p:cNvPr>
              <p:cNvSpPr txBox="1"/>
              <p:nvPr/>
            </p:nvSpPr>
            <p:spPr>
              <a:xfrm>
                <a:off x="627366" y="1335252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A91B3236-4F92-6640-928C-AD1AAC649128}"/>
                  </a:ext>
                </a:extLst>
              </p:cNvPr>
              <p:cNvSpPr txBox="1"/>
              <p:nvPr/>
            </p:nvSpPr>
            <p:spPr>
              <a:xfrm>
                <a:off x="633462" y="1055496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</p:grp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1748BA71-9C0B-9044-8914-35A175028B60}"/>
                </a:ext>
              </a:extLst>
            </p:cNvPr>
            <p:cNvGrpSpPr/>
            <p:nvPr/>
          </p:nvGrpSpPr>
          <p:grpSpPr>
            <a:xfrm>
              <a:off x="2503862" y="3167316"/>
              <a:ext cx="990951" cy="1205499"/>
              <a:chOff x="588436" y="1055496"/>
              <a:chExt cx="990951" cy="1205499"/>
            </a:xfrm>
          </p:grpSpPr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BFF80DF0-D1C3-BB4A-8DF3-DA946B849623}"/>
                  </a:ext>
                </a:extLst>
              </p:cNvPr>
              <p:cNvSpPr txBox="1"/>
              <p:nvPr/>
            </p:nvSpPr>
            <p:spPr>
              <a:xfrm>
                <a:off x="588436" y="2045551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86BDC0A5-402C-6242-B907-657D047665EF}"/>
                  </a:ext>
                </a:extLst>
              </p:cNvPr>
              <p:cNvSpPr txBox="1"/>
              <p:nvPr/>
            </p:nvSpPr>
            <p:spPr>
              <a:xfrm>
                <a:off x="713165" y="1841917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9D2BF850-C861-CE4C-AE20-8024FB6A3507}"/>
                  </a:ext>
                </a:extLst>
              </p:cNvPr>
              <p:cNvSpPr txBox="1"/>
              <p:nvPr/>
            </p:nvSpPr>
            <p:spPr>
              <a:xfrm>
                <a:off x="635897" y="1673361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AFB3BC1A-5CCD-7A44-9D7B-62D67C98E5C8}"/>
                  </a:ext>
                </a:extLst>
              </p:cNvPr>
              <p:cNvSpPr txBox="1"/>
              <p:nvPr/>
            </p:nvSpPr>
            <p:spPr>
              <a:xfrm>
                <a:off x="627366" y="1335252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419B654D-27A5-0C4B-946D-3846D3EAE1A1}"/>
                  </a:ext>
                </a:extLst>
              </p:cNvPr>
              <p:cNvSpPr txBox="1"/>
              <p:nvPr/>
            </p:nvSpPr>
            <p:spPr>
              <a:xfrm>
                <a:off x="633462" y="1055496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</p:grpSp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id="{341B76C7-0D00-FE4D-B0B1-BE1509267149}"/>
                </a:ext>
              </a:extLst>
            </p:cNvPr>
            <p:cNvGrpSpPr/>
            <p:nvPr/>
          </p:nvGrpSpPr>
          <p:grpSpPr>
            <a:xfrm>
              <a:off x="787741" y="4300561"/>
              <a:ext cx="1695317" cy="222927"/>
              <a:chOff x="787741" y="4300561"/>
              <a:chExt cx="1695317" cy="222927"/>
            </a:xfrm>
          </p:grpSpPr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52AC5310-DED4-AB4C-94A9-66769A0FD17A}"/>
                  </a:ext>
                </a:extLst>
              </p:cNvPr>
              <p:cNvSpPr txBox="1"/>
              <p:nvPr/>
            </p:nvSpPr>
            <p:spPr>
              <a:xfrm>
                <a:off x="787741" y="4308044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674A3E26-0A36-094D-A7EB-3A69E75A1C18}"/>
                  </a:ext>
                </a:extLst>
              </p:cNvPr>
              <p:cNvSpPr txBox="1"/>
              <p:nvPr/>
            </p:nvSpPr>
            <p:spPr>
              <a:xfrm>
                <a:off x="1082196" y="4308044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9DD8204E-D71E-BB43-A831-6C83A0C50525}"/>
                  </a:ext>
                </a:extLst>
              </p:cNvPr>
              <p:cNvSpPr txBox="1"/>
              <p:nvPr/>
            </p:nvSpPr>
            <p:spPr>
              <a:xfrm>
                <a:off x="1238748" y="4303612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D2069631-110B-9842-9F2A-B4086727A634}"/>
                  </a:ext>
                </a:extLst>
              </p:cNvPr>
              <p:cNvSpPr txBox="1"/>
              <p:nvPr/>
            </p:nvSpPr>
            <p:spPr>
              <a:xfrm>
                <a:off x="1616836" y="4300561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D203EBCE-750E-CF41-985E-ECDC15693F89}"/>
                </a:ext>
              </a:extLst>
            </p:cNvPr>
            <p:cNvSpPr txBox="1"/>
            <p:nvPr/>
          </p:nvSpPr>
          <p:spPr>
            <a:xfrm>
              <a:off x="1888446" y="4301863"/>
              <a:ext cx="8662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44D0C54D-4738-2D44-B85A-4260A1553C6A}"/>
                </a:ext>
              </a:extLst>
            </p:cNvPr>
            <p:cNvSpPr/>
            <p:nvPr/>
          </p:nvSpPr>
          <p:spPr>
            <a:xfrm>
              <a:off x="1387522" y="5151184"/>
              <a:ext cx="315780" cy="1619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B0EBF30D-1CC9-904D-9A35-D80A073735A5}"/>
                </a:ext>
              </a:extLst>
            </p:cNvPr>
            <p:cNvSpPr txBox="1"/>
            <p:nvPr/>
          </p:nvSpPr>
          <p:spPr>
            <a:xfrm>
              <a:off x="1065730" y="3024543"/>
              <a:ext cx="65900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bIns="0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y6C high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.7 </a:t>
              </a:r>
            </a:p>
          </p:txBody>
        </p:sp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id="{FDFC7F06-C45E-0849-8971-0F1FA40BDAD0}"/>
                </a:ext>
              </a:extLst>
            </p:cNvPr>
            <p:cNvGrpSpPr/>
            <p:nvPr/>
          </p:nvGrpSpPr>
          <p:grpSpPr>
            <a:xfrm>
              <a:off x="2735500" y="3052916"/>
              <a:ext cx="1985350" cy="1476455"/>
              <a:chOff x="2735500" y="3052916"/>
              <a:chExt cx="1985350" cy="1476455"/>
            </a:xfrm>
          </p:grpSpPr>
          <p:grpSp>
            <p:nvGrpSpPr>
              <p:cNvPr id="112" name="Group 111">
                <a:extLst>
                  <a:ext uri="{FF2B5EF4-FFF2-40B4-BE49-F238E27FC236}">
                    <a16:creationId xmlns:a16="http://schemas.microsoft.com/office/drawing/2014/main" id="{30C72E76-7557-9A40-8FCA-0C6515E36012}"/>
                  </a:ext>
                </a:extLst>
              </p:cNvPr>
              <p:cNvGrpSpPr/>
              <p:nvPr/>
            </p:nvGrpSpPr>
            <p:grpSpPr>
              <a:xfrm>
                <a:off x="2735500" y="4306444"/>
                <a:ext cx="1695317" cy="222927"/>
                <a:chOff x="787741" y="4300561"/>
                <a:chExt cx="1695317" cy="222927"/>
              </a:xfrm>
            </p:grpSpPr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75BAD8A0-9EBB-3B46-94E3-45E2F3A0BBBC}"/>
                    </a:ext>
                  </a:extLst>
                </p:cNvPr>
                <p:cNvSpPr txBox="1"/>
                <p:nvPr/>
              </p:nvSpPr>
              <p:spPr>
                <a:xfrm>
                  <a:off x="787741" y="4308044"/>
                  <a:ext cx="86622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0</a:t>
                  </a:r>
                  <a:r>
                    <a:rPr lang="en-US" sz="8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528BC058-5798-744D-8ED1-1012E500FEC1}"/>
                    </a:ext>
                  </a:extLst>
                </p:cNvPr>
                <p:cNvSpPr txBox="1"/>
                <p:nvPr/>
              </p:nvSpPr>
              <p:spPr>
                <a:xfrm>
                  <a:off x="1082196" y="4308044"/>
                  <a:ext cx="86622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EFA4E713-99EC-924C-A3B7-29C8F7D8F779}"/>
                    </a:ext>
                  </a:extLst>
                </p:cNvPr>
                <p:cNvSpPr txBox="1"/>
                <p:nvPr/>
              </p:nvSpPr>
              <p:spPr>
                <a:xfrm>
                  <a:off x="1238748" y="4303612"/>
                  <a:ext cx="86622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sz="8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3C6B8032-348E-BA48-A20D-64C76BA76F8C}"/>
                    </a:ext>
                  </a:extLst>
                </p:cNvPr>
                <p:cNvSpPr txBox="1"/>
                <p:nvPr/>
              </p:nvSpPr>
              <p:spPr>
                <a:xfrm>
                  <a:off x="1616836" y="4300561"/>
                  <a:ext cx="86622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r>
                    <a:rPr lang="en-US" sz="8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ED923D9E-711E-A146-9318-8904C1C98B43}"/>
                  </a:ext>
                </a:extLst>
              </p:cNvPr>
              <p:cNvSpPr txBox="1"/>
              <p:nvPr/>
            </p:nvSpPr>
            <p:spPr>
              <a:xfrm>
                <a:off x="3854628" y="4300670"/>
                <a:ext cx="8662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8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20" name="Rectangle 119">
                <a:extLst>
                  <a:ext uri="{FF2B5EF4-FFF2-40B4-BE49-F238E27FC236}">
                    <a16:creationId xmlns:a16="http://schemas.microsoft.com/office/drawing/2014/main" id="{18FD3423-6611-2A42-8AA1-3DB3E8D2D61D}"/>
                  </a:ext>
                </a:extLst>
              </p:cNvPr>
              <p:cNvSpPr/>
              <p:nvPr/>
            </p:nvSpPr>
            <p:spPr>
              <a:xfrm>
                <a:off x="3417545" y="3052916"/>
                <a:ext cx="285548" cy="16199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82FB7C5D-0B8A-CB4E-BE5D-594AB275481F}"/>
                </a:ext>
              </a:extLst>
            </p:cNvPr>
            <p:cNvSpPr txBox="1"/>
            <p:nvPr/>
          </p:nvSpPr>
          <p:spPr>
            <a:xfrm>
              <a:off x="3263989" y="3008109"/>
              <a:ext cx="9100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y6C high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8.8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82ED9756-FA3C-714D-AF34-7CC3FAD59B05}"/>
                </a:ext>
              </a:extLst>
            </p:cNvPr>
            <p:cNvSpPr txBox="1"/>
            <p:nvPr/>
          </p:nvSpPr>
          <p:spPr>
            <a:xfrm rot="16200000">
              <a:off x="206147" y="3407403"/>
              <a:ext cx="6944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</a:p>
          </p:txBody>
        </p:sp>
        <p:cxnSp>
          <p:nvCxnSpPr>
            <p:cNvPr id="124" name="Straight Arrow Connector 123">
              <a:extLst>
                <a:ext uri="{FF2B5EF4-FFF2-40B4-BE49-F238E27FC236}">
                  <a16:creationId xmlns:a16="http://schemas.microsoft.com/office/drawing/2014/main" id="{6B6E35CD-5E2D-0E4E-85D1-DD658C78A968}"/>
                </a:ext>
              </a:extLst>
            </p:cNvPr>
            <p:cNvCxnSpPr/>
            <p:nvPr/>
          </p:nvCxnSpPr>
          <p:spPr>
            <a:xfrm>
              <a:off x="627365" y="4523488"/>
              <a:ext cx="365760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Arrow Connector 124">
              <a:extLst>
                <a:ext uri="{FF2B5EF4-FFF2-40B4-BE49-F238E27FC236}">
                  <a16:creationId xmlns:a16="http://schemas.microsoft.com/office/drawing/2014/main" id="{E752C2FE-CA77-2F49-A18B-70F802C8AB7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-206164" y="3677668"/>
              <a:ext cx="169164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0FC72F1F-F290-1E43-8E33-97D372B8E9D2}"/>
                </a:ext>
              </a:extLst>
            </p:cNvPr>
            <p:cNvSpPr txBox="1"/>
            <p:nvPr/>
          </p:nvSpPr>
          <p:spPr>
            <a:xfrm>
              <a:off x="2115534" y="4537078"/>
              <a:ext cx="11530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2068A65E-36D9-B349-98A4-479E215E7EC7}"/>
                </a:ext>
              </a:extLst>
            </p:cNvPr>
            <p:cNvSpPr txBox="1"/>
            <p:nvPr/>
          </p:nvSpPr>
          <p:spPr>
            <a:xfrm>
              <a:off x="1347807" y="2803443"/>
              <a:ext cx="8511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CBC4F641-87AD-3941-8301-3A1797D55D4E}"/>
                </a:ext>
              </a:extLst>
            </p:cNvPr>
            <p:cNvSpPr txBox="1"/>
            <p:nvPr/>
          </p:nvSpPr>
          <p:spPr>
            <a:xfrm>
              <a:off x="3278148" y="2822583"/>
              <a:ext cx="8511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LP</a:t>
              </a:r>
            </a:p>
          </p:txBody>
        </p: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62DAB08C-274F-B742-A005-3CBDCA4EC15F}"/>
                </a:ext>
              </a:extLst>
            </p:cNvPr>
            <p:cNvSpPr/>
            <p:nvPr/>
          </p:nvSpPr>
          <p:spPr>
            <a:xfrm>
              <a:off x="3606659" y="473263"/>
              <a:ext cx="217239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ating strategy for single cell RNA-</a:t>
              </a:r>
              <a:r>
                <a:rPr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endParaRPr lang="en-US" sz="9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32965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5423A134-2BDC-0840-97E4-75FB8909A43B}"/>
              </a:ext>
            </a:extLst>
          </p:cNvPr>
          <p:cNvSpPr txBox="1"/>
          <p:nvPr/>
        </p:nvSpPr>
        <p:spPr>
          <a:xfrm>
            <a:off x="78576" y="115748"/>
            <a:ext cx="20695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CD40972-4C6F-1E09-C333-E3F9163A8CC2}"/>
              </a:ext>
            </a:extLst>
          </p:cNvPr>
          <p:cNvGrpSpPr/>
          <p:nvPr/>
        </p:nvGrpSpPr>
        <p:grpSpPr>
          <a:xfrm>
            <a:off x="78102" y="618520"/>
            <a:ext cx="9290952" cy="5924433"/>
            <a:chOff x="78102" y="618520"/>
            <a:chExt cx="9290952" cy="592443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82E976B-F596-824C-A595-A94B01C3C08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/>
            <a:srcRect l="17789" t="7345" b="13390"/>
            <a:stretch/>
          </p:blipFill>
          <p:spPr>
            <a:xfrm>
              <a:off x="3905742" y="1002760"/>
              <a:ext cx="1371600" cy="137160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5250D03E-502A-9C49-A89C-ED7D75D0129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/>
            <a:srcRect l="15227" t="10368" b="14062"/>
            <a:stretch/>
          </p:blipFill>
          <p:spPr>
            <a:xfrm>
              <a:off x="2199682" y="995698"/>
              <a:ext cx="1371600" cy="13716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2BA8E33F-1402-BC44-B1C7-EB92A994EDD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/>
            <a:srcRect l="15340" t="9360" b="14063"/>
            <a:stretch/>
          </p:blipFill>
          <p:spPr>
            <a:xfrm>
              <a:off x="5715061" y="1023567"/>
              <a:ext cx="1371600" cy="1371600"/>
            </a:xfrm>
            <a:prstGeom prst="rect">
              <a:avLst/>
            </a:prstGeom>
          </p:spPr>
        </p:pic>
        <p:pic>
          <p:nvPicPr>
            <p:cNvPr id="20" name="図 30">
              <a:extLst>
                <a:ext uri="{FF2B5EF4-FFF2-40B4-BE49-F238E27FC236}">
                  <a16:creationId xmlns:a16="http://schemas.microsoft.com/office/drawing/2014/main" id="{F70FF5F2-B929-3A44-8D34-8C289ECC74C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/>
            <a:srcRect l="15940" t="9820" r="4018" b="14783"/>
            <a:stretch/>
          </p:blipFill>
          <p:spPr>
            <a:xfrm>
              <a:off x="7497464" y="1028700"/>
              <a:ext cx="1371600" cy="13716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C8B945B-1A04-434E-8CD8-778B2D9FC8B4}"/>
                </a:ext>
              </a:extLst>
            </p:cNvPr>
            <p:cNvSpPr txBox="1"/>
            <p:nvPr/>
          </p:nvSpPr>
          <p:spPr>
            <a:xfrm rot="16200000">
              <a:off x="-621095" y="1326928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spect ratio_M01</a:t>
              </a:r>
            </a:p>
          </p:txBody>
        </p:sp>
        <p:pic>
          <p:nvPicPr>
            <p:cNvPr id="24" name="図 4">
              <a:extLst>
                <a:ext uri="{FF2B5EF4-FFF2-40B4-BE49-F238E27FC236}">
                  <a16:creationId xmlns:a16="http://schemas.microsoft.com/office/drawing/2014/main" id="{47B8F01F-3B87-404E-A9C5-D55044DDBC8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/>
            <a:srcRect l="16553" t="6879" r="-1260" b="14783"/>
            <a:stretch/>
          </p:blipFill>
          <p:spPr>
            <a:xfrm>
              <a:off x="454599" y="1028700"/>
              <a:ext cx="1371600" cy="1371600"/>
            </a:xfrm>
            <a:prstGeom prst="rect">
              <a:avLst/>
            </a:prstGeom>
          </p:spPr>
        </p:pic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A6C04251-EA67-074B-A126-F04E3699752F}"/>
                </a:ext>
              </a:extLst>
            </p:cNvPr>
            <p:cNvGrpSpPr/>
            <p:nvPr/>
          </p:nvGrpSpPr>
          <p:grpSpPr>
            <a:xfrm>
              <a:off x="210545" y="3425086"/>
              <a:ext cx="1574813" cy="1357490"/>
              <a:chOff x="218391" y="1204080"/>
              <a:chExt cx="1574813" cy="1357490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94D9103A-32ED-5042-BD4F-3FAAC39A74FF}"/>
                  </a:ext>
                </a:extLst>
              </p:cNvPr>
              <p:cNvSpPr txBox="1"/>
              <p:nvPr/>
            </p:nvSpPr>
            <p:spPr>
              <a:xfrm>
                <a:off x="218391" y="2065617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2ED2B39-A18A-E246-A903-4E784D3611CD}"/>
                  </a:ext>
                </a:extLst>
              </p:cNvPr>
              <p:cNvSpPr txBox="1"/>
              <p:nvPr/>
            </p:nvSpPr>
            <p:spPr>
              <a:xfrm>
                <a:off x="221923" y="1649073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4DA85459-FCBA-9D46-B19C-6D355BA3947E}"/>
                  </a:ext>
                </a:extLst>
              </p:cNvPr>
              <p:cNvSpPr txBox="1"/>
              <p:nvPr/>
            </p:nvSpPr>
            <p:spPr>
              <a:xfrm>
                <a:off x="218391" y="1204080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9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7B378060-8FC9-B54B-9632-DAA212204167}"/>
                  </a:ext>
                </a:extLst>
              </p:cNvPr>
              <p:cNvSpPr txBox="1"/>
              <p:nvPr/>
            </p:nvSpPr>
            <p:spPr>
              <a:xfrm>
                <a:off x="461084" y="2341935"/>
                <a:ext cx="2880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8CE52A0-3687-B842-AA88-F893D2496C70}"/>
                  </a:ext>
                </a:extLst>
              </p:cNvPr>
              <p:cNvSpPr txBox="1"/>
              <p:nvPr/>
            </p:nvSpPr>
            <p:spPr>
              <a:xfrm>
                <a:off x="693323" y="2345713"/>
                <a:ext cx="4901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33A5105A-B0B4-B84F-B346-8825F4830BC0}"/>
                  </a:ext>
                </a:extLst>
              </p:cNvPr>
              <p:cNvSpPr txBox="1"/>
              <p:nvPr/>
            </p:nvSpPr>
            <p:spPr>
              <a:xfrm>
                <a:off x="1007352" y="2346126"/>
                <a:ext cx="4901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E0A383C1-FFB8-4147-B704-E0D8FBE3A378}"/>
                  </a:ext>
                </a:extLst>
              </p:cNvPr>
              <p:cNvSpPr txBox="1"/>
              <p:nvPr/>
            </p:nvSpPr>
            <p:spPr>
              <a:xfrm>
                <a:off x="1303062" y="2341969"/>
                <a:ext cx="4901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</p:grp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7BDF5EC-ED97-184E-AE89-F3A47B005592}"/>
                </a:ext>
              </a:extLst>
            </p:cNvPr>
            <p:cNvSpPr txBox="1"/>
            <p:nvPr/>
          </p:nvSpPr>
          <p:spPr>
            <a:xfrm>
              <a:off x="818696" y="2518087"/>
              <a:ext cx="14727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rea_M0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083E92A-EC8E-FA4A-9B08-BD529E842D2F}"/>
                </a:ext>
              </a:extLst>
            </p:cNvPr>
            <p:cNvSpPr txBox="1"/>
            <p:nvPr/>
          </p:nvSpPr>
          <p:spPr>
            <a:xfrm>
              <a:off x="2121292" y="2328486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A59B1BD-14D7-2E49-A9CF-67510C11B814}"/>
                </a:ext>
              </a:extLst>
            </p:cNvPr>
            <p:cNvSpPr txBox="1"/>
            <p:nvPr/>
          </p:nvSpPr>
          <p:spPr>
            <a:xfrm>
              <a:off x="2390768" y="2328485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7174415-25E0-4647-879C-7CBB57679E06}"/>
                </a:ext>
              </a:extLst>
            </p:cNvPr>
            <p:cNvSpPr txBox="1"/>
            <p:nvPr/>
          </p:nvSpPr>
          <p:spPr>
            <a:xfrm>
              <a:off x="2642495" y="2328485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2F4412C-80BA-3B45-8DC1-671173A30E97}"/>
                </a:ext>
              </a:extLst>
            </p:cNvPr>
            <p:cNvSpPr txBox="1"/>
            <p:nvPr/>
          </p:nvSpPr>
          <p:spPr>
            <a:xfrm>
              <a:off x="2926966" y="2328485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5C4C327-4C66-FF42-9BFE-37D8AB37DBEF}"/>
                </a:ext>
              </a:extLst>
            </p:cNvPr>
            <p:cNvSpPr txBox="1"/>
            <p:nvPr/>
          </p:nvSpPr>
          <p:spPr>
            <a:xfrm>
              <a:off x="3186347" y="2328485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08079A08-9E24-5E4F-B0E8-4F4D3E223553}"/>
                </a:ext>
              </a:extLst>
            </p:cNvPr>
            <p:cNvGrpSpPr/>
            <p:nvPr/>
          </p:nvGrpSpPr>
          <p:grpSpPr>
            <a:xfrm>
              <a:off x="1969845" y="915845"/>
              <a:ext cx="579103" cy="1520363"/>
              <a:chOff x="1969845" y="915845"/>
              <a:chExt cx="579103" cy="1520363"/>
            </a:xfrm>
          </p:grpSpPr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030CAE1F-66B8-0742-9D3B-88CB50CF7CAC}"/>
                  </a:ext>
                </a:extLst>
              </p:cNvPr>
              <p:cNvSpPr txBox="1"/>
              <p:nvPr/>
            </p:nvSpPr>
            <p:spPr>
              <a:xfrm>
                <a:off x="2050004" y="2220764"/>
                <a:ext cx="2880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EB50AA0-6498-1D42-9C8A-D681FF2EA85B}"/>
                  </a:ext>
                </a:extLst>
              </p:cNvPr>
              <p:cNvSpPr txBox="1"/>
              <p:nvPr/>
            </p:nvSpPr>
            <p:spPr>
              <a:xfrm>
                <a:off x="1972771" y="1573776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FE320037-E62E-8142-8427-EB0143B33227}"/>
                  </a:ext>
                </a:extLst>
              </p:cNvPr>
              <p:cNvSpPr txBox="1"/>
              <p:nvPr/>
            </p:nvSpPr>
            <p:spPr>
              <a:xfrm>
                <a:off x="1969845" y="915845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F9E944E-D98C-0D43-868F-1ED65AB9D5DF}"/>
                </a:ext>
              </a:extLst>
            </p:cNvPr>
            <p:cNvSpPr txBox="1"/>
            <p:nvPr/>
          </p:nvSpPr>
          <p:spPr>
            <a:xfrm rot="16200000">
              <a:off x="1153243" y="1396618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rmalized Frequency 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E21B208-8261-3549-8FA1-F122B39A3525}"/>
                </a:ext>
              </a:extLst>
            </p:cNvPr>
            <p:cNvSpPr txBox="1"/>
            <p:nvPr/>
          </p:nvSpPr>
          <p:spPr>
            <a:xfrm>
              <a:off x="2180925" y="2497280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radient RMS_M01_Ch01</a:t>
              </a:r>
            </a:p>
          </p:txBody>
        </p:sp>
        <p:grpSp>
          <p:nvGrpSpPr>
            <p:cNvPr id="122" name="Group 121">
              <a:extLst>
                <a:ext uri="{FF2B5EF4-FFF2-40B4-BE49-F238E27FC236}">
                  <a16:creationId xmlns:a16="http://schemas.microsoft.com/office/drawing/2014/main" id="{5E605ED6-A4EE-2C44-B993-8FB00E3CF198}"/>
                </a:ext>
              </a:extLst>
            </p:cNvPr>
            <p:cNvGrpSpPr/>
            <p:nvPr/>
          </p:nvGrpSpPr>
          <p:grpSpPr>
            <a:xfrm>
              <a:off x="3639852" y="991828"/>
              <a:ext cx="542596" cy="1411955"/>
              <a:chOff x="3639852" y="991828"/>
              <a:chExt cx="542596" cy="1411955"/>
            </a:xfrm>
          </p:grpSpPr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A7327F1-4C8B-F94E-ABDB-D875A4889F8C}"/>
                  </a:ext>
                </a:extLst>
              </p:cNvPr>
              <p:cNvSpPr txBox="1"/>
              <p:nvPr/>
            </p:nvSpPr>
            <p:spPr>
              <a:xfrm>
                <a:off x="3793787" y="2188339"/>
                <a:ext cx="1054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27324DF4-532C-BD4D-B340-93119F254D4A}"/>
                  </a:ext>
                </a:extLst>
              </p:cNvPr>
              <p:cNvSpPr txBox="1"/>
              <p:nvPr/>
            </p:nvSpPr>
            <p:spPr>
              <a:xfrm>
                <a:off x="3639852" y="2038434"/>
                <a:ext cx="5317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3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9E7E8879-3CE6-2D46-B4A6-4DE5321F2AFF}"/>
                  </a:ext>
                </a:extLst>
              </p:cNvPr>
              <p:cNvSpPr txBox="1"/>
              <p:nvPr/>
            </p:nvSpPr>
            <p:spPr>
              <a:xfrm>
                <a:off x="3644896" y="1696757"/>
                <a:ext cx="5317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4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F847014C-A59E-9745-A637-D7F3AFC6D875}"/>
                  </a:ext>
                </a:extLst>
              </p:cNvPr>
              <p:cNvSpPr txBox="1"/>
              <p:nvPr/>
            </p:nvSpPr>
            <p:spPr>
              <a:xfrm>
                <a:off x="3648959" y="1348653"/>
                <a:ext cx="5317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5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F4B46518-A71B-9846-B237-4FF92377BA33}"/>
                  </a:ext>
                </a:extLst>
              </p:cNvPr>
              <p:cNvSpPr txBox="1"/>
              <p:nvPr/>
            </p:nvSpPr>
            <p:spPr>
              <a:xfrm>
                <a:off x="3650668" y="991828"/>
                <a:ext cx="5317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6</a:t>
                </a:r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29A8FBA-0E03-CD4B-B157-0635759A79D7}"/>
                </a:ext>
              </a:extLst>
            </p:cNvPr>
            <p:cNvSpPr txBox="1"/>
            <p:nvPr/>
          </p:nvSpPr>
          <p:spPr>
            <a:xfrm>
              <a:off x="3829456" y="2314799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1e3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20673FF-E331-A64F-A1CF-A5E4D59D0884}"/>
                </a:ext>
              </a:extLst>
            </p:cNvPr>
            <p:cNvSpPr txBox="1"/>
            <p:nvPr/>
          </p:nvSpPr>
          <p:spPr>
            <a:xfrm>
              <a:off x="4114797" y="2321284"/>
              <a:ext cx="1054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CFC5B121-1691-9242-AB2E-6CDFACA92DD6}"/>
                </a:ext>
              </a:extLst>
            </p:cNvPr>
            <p:cNvSpPr txBox="1"/>
            <p:nvPr/>
          </p:nvSpPr>
          <p:spPr>
            <a:xfrm>
              <a:off x="4130570" y="2315515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3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25E5BAF-4510-2B47-94FC-13E198BFB0CA}"/>
                </a:ext>
              </a:extLst>
            </p:cNvPr>
            <p:cNvSpPr txBox="1"/>
            <p:nvPr/>
          </p:nvSpPr>
          <p:spPr>
            <a:xfrm>
              <a:off x="4329987" y="2316745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4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B74E2D3-68A7-7442-A1B0-67CF31D30897}"/>
                </a:ext>
              </a:extLst>
            </p:cNvPr>
            <p:cNvSpPr txBox="1"/>
            <p:nvPr/>
          </p:nvSpPr>
          <p:spPr>
            <a:xfrm>
              <a:off x="4582032" y="2315313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5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CD669D6-2272-764F-A4D9-8AEA6E7506C0}"/>
                </a:ext>
              </a:extLst>
            </p:cNvPr>
            <p:cNvSpPr txBox="1"/>
            <p:nvPr/>
          </p:nvSpPr>
          <p:spPr>
            <a:xfrm>
              <a:off x="4823556" y="2320287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6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2CF983C-3D0D-6340-A896-04AEF0CD1445}"/>
                </a:ext>
              </a:extLst>
            </p:cNvPr>
            <p:cNvSpPr txBox="1"/>
            <p:nvPr/>
          </p:nvSpPr>
          <p:spPr>
            <a:xfrm rot="16200000">
              <a:off x="2848796" y="1339951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nsity_MC_Ch02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14C3B96-7D36-544D-8412-BAF70D0D5A56}"/>
                </a:ext>
              </a:extLst>
            </p:cNvPr>
            <p:cNvSpPr txBox="1"/>
            <p:nvPr/>
          </p:nvSpPr>
          <p:spPr>
            <a:xfrm>
              <a:off x="4021770" y="2479434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nsity_MC_Ch12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49CC361-4EAA-7340-AC8D-511345348AEE}"/>
                </a:ext>
              </a:extLst>
            </p:cNvPr>
            <p:cNvSpPr txBox="1"/>
            <p:nvPr/>
          </p:nvSpPr>
          <p:spPr>
            <a:xfrm>
              <a:off x="5611713" y="2229080"/>
              <a:ext cx="1054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11BA2D1-A668-0346-8BF3-50FB4AC0D207}"/>
                </a:ext>
              </a:extLst>
            </p:cNvPr>
            <p:cNvSpPr txBox="1"/>
            <p:nvPr/>
          </p:nvSpPr>
          <p:spPr>
            <a:xfrm>
              <a:off x="5480678" y="1994181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5743E4B-3701-E54B-B35B-4232B1196F32}"/>
                </a:ext>
              </a:extLst>
            </p:cNvPr>
            <p:cNvSpPr txBox="1"/>
            <p:nvPr/>
          </p:nvSpPr>
          <p:spPr>
            <a:xfrm>
              <a:off x="5487467" y="1732207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31F5E75-4036-2044-A2AC-AE72A4B91D47}"/>
                </a:ext>
              </a:extLst>
            </p:cNvPr>
            <p:cNvSpPr txBox="1"/>
            <p:nvPr/>
          </p:nvSpPr>
          <p:spPr>
            <a:xfrm>
              <a:off x="5487466" y="1481931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7EABCE7F-80BA-784B-8073-9331153D8920}"/>
                </a:ext>
              </a:extLst>
            </p:cNvPr>
            <p:cNvSpPr txBox="1"/>
            <p:nvPr/>
          </p:nvSpPr>
          <p:spPr>
            <a:xfrm>
              <a:off x="5487465" y="1217255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BB38429-6F17-D44F-8616-CA844693FDCC}"/>
                </a:ext>
              </a:extLst>
            </p:cNvPr>
            <p:cNvSpPr txBox="1"/>
            <p:nvPr/>
          </p:nvSpPr>
          <p:spPr>
            <a:xfrm>
              <a:off x="5571769" y="962901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5FFA08A-1DD2-3843-AD89-7C3481BBC326}"/>
                </a:ext>
              </a:extLst>
            </p:cNvPr>
            <p:cNvSpPr txBox="1"/>
            <p:nvPr/>
          </p:nvSpPr>
          <p:spPr>
            <a:xfrm>
              <a:off x="5699263" y="2342570"/>
              <a:ext cx="1054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7E07FC56-44D9-5E4F-8B51-F0530A60D244}"/>
                </a:ext>
              </a:extLst>
            </p:cNvPr>
            <p:cNvSpPr txBox="1"/>
            <p:nvPr/>
          </p:nvSpPr>
          <p:spPr>
            <a:xfrm>
              <a:off x="5721546" y="2341626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92F9A3DB-BF2A-5F44-B21D-ADF10CA8FF27}"/>
                </a:ext>
              </a:extLst>
            </p:cNvPr>
            <p:cNvSpPr txBox="1"/>
            <p:nvPr/>
          </p:nvSpPr>
          <p:spPr>
            <a:xfrm>
              <a:off x="5944781" y="2336802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4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74B909A-022C-E740-A2A2-4C3F88DF845E}"/>
                </a:ext>
              </a:extLst>
            </p:cNvPr>
            <p:cNvSpPr txBox="1"/>
            <p:nvPr/>
          </p:nvSpPr>
          <p:spPr>
            <a:xfrm>
              <a:off x="6238771" y="2335141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5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E2D296CC-B49E-444C-9A73-E2E49990FF5E}"/>
                </a:ext>
              </a:extLst>
            </p:cNvPr>
            <p:cNvSpPr txBox="1"/>
            <p:nvPr/>
          </p:nvSpPr>
          <p:spPr>
            <a:xfrm>
              <a:off x="6521664" y="2327610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6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77CE381-21EA-9F4A-98D5-607D82087D9C}"/>
                </a:ext>
              </a:extLst>
            </p:cNvPr>
            <p:cNvSpPr txBox="1"/>
            <p:nvPr/>
          </p:nvSpPr>
          <p:spPr>
            <a:xfrm>
              <a:off x="6814904" y="2337264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7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CFCD9630-3F75-5444-8654-0B182AC77DD1}"/>
                </a:ext>
              </a:extLst>
            </p:cNvPr>
            <p:cNvSpPr txBox="1"/>
            <p:nvPr/>
          </p:nvSpPr>
          <p:spPr>
            <a:xfrm rot="16200000">
              <a:off x="4622806" y="1389996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rmalized Frequency 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483640F6-9758-9844-B85D-1105E3204C44}"/>
                </a:ext>
              </a:extLst>
            </p:cNvPr>
            <p:cNvSpPr txBox="1"/>
            <p:nvPr/>
          </p:nvSpPr>
          <p:spPr>
            <a:xfrm>
              <a:off x="5898819" y="2492170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nsity_MC_Ch03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C14985A8-8948-2D43-BA9B-1826B930D5C6}"/>
                </a:ext>
              </a:extLst>
            </p:cNvPr>
            <p:cNvSpPr txBox="1"/>
            <p:nvPr/>
          </p:nvSpPr>
          <p:spPr>
            <a:xfrm>
              <a:off x="7410983" y="2229711"/>
              <a:ext cx="1054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31A6F52E-3180-FB42-8EA1-72034084F34A}"/>
                </a:ext>
              </a:extLst>
            </p:cNvPr>
            <p:cNvSpPr txBox="1"/>
            <p:nvPr/>
          </p:nvSpPr>
          <p:spPr>
            <a:xfrm>
              <a:off x="7279948" y="1994812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36CE13F5-A3FF-7941-A04A-FA43E48EBE8A}"/>
                </a:ext>
              </a:extLst>
            </p:cNvPr>
            <p:cNvSpPr txBox="1"/>
            <p:nvPr/>
          </p:nvSpPr>
          <p:spPr>
            <a:xfrm>
              <a:off x="7286737" y="1732838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11E66842-E125-0C45-B616-2EB6EEBCF01D}"/>
                </a:ext>
              </a:extLst>
            </p:cNvPr>
            <p:cNvSpPr txBox="1"/>
            <p:nvPr/>
          </p:nvSpPr>
          <p:spPr>
            <a:xfrm>
              <a:off x="7286736" y="1482562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F75A7D37-B0F8-3947-AA4E-5DFC235472E9}"/>
                </a:ext>
              </a:extLst>
            </p:cNvPr>
            <p:cNvSpPr txBox="1"/>
            <p:nvPr/>
          </p:nvSpPr>
          <p:spPr>
            <a:xfrm>
              <a:off x="7286735" y="1217886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B180BC4A-FCA4-B84E-9981-880A34AD60A3}"/>
                </a:ext>
              </a:extLst>
            </p:cNvPr>
            <p:cNvSpPr txBox="1"/>
            <p:nvPr/>
          </p:nvSpPr>
          <p:spPr>
            <a:xfrm>
              <a:off x="7371039" y="963532"/>
              <a:ext cx="3977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AC130096-0E6F-E749-9615-A6732D41918B}"/>
                </a:ext>
              </a:extLst>
            </p:cNvPr>
            <p:cNvSpPr txBox="1"/>
            <p:nvPr/>
          </p:nvSpPr>
          <p:spPr>
            <a:xfrm>
              <a:off x="7411264" y="2349097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3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225B31A-B0B6-AE46-BFD3-C6D9DB0F3D1D}"/>
                </a:ext>
              </a:extLst>
            </p:cNvPr>
            <p:cNvSpPr txBox="1"/>
            <p:nvPr/>
          </p:nvSpPr>
          <p:spPr>
            <a:xfrm>
              <a:off x="7778655" y="2338952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4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BD6F48BC-2222-8F4E-A7B2-571C88E09D4B}"/>
                </a:ext>
              </a:extLst>
            </p:cNvPr>
            <p:cNvSpPr txBox="1"/>
            <p:nvPr/>
          </p:nvSpPr>
          <p:spPr>
            <a:xfrm>
              <a:off x="8195284" y="2341626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5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168597F8-B30A-C843-BC55-8C0D12ABAB36}"/>
                </a:ext>
              </a:extLst>
            </p:cNvPr>
            <p:cNvSpPr txBox="1"/>
            <p:nvPr/>
          </p:nvSpPr>
          <p:spPr>
            <a:xfrm>
              <a:off x="8587681" y="2340595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6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08D2B600-9A0C-6F4F-979C-6032ABF7418B}"/>
                </a:ext>
              </a:extLst>
            </p:cNvPr>
            <p:cNvSpPr txBox="1"/>
            <p:nvPr/>
          </p:nvSpPr>
          <p:spPr>
            <a:xfrm rot="16200000">
              <a:off x="6425828" y="1417229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rmalized Frequency 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1E02CB66-D9FA-CF41-A88B-AE1B7CED8272}"/>
                </a:ext>
              </a:extLst>
            </p:cNvPr>
            <p:cNvSpPr txBox="1"/>
            <p:nvPr/>
          </p:nvSpPr>
          <p:spPr>
            <a:xfrm>
              <a:off x="7728778" y="2489924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rnalized SRBCs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53E95CDE-F52A-034C-9A6F-0B38A0B56FE1}"/>
                </a:ext>
              </a:extLst>
            </p:cNvPr>
            <p:cNvSpPr txBox="1"/>
            <p:nvPr/>
          </p:nvSpPr>
          <p:spPr>
            <a:xfrm>
              <a:off x="781818" y="818378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4B87775-3E59-B942-9F6C-4C011FEDA2EC}"/>
                </a:ext>
              </a:extLst>
            </p:cNvPr>
            <p:cNvSpPr txBox="1"/>
            <p:nvPr/>
          </p:nvSpPr>
          <p:spPr>
            <a:xfrm>
              <a:off x="2454225" y="814537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ocused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7818FBBD-D33A-744E-B0B0-B79BBF8048EC}"/>
                </a:ext>
              </a:extLst>
            </p:cNvPr>
            <p:cNvSpPr txBox="1"/>
            <p:nvPr/>
          </p:nvSpPr>
          <p:spPr>
            <a:xfrm>
              <a:off x="4042426" y="817605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11b+Ly6C high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9E1F1BCA-9528-544B-A462-225352E1F977}"/>
                </a:ext>
              </a:extLst>
            </p:cNvPr>
            <p:cNvSpPr txBox="1"/>
            <p:nvPr/>
          </p:nvSpPr>
          <p:spPr>
            <a:xfrm>
              <a:off x="6109119" y="838263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RBC+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D36BAD7-C63F-4042-B36A-629C2A27ADF0}"/>
                </a:ext>
              </a:extLst>
            </p:cNvPr>
            <p:cNvSpPr txBox="1"/>
            <p:nvPr/>
          </p:nvSpPr>
          <p:spPr>
            <a:xfrm>
              <a:off x="7624861" y="842745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rnalized SRBC+</a:t>
              </a:r>
            </a:p>
          </p:txBody>
        </p:sp>
        <p:pic>
          <p:nvPicPr>
            <p:cNvPr id="85" name="図 20">
              <a:extLst>
                <a:ext uri="{FF2B5EF4-FFF2-40B4-BE49-F238E27FC236}">
                  <a16:creationId xmlns:a16="http://schemas.microsoft.com/office/drawing/2014/main" id="{DD23693D-97DE-DB43-8D6A-D46AB43F783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88688" y="5497593"/>
              <a:ext cx="1338263" cy="914400"/>
            </a:xfrm>
            <a:prstGeom prst="rect">
              <a:avLst/>
            </a:prstGeom>
          </p:spPr>
        </p:pic>
        <p:pic>
          <p:nvPicPr>
            <p:cNvPr id="86" name="図 54">
              <a:extLst>
                <a:ext uri="{FF2B5EF4-FFF2-40B4-BE49-F238E27FC236}">
                  <a16:creationId xmlns:a16="http://schemas.microsoft.com/office/drawing/2014/main" id="{18186726-730E-BB41-BE11-F5AFFBB6C82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/>
            <a:srcRect l="16114" t="5808" b="15302"/>
            <a:stretch/>
          </p:blipFill>
          <p:spPr>
            <a:xfrm>
              <a:off x="445313" y="3234780"/>
              <a:ext cx="1371600" cy="1371600"/>
            </a:xfrm>
            <a:prstGeom prst="rect">
              <a:avLst/>
            </a:prstGeom>
          </p:spPr>
        </p:pic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6360C6BB-ED2B-7440-8B04-88BE7D70D737}"/>
                </a:ext>
              </a:extLst>
            </p:cNvPr>
            <p:cNvGrpSpPr/>
            <p:nvPr/>
          </p:nvGrpSpPr>
          <p:grpSpPr>
            <a:xfrm>
              <a:off x="224566" y="1205228"/>
              <a:ext cx="1574813" cy="1357490"/>
              <a:chOff x="218391" y="1204080"/>
              <a:chExt cx="1574813" cy="1357490"/>
            </a:xfrm>
          </p:grpSpPr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687C17B2-2277-E24E-A4EA-3B863BFA6601}"/>
                  </a:ext>
                </a:extLst>
              </p:cNvPr>
              <p:cNvSpPr txBox="1"/>
              <p:nvPr/>
            </p:nvSpPr>
            <p:spPr>
              <a:xfrm>
                <a:off x="218391" y="2065617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A618BB51-8374-CB4C-9D9A-6CD29F612ECF}"/>
                  </a:ext>
                </a:extLst>
              </p:cNvPr>
              <p:cNvSpPr txBox="1"/>
              <p:nvPr/>
            </p:nvSpPr>
            <p:spPr>
              <a:xfrm>
                <a:off x="221923" y="1637571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22B220E1-20D8-524C-A4B8-B6766CF4774F}"/>
                  </a:ext>
                </a:extLst>
              </p:cNvPr>
              <p:cNvSpPr txBox="1"/>
              <p:nvPr/>
            </p:nvSpPr>
            <p:spPr>
              <a:xfrm>
                <a:off x="218391" y="1204080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9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7148511B-8AA1-694E-9E65-DD380D933794}"/>
                  </a:ext>
                </a:extLst>
              </p:cNvPr>
              <p:cNvSpPr txBox="1"/>
              <p:nvPr/>
            </p:nvSpPr>
            <p:spPr>
              <a:xfrm>
                <a:off x="461084" y="2341935"/>
                <a:ext cx="2880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565B64C0-11FD-F348-944C-65F8EFB0BABB}"/>
                  </a:ext>
                </a:extLst>
              </p:cNvPr>
              <p:cNvSpPr txBox="1"/>
              <p:nvPr/>
            </p:nvSpPr>
            <p:spPr>
              <a:xfrm>
                <a:off x="693323" y="2345713"/>
                <a:ext cx="4901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8289ED0E-9AA9-D747-A9EC-C9482D5C9492}"/>
                  </a:ext>
                </a:extLst>
              </p:cNvPr>
              <p:cNvSpPr txBox="1"/>
              <p:nvPr/>
            </p:nvSpPr>
            <p:spPr>
              <a:xfrm>
                <a:off x="1007352" y="2346126"/>
                <a:ext cx="4901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C50570C2-6B63-C14B-BF34-D0BF80804230}"/>
                  </a:ext>
                </a:extLst>
              </p:cNvPr>
              <p:cNvSpPr txBox="1"/>
              <p:nvPr/>
            </p:nvSpPr>
            <p:spPr>
              <a:xfrm>
                <a:off x="1303062" y="2341969"/>
                <a:ext cx="4901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</a:p>
            </p:txBody>
          </p:sp>
        </p:grp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00579D45-C5A2-A44D-96EE-01D5D05FBBC5}"/>
                </a:ext>
              </a:extLst>
            </p:cNvPr>
            <p:cNvSpPr txBox="1"/>
            <p:nvPr/>
          </p:nvSpPr>
          <p:spPr>
            <a:xfrm rot="16200000">
              <a:off x="-612017" y="3522816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spect ratio_M01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4255988B-6331-DE43-8DC0-E923C6B64F65}"/>
                </a:ext>
              </a:extLst>
            </p:cNvPr>
            <p:cNvSpPr txBox="1"/>
            <p:nvPr/>
          </p:nvSpPr>
          <p:spPr>
            <a:xfrm>
              <a:off x="827774" y="4740479"/>
              <a:ext cx="14727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rea_M01</a:t>
              </a:r>
            </a:p>
          </p:txBody>
        </p:sp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id="{AC2F77FF-D6F6-AE45-9961-17CC596EC79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9"/>
            <a:srcRect l="15622" t="9522" b="13740"/>
            <a:stretch/>
          </p:blipFill>
          <p:spPr>
            <a:xfrm>
              <a:off x="2209377" y="3255685"/>
              <a:ext cx="1371600" cy="1371600"/>
            </a:xfrm>
            <a:prstGeom prst="rect">
              <a:avLst/>
            </a:prstGeom>
          </p:spPr>
        </p:pic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39F21DFD-A031-4A46-8408-8EA0CF3AB4A9}"/>
                </a:ext>
              </a:extLst>
            </p:cNvPr>
            <p:cNvGrpSpPr/>
            <p:nvPr/>
          </p:nvGrpSpPr>
          <p:grpSpPr>
            <a:xfrm>
              <a:off x="1978421" y="3510443"/>
              <a:ext cx="579103" cy="1186805"/>
              <a:chOff x="1981347" y="1249403"/>
              <a:chExt cx="579103" cy="1186805"/>
            </a:xfrm>
          </p:grpSpPr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9F684D06-64A1-5E45-9835-744B86B18A65}"/>
                  </a:ext>
                </a:extLst>
              </p:cNvPr>
              <p:cNvSpPr txBox="1"/>
              <p:nvPr/>
            </p:nvSpPr>
            <p:spPr>
              <a:xfrm>
                <a:off x="2050004" y="2220764"/>
                <a:ext cx="2880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A7E182F6-10F5-D24E-B05E-6F2F8DC22389}"/>
                  </a:ext>
                </a:extLst>
              </p:cNvPr>
              <p:cNvSpPr txBox="1"/>
              <p:nvPr/>
            </p:nvSpPr>
            <p:spPr>
              <a:xfrm>
                <a:off x="1984273" y="1734804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B12E88F6-4751-3446-887A-41C83FCD268B}"/>
                  </a:ext>
                </a:extLst>
              </p:cNvPr>
              <p:cNvSpPr txBox="1"/>
              <p:nvPr/>
            </p:nvSpPr>
            <p:spPr>
              <a:xfrm>
                <a:off x="1981347" y="1249403"/>
                <a:ext cx="57617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6</a:t>
                </a:r>
              </a:p>
            </p:txBody>
          </p:sp>
        </p:grp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C0FE5ACE-6B51-7749-BAB9-B3FDED9BAB56}"/>
                </a:ext>
              </a:extLst>
            </p:cNvPr>
            <p:cNvSpPr txBox="1"/>
            <p:nvPr/>
          </p:nvSpPr>
          <p:spPr>
            <a:xfrm>
              <a:off x="2131677" y="4568731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A9937491-A8CD-D94A-BBD3-A9FCEA05C1DD}"/>
                </a:ext>
              </a:extLst>
            </p:cNvPr>
            <p:cNvSpPr txBox="1"/>
            <p:nvPr/>
          </p:nvSpPr>
          <p:spPr>
            <a:xfrm>
              <a:off x="2401153" y="4568730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CACD2D4F-182B-344B-ABF8-D079DA70E3C4}"/>
                </a:ext>
              </a:extLst>
            </p:cNvPr>
            <p:cNvSpPr txBox="1"/>
            <p:nvPr/>
          </p:nvSpPr>
          <p:spPr>
            <a:xfrm>
              <a:off x="2652880" y="4568730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E9169327-9094-A245-A29F-011E1F313784}"/>
                </a:ext>
              </a:extLst>
            </p:cNvPr>
            <p:cNvSpPr txBox="1"/>
            <p:nvPr/>
          </p:nvSpPr>
          <p:spPr>
            <a:xfrm>
              <a:off x="2937351" y="4568730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57E82801-20A2-2C4C-AAE9-C2C4991651DC}"/>
                </a:ext>
              </a:extLst>
            </p:cNvPr>
            <p:cNvSpPr txBox="1"/>
            <p:nvPr/>
          </p:nvSpPr>
          <p:spPr>
            <a:xfrm>
              <a:off x="3196732" y="4568730"/>
              <a:ext cx="4713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3A2EECFF-2F16-6F4A-B3FC-472344EDEC23}"/>
                </a:ext>
              </a:extLst>
            </p:cNvPr>
            <p:cNvSpPr txBox="1"/>
            <p:nvPr/>
          </p:nvSpPr>
          <p:spPr>
            <a:xfrm>
              <a:off x="2148129" y="4726244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radient RMS_M01_Ch01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F1F52968-3F0A-FD4C-B3A1-828977982A65}"/>
                </a:ext>
              </a:extLst>
            </p:cNvPr>
            <p:cNvSpPr txBox="1"/>
            <p:nvPr/>
          </p:nvSpPr>
          <p:spPr>
            <a:xfrm rot="16200000">
              <a:off x="1178969" y="3667165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rmalized Frequency </a:t>
              </a:r>
            </a:p>
          </p:txBody>
        </p:sp>
        <p:pic>
          <p:nvPicPr>
            <p:cNvPr id="121" name="Picture 120">
              <a:extLst>
                <a:ext uri="{FF2B5EF4-FFF2-40B4-BE49-F238E27FC236}">
                  <a16:creationId xmlns:a16="http://schemas.microsoft.com/office/drawing/2014/main" id="{CD1D58FA-0B62-1146-BBA2-0DBDE556F69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/>
            <a:srcRect l="16445" t="9600" b="14351"/>
            <a:stretch/>
          </p:blipFill>
          <p:spPr>
            <a:xfrm>
              <a:off x="3881268" y="3242274"/>
              <a:ext cx="1371600" cy="1371600"/>
            </a:xfrm>
            <a:prstGeom prst="rect">
              <a:avLst/>
            </a:prstGeom>
          </p:spPr>
        </p:pic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id="{7E9B4FDB-15E0-714F-A44F-5CC3E1739426}"/>
                </a:ext>
              </a:extLst>
            </p:cNvPr>
            <p:cNvGrpSpPr/>
            <p:nvPr/>
          </p:nvGrpSpPr>
          <p:grpSpPr>
            <a:xfrm>
              <a:off x="3624936" y="3255036"/>
              <a:ext cx="542575" cy="1423457"/>
              <a:chOff x="3639852" y="991828"/>
              <a:chExt cx="542575" cy="1423457"/>
            </a:xfrm>
          </p:grpSpPr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34D2D129-CB58-A34E-B5C0-BA26E73CD203}"/>
                  </a:ext>
                </a:extLst>
              </p:cNvPr>
              <p:cNvSpPr txBox="1"/>
              <p:nvPr/>
            </p:nvSpPr>
            <p:spPr>
              <a:xfrm>
                <a:off x="3793787" y="2199841"/>
                <a:ext cx="1054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7925093A-CCEB-8D4A-A86A-E68A015FA439}"/>
                  </a:ext>
                </a:extLst>
              </p:cNvPr>
              <p:cNvSpPr txBox="1"/>
              <p:nvPr/>
            </p:nvSpPr>
            <p:spPr>
              <a:xfrm>
                <a:off x="3639852" y="2055687"/>
                <a:ext cx="5317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3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66EEBBA6-9757-674E-B82F-CD4A36D26C6C}"/>
                  </a:ext>
                </a:extLst>
              </p:cNvPr>
              <p:cNvSpPr txBox="1"/>
              <p:nvPr/>
            </p:nvSpPr>
            <p:spPr>
              <a:xfrm>
                <a:off x="3650647" y="1696757"/>
                <a:ext cx="5317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4</a:t>
                </a: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D07CFF95-347D-9445-A771-E49280E70C8B}"/>
                  </a:ext>
                </a:extLst>
              </p:cNvPr>
              <p:cNvSpPr txBox="1"/>
              <p:nvPr/>
            </p:nvSpPr>
            <p:spPr>
              <a:xfrm>
                <a:off x="3643208" y="1342902"/>
                <a:ext cx="5317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5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FCC29BE7-EB55-0140-8C6B-F094855FACE0}"/>
                  </a:ext>
                </a:extLst>
              </p:cNvPr>
              <p:cNvSpPr txBox="1"/>
              <p:nvPr/>
            </p:nvSpPr>
            <p:spPr>
              <a:xfrm>
                <a:off x="3644917" y="991828"/>
                <a:ext cx="5317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e6</a:t>
                </a:r>
              </a:p>
            </p:txBody>
          </p:sp>
        </p:grp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83FDCFBD-A57F-0345-99E8-5E1D92643ADA}"/>
                </a:ext>
              </a:extLst>
            </p:cNvPr>
            <p:cNvSpPr txBox="1"/>
            <p:nvPr/>
          </p:nvSpPr>
          <p:spPr>
            <a:xfrm>
              <a:off x="3803202" y="4565028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1e3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02BBDE11-2F99-2E40-AFBE-EF76863722E6}"/>
                </a:ext>
              </a:extLst>
            </p:cNvPr>
            <p:cNvSpPr txBox="1"/>
            <p:nvPr/>
          </p:nvSpPr>
          <p:spPr>
            <a:xfrm>
              <a:off x="4091075" y="4560045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3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C469BBE1-25C8-5C4E-8C21-D9AE28413CA8}"/>
                </a:ext>
              </a:extLst>
            </p:cNvPr>
            <p:cNvSpPr txBox="1"/>
            <p:nvPr/>
          </p:nvSpPr>
          <p:spPr>
            <a:xfrm>
              <a:off x="4016297" y="4568674"/>
              <a:ext cx="2788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700B32F6-95BA-BE47-94F5-B9A6D6B8EB8C}"/>
                </a:ext>
              </a:extLst>
            </p:cNvPr>
            <p:cNvSpPr txBox="1"/>
            <p:nvPr/>
          </p:nvSpPr>
          <p:spPr>
            <a:xfrm>
              <a:off x="4301687" y="4557913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4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79C69C24-F3A3-1247-924E-EF4F91A65081}"/>
                </a:ext>
              </a:extLst>
            </p:cNvPr>
            <p:cNvSpPr txBox="1"/>
            <p:nvPr/>
          </p:nvSpPr>
          <p:spPr>
            <a:xfrm>
              <a:off x="4542375" y="4555618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5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EDDA1660-5BF3-644D-8BB5-3962139BF777}"/>
                </a:ext>
              </a:extLst>
            </p:cNvPr>
            <p:cNvSpPr txBox="1"/>
            <p:nvPr/>
          </p:nvSpPr>
          <p:spPr>
            <a:xfrm>
              <a:off x="4787772" y="4554294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6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BA27881F-4032-2241-A17E-B20ECE37A1D8}"/>
                </a:ext>
              </a:extLst>
            </p:cNvPr>
            <p:cNvSpPr txBox="1"/>
            <p:nvPr/>
          </p:nvSpPr>
          <p:spPr>
            <a:xfrm rot="16200000">
              <a:off x="2840541" y="3583458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nsity_MC_Ch02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603EB991-1B9B-3D42-A0DC-7011B7608E23}"/>
                </a:ext>
              </a:extLst>
            </p:cNvPr>
            <p:cNvSpPr txBox="1"/>
            <p:nvPr/>
          </p:nvSpPr>
          <p:spPr>
            <a:xfrm>
              <a:off x="3973258" y="4714939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nsity_MC_Ch12</a:t>
              </a:r>
            </a:p>
          </p:txBody>
        </p:sp>
        <p:pic>
          <p:nvPicPr>
            <p:cNvPr id="138" name="Picture 137">
              <a:extLst>
                <a:ext uri="{FF2B5EF4-FFF2-40B4-BE49-F238E27FC236}">
                  <a16:creationId xmlns:a16="http://schemas.microsoft.com/office/drawing/2014/main" id="{E59554F0-C7A8-7946-99BB-55AB66BEA2E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1"/>
            <a:srcRect l="15585" t="9946" b="13734"/>
            <a:stretch/>
          </p:blipFill>
          <p:spPr>
            <a:xfrm>
              <a:off x="5670786" y="3255685"/>
              <a:ext cx="1371600" cy="1371600"/>
            </a:xfrm>
            <a:prstGeom prst="rect">
              <a:avLst/>
            </a:prstGeom>
          </p:spPr>
        </p:pic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7BDCCF93-CAC5-684B-995B-0DF1BAEBC366}"/>
                </a:ext>
              </a:extLst>
            </p:cNvPr>
            <p:cNvSpPr txBox="1"/>
            <p:nvPr/>
          </p:nvSpPr>
          <p:spPr>
            <a:xfrm rot="10800000" flipV="1">
              <a:off x="5522452" y="4463310"/>
              <a:ext cx="3821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1421CE3B-4640-174C-94EA-94F418A2F522}"/>
                </a:ext>
              </a:extLst>
            </p:cNvPr>
            <p:cNvSpPr txBox="1"/>
            <p:nvPr/>
          </p:nvSpPr>
          <p:spPr>
            <a:xfrm rot="10800000" flipV="1">
              <a:off x="5445619" y="4044331"/>
              <a:ext cx="3821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AF7D249C-08D9-7A4D-996B-A7A8F060410F}"/>
                </a:ext>
              </a:extLst>
            </p:cNvPr>
            <p:cNvSpPr txBox="1"/>
            <p:nvPr/>
          </p:nvSpPr>
          <p:spPr>
            <a:xfrm rot="10800000" flipV="1">
              <a:off x="5445697" y="3609031"/>
              <a:ext cx="3821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678B73C9-9967-E147-B8D2-ED7AFAE94CB2}"/>
                </a:ext>
              </a:extLst>
            </p:cNvPr>
            <p:cNvSpPr txBox="1"/>
            <p:nvPr/>
          </p:nvSpPr>
          <p:spPr>
            <a:xfrm rot="10800000" flipV="1">
              <a:off x="5445618" y="3183150"/>
              <a:ext cx="3821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9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8B98A6FB-3A50-C94E-90AC-9B21627DEEF3}"/>
                </a:ext>
              </a:extLst>
            </p:cNvPr>
            <p:cNvSpPr txBox="1"/>
            <p:nvPr/>
          </p:nvSpPr>
          <p:spPr>
            <a:xfrm>
              <a:off x="5532976" y="4562941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4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312C4DD6-BDFC-6F4A-B9D0-716145FC2614}"/>
                </a:ext>
              </a:extLst>
            </p:cNvPr>
            <p:cNvSpPr txBox="1"/>
            <p:nvPr/>
          </p:nvSpPr>
          <p:spPr>
            <a:xfrm>
              <a:off x="6276848" y="4546207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5</a:t>
              </a:r>
            </a:p>
          </p:txBody>
        </p:sp>
        <p:pic>
          <p:nvPicPr>
            <p:cNvPr id="146" name="図 47">
              <a:extLst>
                <a:ext uri="{FF2B5EF4-FFF2-40B4-BE49-F238E27FC236}">
                  <a16:creationId xmlns:a16="http://schemas.microsoft.com/office/drawing/2014/main" id="{E61D9F57-3B13-5745-A8A8-C8BCC34643F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/>
            <a:srcRect l="16326" t="9885" b="15015"/>
            <a:stretch/>
          </p:blipFill>
          <p:spPr>
            <a:xfrm>
              <a:off x="7460304" y="3274165"/>
              <a:ext cx="1371600" cy="1371600"/>
            </a:xfrm>
            <a:prstGeom prst="rect">
              <a:avLst/>
            </a:prstGeom>
          </p:spPr>
        </p:pic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72C911B7-D890-C942-8356-C6F9D7275799}"/>
                </a:ext>
              </a:extLst>
            </p:cNvPr>
            <p:cNvSpPr txBox="1"/>
            <p:nvPr/>
          </p:nvSpPr>
          <p:spPr>
            <a:xfrm>
              <a:off x="7372713" y="4606380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4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03853A2F-D03C-CF40-A882-E9086DDC2C7B}"/>
                </a:ext>
              </a:extLst>
            </p:cNvPr>
            <p:cNvSpPr txBox="1"/>
            <p:nvPr/>
          </p:nvSpPr>
          <p:spPr>
            <a:xfrm>
              <a:off x="8023821" y="4589646"/>
              <a:ext cx="4118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1e5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C6731C37-2A9A-7848-B0F6-88A58F6A7156}"/>
                </a:ext>
              </a:extLst>
            </p:cNvPr>
            <p:cNvSpPr txBox="1"/>
            <p:nvPr/>
          </p:nvSpPr>
          <p:spPr>
            <a:xfrm rot="10800000" flipV="1">
              <a:off x="7309145" y="4496046"/>
              <a:ext cx="3821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1A16F047-D74C-3245-8AFB-EE2E86FBA3FD}"/>
                </a:ext>
              </a:extLst>
            </p:cNvPr>
            <p:cNvSpPr txBox="1"/>
            <p:nvPr/>
          </p:nvSpPr>
          <p:spPr>
            <a:xfrm rot="10800000" flipV="1">
              <a:off x="7219060" y="4024059"/>
              <a:ext cx="3821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B4A8B52B-0344-EB4A-8713-5BA581D112AB}"/>
                </a:ext>
              </a:extLst>
            </p:cNvPr>
            <p:cNvSpPr txBox="1"/>
            <p:nvPr/>
          </p:nvSpPr>
          <p:spPr>
            <a:xfrm rot="10800000" flipV="1">
              <a:off x="7225450" y="3510443"/>
              <a:ext cx="3821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488AA981-109E-364C-AAEC-81AD9DA19F8B}"/>
                </a:ext>
              </a:extLst>
            </p:cNvPr>
            <p:cNvSpPr txBox="1"/>
            <p:nvPr/>
          </p:nvSpPr>
          <p:spPr>
            <a:xfrm rot="16200000">
              <a:off x="4633393" y="3568147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rmalized Frequency 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864DF17A-2653-6046-B285-9D67FC0C1C9F}"/>
                </a:ext>
              </a:extLst>
            </p:cNvPr>
            <p:cNvSpPr txBox="1"/>
            <p:nvPr/>
          </p:nvSpPr>
          <p:spPr>
            <a:xfrm>
              <a:off x="5851729" y="4707216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nsity_MC_Ch04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518C08A6-D832-4C4E-B361-D406A8791168}"/>
                </a:ext>
              </a:extLst>
            </p:cNvPr>
            <p:cNvSpPr txBox="1"/>
            <p:nvPr/>
          </p:nvSpPr>
          <p:spPr>
            <a:xfrm rot="16200000">
              <a:off x="6413418" y="3703136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rmalized Frequency 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ECED49EC-D077-9140-AF52-794229B7B06B}"/>
                </a:ext>
              </a:extLst>
            </p:cNvPr>
            <p:cNvSpPr txBox="1"/>
            <p:nvPr/>
          </p:nvSpPr>
          <p:spPr>
            <a:xfrm>
              <a:off x="7636856" y="4702041"/>
              <a:ext cx="1640276" cy="2234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rnalized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pHrodo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9B9B486C-0670-4E4B-B04B-FA573DE59125}"/>
                </a:ext>
              </a:extLst>
            </p:cNvPr>
            <p:cNvSpPr txBox="1"/>
            <p:nvPr/>
          </p:nvSpPr>
          <p:spPr>
            <a:xfrm>
              <a:off x="744687" y="3064024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1CD5BDE4-9CFA-724D-B4C4-9D99B6ADD8BE}"/>
                </a:ext>
              </a:extLst>
            </p:cNvPr>
            <p:cNvSpPr txBox="1"/>
            <p:nvPr/>
          </p:nvSpPr>
          <p:spPr>
            <a:xfrm>
              <a:off x="2550369" y="3073435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Focused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58F014F8-5678-2A44-A08F-BFA0A8BDFE48}"/>
                </a:ext>
              </a:extLst>
            </p:cNvPr>
            <p:cNvSpPr txBox="1"/>
            <p:nvPr/>
          </p:nvSpPr>
          <p:spPr>
            <a:xfrm>
              <a:off x="4005295" y="3066112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11b+Ly6C high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AD6BDB7F-67B2-AB4A-8A6B-D9D4BC4C2F34}"/>
                </a:ext>
              </a:extLst>
            </p:cNvPr>
            <p:cNvSpPr txBox="1"/>
            <p:nvPr/>
          </p:nvSpPr>
          <p:spPr>
            <a:xfrm>
              <a:off x="6113552" y="3055597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E.coli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1D712D8F-1DFC-7549-8E4E-973C4FD10A9C}"/>
                </a:ext>
              </a:extLst>
            </p:cNvPr>
            <p:cNvSpPr txBox="1"/>
            <p:nvPr/>
          </p:nvSpPr>
          <p:spPr>
            <a:xfrm>
              <a:off x="7587730" y="3080861"/>
              <a:ext cx="13663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rnalized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E.coli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719B9165-7543-7B48-86CF-EEF02049130F}"/>
                </a:ext>
              </a:extLst>
            </p:cNvPr>
            <p:cNvSpPr txBox="1"/>
            <p:nvPr/>
          </p:nvSpPr>
          <p:spPr>
            <a:xfrm>
              <a:off x="855824" y="5186310"/>
              <a:ext cx="14046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RBC Mask</a:t>
              </a:r>
            </a:p>
          </p:txBody>
        </p:sp>
        <p:pic>
          <p:nvPicPr>
            <p:cNvPr id="162" name="図 23">
              <a:extLst>
                <a:ext uri="{FF2B5EF4-FFF2-40B4-BE49-F238E27FC236}">
                  <a16:creationId xmlns:a16="http://schemas.microsoft.com/office/drawing/2014/main" id="{6EDE7BD4-41F4-6C4F-88DB-B17BB5DE3CD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019868" y="5486401"/>
              <a:ext cx="1339829" cy="914400"/>
            </a:xfrm>
            <a:prstGeom prst="rect">
              <a:avLst/>
            </a:prstGeom>
          </p:spPr>
        </p:pic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39591E13-611C-E340-821E-7954D6989F77}"/>
                </a:ext>
              </a:extLst>
            </p:cNvPr>
            <p:cNvSpPr txBox="1"/>
            <p:nvPr/>
          </p:nvSpPr>
          <p:spPr>
            <a:xfrm>
              <a:off x="2339867" y="5186310"/>
              <a:ext cx="14046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E.Coli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Mask</a:t>
              </a:r>
            </a:p>
          </p:txBody>
        </p:sp>
        <p:pic>
          <p:nvPicPr>
            <p:cNvPr id="164" name="Picture 163">
              <a:extLst>
                <a:ext uri="{FF2B5EF4-FFF2-40B4-BE49-F238E27FC236}">
                  <a16:creationId xmlns:a16="http://schemas.microsoft.com/office/drawing/2014/main" id="{8F3F7C49-A445-1C40-B798-3C4205795ED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557204" y="5404000"/>
              <a:ext cx="1727200" cy="1117600"/>
            </a:xfrm>
            <a:prstGeom prst="rect">
              <a:avLst/>
            </a:prstGeom>
          </p:spPr>
        </p:pic>
        <p:pic>
          <p:nvPicPr>
            <p:cNvPr id="165" name="Picture 164">
              <a:extLst>
                <a:ext uri="{FF2B5EF4-FFF2-40B4-BE49-F238E27FC236}">
                  <a16:creationId xmlns:a16="http://schemas.microsoft.com/office/drawing/2014/main" id="{850C5D3E-208F-8D4A-ADB2-FDD959E031C9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340810" y="5387253"/>
              <a:ext cx="1727200" cy="1155700"/>
            </a:xfrm>
            <a:prstGeom prst="rect">
              <a:avLst/>
            </a:prstGeom>
          </p:spPr>
        </p:pic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5A4E4888-CC0B-E64C-AC4A-23A781B05BA4}"/>
                </a:ext>
              </a:extLst>
            </p:cNvPr>
            <p:cNvSpPr txBox="1"/>
            <p:nvPr/>
          </p:nvSpPr>
          <p:spPr>
            <a:xfrm>
              <a:off x="78102" y="849551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9995EA37-5B1E-D945-86E7-47F827C9F6E8}"/>
                </a:ext>
              </a:extLst>
            </p:cNvPr>
            <p:cNvSpPr txBox="1"/>
            <p:nvPr/>
          </p:nvSpPr>
          <p:spPr>
            <a:xfrm>
              <a:off x="96033" y="3060301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128E6EE9-7415-B24E-AB2E-CB54B52A1512}"/>
                </a:ext>
              </a:extLst>
            </p:cNvPr>
            <p:cNvSpPr txBox="1"/>
            <p:nvPr/>
          </p:nvSpPr>
          <p:spPr>
            <a:xfrm>
              <a:off x="80818" y="5197199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391AA13F-B170-DB4C-A494-D82C31E66486}"/>
                </a:ext>
              </a:extLst>
            </p:cNvPr>
            <p:cNvSpPr txBox="1"/>
            <p:nvPr/>
          </p:nvSpPr>
          <p:spPr>
            <a:xfrm>
              <a:off x="3536751" y="5205812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4FF5417A-E712-014E-BD5A-642DAFBC623C}"/>
                </a:ext>
              </a:extLst>
            </p:cNvPr>
            <p:cNvSpPr txBox="1"/>
            <p:nvPr/>
          </p:nvSpPr>
          <p:spPr>
            <a:xfrm>
              <a:off x="3800892" y="5196308"/>
              <a:ext cx="25938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opsonized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E.coli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 B6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FB479D69-0C4C-8D42-A956-3E27D5A41029}"/>
                </a:ext>
              </a:extLst>
            </p:cNvPr>
            <p:cNvSpPr txBox="1"/>
            <p:nvPr/>
          </p:nvSpPr>
          <p:spPr>
            <a:xfrm>
              <a:off x="5628428" y="5204085"/>
              <a:ext cx="25938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opsonized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E.coli 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 BALB/c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215758A7-4237-8948-8A6F-E760AD986F19}"/>
                </a:ext>
              </a:extLst>
            </p:cNvPr>
            <p:cNvSpPr txBox="1"/>
            <p:nvPr/>
          </p:nvSpPr>
          <p:spPr>
            <a:xfrm>
              <a:off x="5294280" y="5203895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811950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5FD52D78-5250-B972-5029-1608B7B3D8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8077" y="4585999"/>
            <a:ext cx="2543063" cy="248548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09369DB-252F-DD59-6000-66851416F2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066" y="1539850"/>
            <a:ext cx="3104413" cy="215455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49DA730-E65A-0CFC-31FD-95E90D7341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20018" y="1181962"/>
            <a:ext cx="2943225" cy="2466975"/>
          </a:xfrm>
          <a:prstGeom prst="rect">
            <a:avLst/>
          </a:prstGeom>
        </p:spPr>
      </p:pic>
      <p:sp>
        <p:nvSpPr>
          <p:cNvPr id="5" name="Arrow: Down 4">
            <a:extLst>
              <a:ext uri="{FF2B5EF4-FFF2-40B4-BE49-F238E27FC236}">
                <a16:creationId xmlns:a16="http://schemas.microsoft.com/office/drawing/2014/main" id="{025A9466-C5FD-ABC3-7F19-28B4F74C6751}"/>
              </a:ext>
            </a:extLst>
          </p:cNvPr>
          <p:cNvSpPr/>
          <p:nvPr/>
        </p:nvSpPr>
        <p:spPr>
          <a:xfrm>
            <a:off x="1290718" y="1434642"/>
            <a:ext cx="45719" cy="187017"/>
          </a:xfrm>
          <a:prstGeom prst="downArrow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6" name="Arrow: Down 5">
            <a:extLst>
              <a:ext uri="{FF2B5EF4-FFF2-40B4-BE49-F238E27FC236}">
                <a16:creationId xmlns:a16="http://schemas.microsoft.com/office/drawing/2014/main" id="{06932BA7-2E6A-8467-A4E6-78A78AD56B44}"/>
              </a:ext>
            </a:extLst>
          </p:cNvPr>
          <p:cNvSpPr/>
          <p:nvPr/>
        </p:nvSpPr>
        <p:spPr>
          <a:xfrm>
            <a:off x="1849678" y="1434642"/>
            <a:ext cx="45719" cy="187017"/>
          </a:xfrm>
          <a:prstGeom prst="downArrow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8" name="Arrow: Down 7">
            <a:extLst>
              <a:ext uri="{FF2B5EF4-FFF2-40B4-BE49-F238E27FC236}">
                <a16:creationId xmlns:a16="http://schemas.microsoft.com/office/drawing/2014/main" id="{C304CE2A-001D-16BE-740A-270CCE5296DC}"/>
              </a:ext>
            </a:extLst>
          </p:cNvPr>
          <p:cNvSpPr/>
          <p:nvPr/>
        </p:nvSpPr>
        <p:spPr>
          <a:xfrm>
            <a:off x="2384688" y="1434642"/>
            <a:ext cx="45719" cy="187017"/>
          </a:xfrm>
          <a:prstGeom prst="downArrow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AE77204-3D9D-76B0-BBB3-BE7AC22A36C3}"/>
              </a:ext>
            </a:extLst>
          </p:cNvPr>
          <p:cNvSpPr txBox="1"/>
          <p:nvPr/>
        </p:nvSpPr>
        <p:spPr>
          <a:xfrm>
            <a:off x="1106052" y="745137"/>
            <a:ext cx="369332" cy="57246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b="1" dirty="0"/>
              <a:t>glucos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B48F793-149D-A876-5DBF-53162350062B}"/>
              </a:ext>
            </a:extLst>
          </p:cNvPr>
          <p:cNvSpPr txBox="1"/>
          <p:nvPr/>
        </p:nvSpPr>
        <p:spPr>
          <a:xfrm>
            <a:off x="1665012" y="634852"/>
            <a:ext cx="369332" cy="78669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b="1" dirty="0"/>
              <a:t>oligomyc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39013F3-A91B-4E39-4F7F-D9477DA5E810}"/>
              </a:ext>
            </a:extLst>
          </p:cNvPr>
          <p:cNvSpPr txBox="1"/>
          <p:nvPr/>
        </p:nvSpPr>
        <p:spPr>
          <a:xfrm>
            <a:off x="2222881" y="859203"/>
            <a:ext cx="369332" cy="412934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200" b="1" dirty="0"/>
              <a:t>2-D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85C7809-C255-E2FE-3819-47AA0190BD3B}"/>
              </a:ext>
            </a:extLst>
          </p:cNvPr>
          <p:cNvSpPr txBox="1"/>
          <p:nvPr/>
        </p:nvSpPr>
        <p:spPr>
          <a:xfrm>
            <a:off x="7186294" y="348814"/>
            <a:ext cx="428965" cy="24006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lIns="45720" tIns="27432" rIns="45720" bIns="27432" rtlCol="0">
            <a:spAutoFit/>
          </a:bodyPr>
          <a:lstStyle/>
          <a:p>
            <a:pPr algn="ctr"/>
            <a:r>
              <a:rPr lang="en-US" sz="1200" b="1" dirty="0"/>
              <a:t>Basa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C4918E3-2A25-E2AC-6DC3-80438D7E5665}"/>
              </a:ext>
            </a:extLst>
          </p:cNvPr>
          <p:cNvSpPr txBox="1"/>
          <p:nvPr/>
        </p:nvSpPr>
        <p:spPr>
          <a:xfrm>
            <a:off x="7223127" y="2344366"/>
            <a:ext cx="708720" cy="24006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lIns="45720" tIns="27432" rIns="45720" bIns="27432" rtlCol="0">
            <a:spAutoFit/>
          </a:bodyPr>
          <a:lstStyle/>
          <a:p>
            <a:pPr algn="ctr"/>
            <a:r>
              <a:rPr lang="en-US" sz="1200" b="1" dirty="0"/>
              <a:t>+ Glucos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01C0556-02A1-DBE4-D585-4453CC17DDE9}"/>
              </a:ext>
            </a:extLst>
          </p:cNvPr>
          <p:cNvSpPr txBox="1"/>
          <p:nvPr/>
        </p:nvSpPr>
        <p:spPr>
          <a:xfrm>
            <a:off x="336183" y="645071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AD1C517-2AC1-BF13-3FC2-81C1D3CDCF1C}"/>
              </a:ext>
            </a:extLst>
          </p:cNvPr>
          <p:cNvSpPr txBox="1"/>
          <p:nvPr/>
        </p:nvSpPr>
        <p:spPr>
          <a:xfrm>
            <a:off x="3427479" y="645071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19622E1-94AD-5363-137E-3147D39D30A1}"/>
              </a:ext>
            </a:extLst>
          </p:cNvPr>
          <p:cNvSpPr txBox="1"/>
          <p:nvPr/>
        </p:nvSpPr>
        <p:spPr>
          <a:xfrm>
            <a:off x="6179539" y="645071"/>
            <a:ext cx="3674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03EAAF3-4011-85B2-5D5E-8CC388B6334D}"/>
              </a:ext>
            </a:extLst>
          </p:cNvPr>
          <p:cNvSpPr txBox="1"/>
          <p:nvPr/>
        </p:nvSpPr>
        <p:spPr>
          <a:xfrm>
            <a:off x="336183" y="4330150"/>
            <a:ext cx="386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E76899C-5F8D-9CBE-36A8-A44240EC9297}"/>
              </a:ext>
            </a:extLst>
          </p:cNvPr>
          <p:cNvSpPr txBox="1"/>
          <p:nvPr/>
        </p:nvSpPr>
        <p:spPr>
          <a:xfrm>
            <a:off x="6112811" y="4296731"/>
            <a:ext cx="333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BD49C1E7-A303-6DF4-A668-5B6E67F5AA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12993" y="2421548"/>
            <a:ext cx="2140058" cy="1936887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4BC21991-586A-4080-D640-45526F54433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80233" y="423699"/>
            <a:ext cx="2140058" cy="193688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C71765C-533C-7A77-8716-AEB602B06A2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2729" y="4604508"/>
            <a:ext cx="2676525" cy="2466975"/>
          </a:xfrm>
          <a:prstGeom prst="rect">
            <a:avLst/>
          </a:prstGeom>
        </p:spPr>
      </p:pic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5B8DEE4E-1523-0727-98A4-003B0B71E0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1009903"/>
              </p:ext>
            </p:extLst>
          </p:nvPr>
        </p:nvGraphicFramePr>
        <p:xfrm>
          <a:off x="5990844" y="4519210"/>
          <a:ext cx="1956728" cy="22843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1705963" imgH="1992732" progId="Prism10.Document">
                  <p:embed/>
                </p:oleObj>
              </mc:Choice>
              <mc:Fallback>
                <p:oleObj name="Prism 10" r:id="rId8" imgW="1705963" imgH="1992732" progId="Prism10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5B8DEE4E-1523-0727-98A4-003B0B71E0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990844" y="4519210"/>
                        <a:ext cx="1956728" cy="22843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6E6C09C2-EB00-EE16-AA80-6D5C41837E2A}"/>
              </a:ext>
            </a:extLst>
          </p:cNvPr>
          <p:cNvSpPr txBox="1"/>
          <p:nvPr/>
        </p:nvSpPr>
        <p:spPr>
          <a:xfrm>
            <a:off x="78576" y="115748"/>
            <a:ext cx="20695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3964E6B-CFBD-5DBE-7006-4F9786A7808D}"/>
              </a:ext>
            </a:extLst>
          </p:cNvPr>
          <p:cNvSpPr txBox="1"/>
          <p:nvPr/>
        </p:nvSpPr>
        <p:spPr>
          <a:xfrm>
            <a:off x="3248077" y="4296731"/>
            <a:ext cx="3674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7565125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>
            <a:extLst>
              <a:ext uri="{FF2B5EF4-FFF2-40B4-BE49-F238E27FC236}">
                <a16:creationId xmlns:a16="http://schemas.microsoft.com/office/drawing/2014/main" id="{CE8F26E5-DEE8-88CA-F953-ED23411C1555}"/>
              </a:ext>
            </a:extLst>
          </p:cNvPr>
          <p:cNvGrpSpPr/>
          <p:nvPr/>
        </p:nvGrpSpPr>
        <p:grpSpPr>
          <a:xfrm>
            <a:off x="1392868" y="1440276"/>
            <a:ext cx="6615355" cy="3665934"/>
            <a:chOff x="96515" y="3636379"/>
            <a:chExt cx="6615355" cy="3665934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FDF3484D-F08C-4DB9-BA9E-0D5FE954C3D2}"/>
                </a:ext>
              </a:extLst>
            </p:cNvPr>
            <p:cNvGrpSpPr/>
            <p:nvPr/>
          </p:nvGrpSpPr>
          <p:grpSpPr>
            <a:xfrm>
              <a:off x="96515" y="3636379"/>
              <a:ext cx="6615355" cy="3643979"/>
              <a:chOff x="96515" y="3636379"/>
              <a:chExt cx="6615355" cy="3643979"/>
            </a:xfrm>
          </p:grpSpPr>
          <p:pic>
            <p:nvPicPr>
              <p:cNvPr id="50" name="Picture 49" descr="A chart with many dots&#10;&#10;Description automatically generated with medium confidence">
                <a:extLst>
                  <a:ext uri="{FF2B5EF4-FFF2-40B4-BE49-F238E27FC236}">
                    <a16:creationId xmlns:a16="http://schemas.microsoft.com/office/drawing/2014/main" id="{ACCDEB13-F94C-A797-15CA-4ABCE4D768A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983" b="18095"/>
              <a:stretch/>
            </p:blipFill>
            <p:spPr>
              <a:xfrm>
                <a:off x="96515" y="3636379"/>
                <a:ext cx="4734631" cy="2966594"/>
              </a:xfrm>
              <a:prstGeom prst="rect">
                <a:avLst/>
              </a:prstGeom>
            </p:spPr>
          </p:pic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EDBDF0AC-8004-2B7F-9FCA-5E62D566E021}"/>
                  </a:ext>
                </a:extLst>
              </p:cNvPr>
              <p:cNvSpPr txBox="1"/>
              <p:nvPr/>
            </p:nvSpPr>
            <p:spPr>
              <a:xfrm>
                <a:off x="4650575" y="3878602"/>
                <a:ext cx="2061295" cy="27853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9   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oDCs</a:t>
                </a:r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6    Classical monocyte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7    M2-like macrophage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10  Non-classical monocyte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5    Non-classical monocyte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4    M1-like macrophage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12  Proliferating M-MDSC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11  Proliferating M-MDSC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8    Proliferating M-MDSC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3    Classical monocyte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2    Classical monocyte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1    DCs</a:t>
                </a:r>
              </a:p>
              <a:p>
                <a:endParaRPr 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Cluster 0    Classical monocytes</a:t>
                </a:r>
              </a:p>
              <a:p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840ABC2E-AC0D-C74A-0ADD-9584C5270E3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42130" y="3878602"/>
                <a:ext cx="0" cy="2693508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036156FF-4DDB-C4BD-F214-2970322C0A07}"/>
                  </a:ext>
                </a:extLst>
              </p:cNvPr>
              <p:cNvSpPr txBox="1"/>
              <p:nvPr/>
            </p:nvSpPr>
            <p:spPr>
              <a:xfrm rot="2885827">
                <a:off x="4518841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err="1">
                    <a:latin typeface="Arial" panose="020B0604020202020204" pitchFamily="34" charset="0"/>
                    <a:cs typeface="Arial" panose="020B0604020202020204" pitchFamily="34" charset="0"/>
                  </a:rPr>
                  <a:t>Elane</a:t>
                </a:r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CE69991D-479C-C958-D34F-CF0355CF6228}"/>
                  </a:ext>
                </a:extLst>
              </p:cNvPr>
              <p:cNvSpPr txBox="1"/>
              <p:nvPr/>
            </p:nvSpPr>
            <p:spPr>
              <a:xfrm rot="2885827">
                <a:off x="4236131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Prtn3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BE571C86-A5EA-AA5E-A4BC-D6234B17A0AC}"/>
                  </a:ext>
                </a:extLst>
              </p:cNvPr>
              <p:cNvSpPr txBox="1"/>
              <p:nvPr/>
            </p:nvSpPr>
            <p:spPr>
              <a:xfrm rot="2885827">
                <a:off x="2682556" y="6690944"/>
                <a:ext cx="6208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Adgre4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18D008D9-D92F-6625-E6CF-802355654AF2}"/>
                  </a:ext>
                </a:extLst>
              </p:cNvPr>
              <p:cNvSpPr txBox="1"/>
              <p:nvPr/>
            </p:nvSpPr>
            <p:spPr>
              <a:xfrm rot="2885827">
                <a:off x="3821165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Mki67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1E3BF018-E4C1-F8C8-09C8-ADF22EA2EF57}"/>
                  </a:ext>
                </a:extLst>
              </p:cNvPr>
              <p:cNvSpPr txBox="1"/>
              <p:nvPr/>
            </p:nvSpPr>
            <p:spPr>
              <a:xfrm rot="2885827">
                <a:off x="3953762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Stmn1</a:t>
                </a: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2589F2FC-589B-EACA-63C3-3C31C989B289}"/>
                  </a:ext>
                </a:extLst>
              </p:cNvPr>
              <p:cNvSpPr txBox="1"/>
              <p:nvPr/>
            </p:nvSpPr>
            <p:spPr>
              <a:xfrm rot="2885827">
                <a:off x="4040912" y="6759397"/>
                <a:ext cx="8264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Hist1h2ap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9AE11DEB-65CA-0D85-5673-71B97CC37269}"/>
                  </a:ext>
                </a:extLst>
              </p:cNvPr>
              <p:cNvSpPr txBox="1"/>
              <p:nvPr/>
            </p:nvSpPr>
            <p:spPr>
              <a:xfrm rot="2885827">
                <a:off x="4359064" y="6665363"/>
                <a:ext cx="552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S100a8</a:t>
                </a: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EC983F49-1F5F-A077-B1F0-6176C353367B}"/>
                  </a:ext>
                </a:extLst>
              </p:cNvPr>
              <p:cNvSpPr txBox="1"/>
              <p:nvPr/>
            </p:nvSpPr>
            <p:spPr>
              <a:xfrm rot="2885827">
                <a:off x="2314861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Isg15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C0EB0444-B74D-DAF3-3601-88BC0C8EC169}"/>
                  </a:ext>
                </a:extLst>
              </p:cNvPr>
              <p:cNvSpPr txBox="1"/>
              <p:nvPr/>
            </p:nvSpPr>
            <p:spPr>
              <a:xfrm rot="2885827">
                <a:off x="2436952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Irf7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1E445814-55BC-96C8-950D-14B8163B5269}"/>
                  </a:ext>
                </a:extLst>
              </p:cNvPr>
              <p:cNvSpPr txBox="1"/>
              <p:nvPr/>
            </p:nvSpPr>
            <p:spPr>
              <a:xfrm rot="2885827">
                <a:off x="1887516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Batf3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1D1BEC9F-799E-D1FB-3655-38F8C4678DC3}"/>
                  </a:ext>
                </a:extLst>
              </p:cNvPr>
              <p:cNvSpPr txBox="1"/>
              <p:nvPr/>
            </p:nvSpPr>
            <p:spPr>
              <a:xfrm rot="2885827">
                <a:off x="1755120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err="1">
                    <a:latin typeface="Arial" panose="020B0604020202020204" pitchFamily="34" charset="0"/>
                    <a:cs typeface="Arial" panose="020B0604020202020204" pitchFamily="34" charset="0"/>
                  </a:rPr>
                  <a:t>Ciita</a:t>
                </a:r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AB2CE52A-0B39-2F3A-7D26-1BF949AF01E2}"/>
                  </a:ext>
                </a:extLst>
              </p:cNvPr>
              <p:cNvSpPr txBox="1"/>
              <p:nvPr/>
            </p:nvSpPr>
            <p:spPr>
              <a:xfrm rot="2885827">
                <a:off x="494688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Ccr2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02A2A60-5C89-CD2D-42EA-40BEE552132B}"/>
                  </a:ext>
                </a:extLst>
              </p:cNvPr>
              <p:cNvSpPr txBox="1"/>
              <p:nvPr/>
            </p:nvSpPr>
            <p:spPr>
              <a:xfrm rot="2885827">
                <a:off x="641776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Chil3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5B942BEC-01B9-5744-DA29-1096CC4D8111}"/>
                  </a:ext>
                </a:extLst>
              </p:cNvPr>
              <p:cNvSpPr txBox="1"/>
              <p:nvPr/>
            </p:nvSpPr>
            <p:spPr>
              <a:xfrm rot="2885827">
                <a:off x="2569566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Ace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8D334E77-B557-BCFC-FBCC-BAE4B4EDC47F}"/>
                  </a:ext>
                </a:extLst>
              </p:cNvPr>
              <p:cNvSpPr txBox="1"/>
              <p:nvPr/>
            </p:nvSpPr>
            <p:spPr>
              <a:xfrm rot="2885827">
                <a:off x="2162759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Ifi204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CF7C0B59-E554-BCDC-7B64-913617EFF5E5}"/>
                  </a:ext>
                </a:extLst>
              </p:cNvPr>
              <p:cNvSpPr txBox="1"/>
              <p:nvPr/>
            </p:nvSpPr>
            <p:spPr>
              <a:xfrm rot="2885827">
                <a:off x="2010654" y="6671275"/>
                <a:ext cx="5680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Cd209a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06AE0759-AA92-5779-C4AC-F5FA64025198}"/>
                  </a:ext>
                </a:extLst>
              </p:cNvPr>
              <p:cNvSpPr txBox="1"/>
              <p:nvPr/>
            </p:nvSpPr>
            <p:spPr>
              <a:xfrm rot="2885827">
                <a:off x="789621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Ly6c2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46C29BBB-7772-EE73-E066-AFF2634DA2A8}"/>
                  </a:ext>
                </a:extLst>
              </p:cNvPr>
              <p:cNvSpPr txBox="1"/>
              <p:nvPr/>
            </p:nvSpPr>
            <p:spPr>
              <a:xfrm rot="2885827">
                <a:off x="1612798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Cd74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5501469E-F75E-F810-5055-155D90D311B3}"/>
                  </a:ext>
                </a:extLst>
              </p:cNvPr>
              <p:cNvSpPr txBox="1"/>
              <p:nvPr/>
            </p:nvSpPr>
            <p:spPr>
              <a:xfrm rot="2885827">
                <a:off x="219509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F13a1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5F8E969B-A6D6-DE4C-FAD2-074D56633CFA}"/>
                  </a:ext>
                </a:extLst>
              </p:cNvPr>
              <p:cNvSpPr txBox="1"/>
              <p:nvPr/>
            </p:nvSpPr>
            <p:spPr>
              <a:xfrm rot="2885827">
                <a:off x="3643394" y="6693219"/>
                <a:ext cx="6269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Hmgn2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864DE265-EE0F-269B-3733-3414E3364E8A}"/>
                  </a:ext>
                </a:extLst>
              </p:cNvPr>
              <p:cNvSpPr txBox="1"/>
              <p:nvPr/>
            </p:nvSpPr>
            <p:spPr>
              <a:xfrm rot="2885827">
                <a:off x="3392800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Hmox1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1B72C0B6-F03C-0804-A997-1D9AFE98A76B}"/>
                  </a:ext>
                </a:extLst>
              </p:cNvPr>
              <p:cNvSpPr txBox="1"/>
              <p:nvPr/>
            </p:nvSpPr>
            <p:spPr>
              <a:xfrm rot="2885827">
                <a:off x="3534180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Vcam1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5D9B5589-C9EE-29D9-6F0E-9D6F9427F1B3}"/>
                  </a:ext>
                </a:extLst>
              </p:cNvPr>
              <p:cNvSpPr txBox="1"/>
              <p:nvPr/>
            </p:nvSpPr>
            <p:spPr>
              <a:xfrm rot="2885827">
                <a:off x="3117327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C1qa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9B00DB43-A383-B589-1D38-BCF7DB167D71}"/>
                  </a:ext>
                </a:extLst>
              </p:cNvPr>
              <p:cNvSpPr txBox="1"/>
              <p:nvPr/>
            </p:nvSpPr>
            <p:spPr>
              <a:xfrm rot="2885827">
                <a:off x="3259174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Mrc1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D3AB8231-B615-9E6C-FAFD-E38DE418898A}"/>
                  </a:ext>
                </a:extLst>
              </p:cNvPr>
              <p:cNvSpPr txBox="1"/>
              <p:nvPr/>
            </p:nvSpPr>
            <p:spPr>
              <a:xfrm rot="2885827">
                <a:off x="2846980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Nr4a1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24BEF8C2-E86D-02C4-1500-459DAB20A1CE}"/>
                  </a:ext>
                </a:extLst>
              </p:cNvPr>
              <p:cNvSpPr txBox="1"/>
              <p:nvPr/>
            </p:nvSpPr>
            <p:spPr>
              <a:xfrm rot="2885827">
                <a:off x="2945464" y="6721068"/>
                <a:ext cx="701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Pou2f2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4CD0E0ED-2608-96A7-659B-88605211FA80}"/>
                  </a:ext>
                </a:extLst>
              </p:cNvPr>
              <p:cNvSpPr txBox="1"/>
              <p:nvPr/>
            </p:nvSpPr>
            <p:spPr>
              <a:xfrm rot="2885827">
                <a:off x="1333352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H2-Aa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4D62D04B-3134-2BF0-EA36-89FDF57E33E4}"/>
                  </a:ext>
                </a:extLst>
              </p:cNvPr>
              <p:cNvSpPr txBox="1"/>
              <p:nvPr/>
            </p:nvSpPr>
            <p:spPr>
              <a:xfrm rot="2885827">
                <a:off x="1194215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Mmp8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870C3DD8-A2A9-59A3-8A8D-C8488BC891D1}"/>
                  </a:ext>
                </a:extLst>
              </p:cNvPr>
              <p:cNvSpPr txBox="1"/>
              <p:nvPr/>
            </p:nvSpPr>
            <p:spPr>
              <a:xfrm rot="2885827">
                <a:off x="909180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Cd14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8B62E509-4DF0-070E-FE6C-C7FD3D0E034F}"/>
                  </a:ext>
                </a:extLst>
              </p:cNvPr>
              <p:cNvSpPr txBox="1"/>
              <p:nvPr/>
            </p:nvSpPr>
            <p:spPr>
              <a:xfrm rot="2885827">
                <a:off x="1445425" y="6707165"/>
                <a:ext cx="66446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H2-Ab1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3F145B9A-3851-A796-DDA7-CF889B02F68A}"/>
                  </a:ext>
                </a:extLst>
              </p:cNvPr>
              <p:cNvSpPr txBox="1"/>
              <p:nvPr/>
            </p:nvSpPr>
            <p:spPr>
              <a:xfrm rot="2885827">
                <a:off x="1058656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err="1">
                    <a:latin typeface="Arial" panose="020B0604020202020204" pitchFamily="34" charset="0"/>
                    <a:cs typeface="Arial" panose="020B0604020202020204" pitchFamily="34" charset="0"/>
                  </a:rPr>
                  <a:t>Vcan</a:t>
                </a:r>
                <a:endParaRPr 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BA201420-2971-7809-30DC-2C050091D602}"/>
                  </a:ext>
                </a:extLst>
              </p:cNvPr>
              <p:cNvSpPr txBox="1"/>
              <p:nvPr/>
            </p:nvSpPr>
            <p:spPr>
              <a:xfrm rot="2885827">
                <a:off x="70859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Fn1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B30F523B-C989-C341-E677-62CA544E3EE0}"/>
                  </a:ext>
                </a:extLst>
              </p:cNvPr>
              <p:cNvSpPr txBox="1"/>
              <p:nvPr/>
            </p:nvSpPr>
            <p:spPr>
              <a:xfrm rot="2885827">
                <a:off x="365319" y="6648282"/>
                <a:ext cx="5062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Sell</a:t>
                </a:r>
              </a:p>
            </p:txBody>
          </p:sp>
        </p:grpSp>
        <p:pic>
          <p:nvPicPr>
            <p:cNvPr id="49" name="Picture 48" descr="A chart with many dots&#10;&#10;Description automatically generated with medium confidence">
              <a:extLst>
                <a:ext uri="{FF2B5EF4-FFF2-40B4-BE49-F238E27FC236}">
                  <a16:creationId xmlns:a16="http://schemas.microsoft.com/office/drawing/2014/main" id="{DF591A6A-AD91-2BE8-E65C-12D3E88A1A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983" t="91465" b="-373"/>
            <a:stretch/>
          </p:blipFill>
          <p:spPr>
            <a:xfrm>
              <a:off x="1296828" y="6979595"/>
              <a:ext cx="4734631" cy="322718"/>
            </a:xfrm>
            <a:prstGeom prst="rect">
              <a:avLst/>
            </a:prstGeom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5A7E6FBF-8153-C1E2-331A-34C7457FF4AA}"/>
              </a:ext>
            </a:extLst>
          </p:cNvPr>
          <p:cNvSpPr txBox="1"/>
          <p:nvPr/>
        </p:nvSpPr>
        <p:spPr>
          <a:xfrm>
            <a:off x="111385" y="333879"/>
            <a:ext cx="18306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</p:spTree>
    <p:extLst>
      <p:ext uri="{BB962C8B-B14F-4D97-AF65-F5344CB8AC3E}">
        <p14:creationId xmlns:p14="http://schemas.microsoft.com/office/powerpoint/2010/main" val="12795886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138CA1F-7D12-8BA0-B78C-F87C3A13C1D7}"/>
              </a:ext>
            </a:extLst>
          </p:cNvPr>
          <p:cNvGrpSpPr/>
          <p:nvPr/>
        </p:nvGrpSpPr>
        <p:grpSpPr>
          <a:xfrm>
            <a:off x="1417360" y="958507"/>
            <a:ext cx="6331425" cy="4993566"/>
            <a:chOff x="1417360" y="958507"/>
            <a:chExt cx="6331425" cy="4993566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CAC9C74B-E48F-9164-37DD-104E65AA93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01445" y="958507"/>
              <a:ext cx="5947340" cy="4413099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2DD9F66-66F4-AFEC-D921-BBAC32A2432E}"/>
                </a:ext>
              </a:extLst>
            </p:cNvPr>
            <p:cNvSpPr txBox="1"/>
            <p:nvPr/>
          </p:nvSpPr>
          <p:spPr>
            <a:xfrm>
              <a:off x="1474940" y="1159798"/>
              <a:ext cx="827534" cy="3708708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0</a:t>
              </a:r>
              <a:endParaRPr lang="en-US" sz="3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1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2</a:t>
              </a: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3</a:t>
              </a: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4</a:t>
              </a:r>
            </a:p>
            <a:p>
              <a:pPr algn="r"/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8</a:t>
              </a: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11</a:t>
              </a: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12</a:t>
              </a: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5</a:t>
              </a: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7</a:t>
              </a: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6</a:t>
              </a: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10</a:t>
              </a:r>
            </a:p>
            <a:p>
              <a:pPr algn="r"/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luster 9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AE106606-8282-AF94-7B16-B066BC50CBBA}"/>
                </a:ext>
              </a:extLst>
            </p:cNvPr>
            <p:cNvSpPr/>
            <p:nvPr/>
          </p:nvSpPr>
          <p:spPr>
            <a:xfrm>
              <a:off x="1417360" y="2595404"/>
              <a:ext cx="5039719" cy="89054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1E8486B-3444-DF67-3497-2847C101F0B5}"/>
                </a:ext>
              </a:extLst>
            </p:cNvPr>
            <p:cNvSpPr txBox="1"/>
            <p:nvPr/>
          </p:nvSpPr>
          <p:spPr>
            <a:xfrm rot="2885827">
              <a:off x="2686711" y="5285726"/>
              <a:ext cx="657546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Elane</a:t>
              </a:r>
              <a:endParaRPr 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7B19598-8AC9-ADAC-7AD6-A5DE3ED44C1E}"/>
                </a:ext>
              </a:extLst>
            </p:cNvPr>
            <p:cNvSpPr txBox="1"/>
            <p:nvPr/>
          </p:nvSpPr>
          <p:spPr>
            <a:xfrm rot="2885827">
              <a:off x="3256201" y="5285726"/>
              <a:ext cx="657546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rtn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06771D7-8C20-48FF-2A9D-9F60D3B82264}"/>
                </a:ext>
              </a:extLst>
            </p:cNvPr>
            <p:cNvSpPr txBox="1"/>
            <p:nvPr/>
          </p:nvSpPr>
          <p:spPr>
            <a:xfrm rot="2885827">
              <a:off x="3821328" y="5285727"/>
              <a:ext cx="657546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tsg</a:t>
              </a:r>
              <a:endParaRPr 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0AFA6B4-8CB4-98D6-D0FF-C18A167709D1}"/>
                </a:ext>
              </a:extLst>
            </p:cNvPr>
            <p:cNvSpPr txBox="1"/>
            <p:nvPr/>
          </p:nvSpPr>
          <p:spPr>
            <a:xfrm rot="2885827">
              <a:off x="4372346" y="5258716"/>
              <a:ext cx="65754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po</a:t>
              </a:r>
              <a:endParaRPr lang="en-US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40FBCCA-7CA1-F8EB-3CD0-35646DF8B344}"/>
                </a:ext>
              </a:extLst>
            </p:cNvPr>
            <p:cNvSpPr txBox="1"/>
            <p:nvPr/>
          </p:nvSpPr>
          <p:spPr>
            <a:xfrm rot="2885827">
              <a:off x="4922326" y="5258715"/>
              <a:ext cx="65754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cn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814275B-91CC-7B00-6478-16A5F1F9CD1C}"/>
                </a:ext>
              </a:extLst>
            </p:cNvPr>
            <p:cNvSpPr txBox="1"/>
            <p:nvPr/>
          </p:nvSpPr>
          <p:spPr>
            <a:xfrm rot="2885827">
              <a:off x="5482580" y="5258715"/>
              <a:ext cx="65754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cnb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CBCBB1F-836F-B15B-18DC-8EC830C8B6C4}"/>
                </a:ext>
              </a:extLst>
            </p:cNvPr>
            <p:cNvSpPr txBox="1"/>
            <p:nvPr/>
          </p:nvSpPr>
          <p:spPr>
            <a:xfrm rot="2885827">
              <a:off x="6006807" y="5258715"/>
              <a:ext cx="65754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amp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4F2C3C8-BC15-F40B-E1FE-FC879B34F815}"/>
                </a:ext>
              </a:extLst>
            </p:cNvPr>
            <p:cNvSpPr txBox="1"/>
            <p:nvPr/>
          </p:nvSpPr>
          <p:spPr>
            <a:xfrm rot="2885827">
              <a:off x="4332489" y="5285727"/>
              <a:ext cx="657546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po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CA8CD87-9A17-0227-5363-799ABC56E462}"/>
                </a:ext>
              </a:extLst>
            </p:cNvPr>
            <p:cNvSpPr txBox="1"/>
            <p:nvPr/>
          </p:nvSpPr>
          <p:spPr>
            <a:xfrm rot="2885827">
              <a:off x="4873233" y="5285727"/>
              <a:ext cx="657546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Lcn2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D2B68E7-5B6E-096D-156F-583A5F07831C}"/>
                </a:ext>
              </a:extLst>
            </p:cNvPr>
            <p:cNvSpPr txBox="1"/>
            <p:nvPr/>
          </p:nvSpPr>
          <p:spPr>
            <a:xfrm rot="2885827">
              <a:off x="5433487" y="5285727"/>
              <a:ext cx="657546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cnb</a:t>
              </a:r>
              <a:endParaRPr 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97DF4F3-30A4-D4E5-C3A5-F16A9525B858}"/>
                </a:ext>
              </a:extLst>
            </p:cNvPr>
            <p:cNvSpPr txBox="1"/>
            <p:nvPr/>
          </p:nvSpPr>
          <p:spPr>
            <a:xfrm rot="2885827">
              <a:off x="6009226" y="5285727"/>
              <a:ext cx="657546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amp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55B22E6-422E-47F5-A773-5D49EB59B8EE}"/>
                </a:ext>
              </a:extLst>
            </p:cNvPr>
            <p:cNvSpPr txBox="1"/>
            <p:nvPr/>
          </p:nvSpPr>
          <p:spPr>
            <a:xfrm>
              <a:off x="3011055" y="5644296"/>
              <a:ext cx="203515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/>
                <a:t>Azurophilic granule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FFC656A-FA90-227D-E0D8-F97FD76ED520}"/>
                </a:ext>
              </a:extLst>
            </p:cNvPr>
            <p:cNvSpPr txBox="1"/>
            <p:nvPr/>
          </p:nvSpPr>
          <p:spPr>
            <a:xfrm>
              <a:off x="5012325" y="5643397"/>
              <a:ext cx="1849723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/>
                <a:t>Secondary granule 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1CFE4354-9023-CCEB-C5C8-A5D3CE5B4651}"/>
                </a:ext>
              </a:extLst>
            </p:cNvPr>
            <p:cNvCxnSpPr>
              <a:cxnSpLocks/>
            </p:cNvCxnSpPr>
            <p:nvPr/>
          </p:nvCxnSpPr>
          <p:spPr>
            <a:xfrm>
              <a:off x="2885628" y="5639706"/>
              <a:ext cx="1836736" cy="369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B59F88C4-52D6-716A-3695-8C378141E82D}"/>
                </a:ext>
              </a:extLst>
            </p:cNvPr>
            <p:cNvCxnSpPr>
              <a:cxnSpLocks/>
            </p:cNvCxnSpPr>
            <p:nvPr/>
          </p:nvCxnSpPr>
          <p:spPr>
            <a:xfrm>
              <a:off x="5107858" y="5639706"/>
              <a:ext cx="1325564" cy="369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52011B9E-3197-9CDD-11A6-7C8E1367FCE8}"/>
              </a:ext>
            </a:extLst>
          </p:cNvPr>
          <p:cNvSpPr txBox="1"/>
          <p:nvPr/>
        </p:nvSpPr>
        <p:spPr>
          <a:xfrm>
            <a:off x="32594" y="109340"/>
            <a:ext cx="18306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40090368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BAD54F-B414-4A44-8456-BA5F89E558AA}"/>
              </a:ext>
            </a:extLst>
          </p:cNvPr>
          <p:cNvSpPr txBox="1"/>
          <p:nvPr/>
        </p:nvSpPr>
        <p:spPr>
          <a:xfrm>
            <a:off x="-6657" y="106634"/>
            <a:ext cx="24210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9F2C224-E7B5-9C4D-C141-4904EC00E6B3}"/>
              </a:ext>
            </a:extLst>
          </p:cNvPr>
          <p:cNvGrpSpPr/>
          <p:nvPr/>
        </p:nvGrpSpPr>
        <p:grpSpPr>
          <a:xfrm>
            <a:off x="913532" y="543545"/>
            <a:ext cx="5736155" cy="6669445"/>
            <a:chOff x="913532" y="543545"/>
            <a:chExt cx="5736155" cy="6669445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35EC7770-C86B-A645-BB78-3BA2EA80FC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31417" y="5591298"/>
              <a:ext cx="1409700" cy="1612900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7773DB6-5474-4D46-97D1-C7748A8554F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26103" y="3298665"/>
              <a:ext cx="4775200" cy="19939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A95E05D-B048-5C44-818C-A5F6187539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250" t="11506" b="7812"/>
            <a:stretch/>
          </p:blipFill>
          <p:spPr>
            <a:xfrm>
              <a:off x="4364781" y="756558"/>
              <a:ext cx="2125014" cy="18288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F7D2126-79B0-2848-8F60-4ECDBD2BB4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6250" t="10653" b="7812"/>
            <a:stretch/>
          </p:blipFill>
          <p:spPr>
            <a:xfrm>
              <a:off x="1474716" y="765941"/>
              <a:ext cx="2102801" cy="1828800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B6C5A4C-D115-F343-9636-2FA43BE71435}"/>
                </a:ext>
              </a:extLst>
            </p:cNvPr>
            <p:cNvSpPr txBox="1"/>
            <p:nvPr/>
          </p:nvSpPr>
          <p:spPr>
            <a:xfrm>
              <a:off x="4369624" y="2515846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719ECF4-8536-1D44-A919-374BE954E00E}"/>
                </a:ext>
              </a:extLst>
            </p:cNvPr>
            <p:cNvSpPr txBox="1"/>
            <p:nvPr/>
          </p:nvSpPr>
          <p:spPr>
            <a:xfrm>
              <a:off x="4525285" y="2515887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9DD0213-10B0-F141-9B90-D40E647C9799}"/>
                </a:ext>
              </a:extLst>
            </p:cNvPr>
            <p:cNvSpPr txBox="1"/>
            <p:nvPr/>
          </p:nvSpPr>
          <p:spPr>
            <a:xfrm>
              <a:off x="4673267" y="2515846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4F08813-BB0D-5D4A-A826-29C20DC2D371}"/>
                </a:ext>
              </a:extLst>
            </p:cNvPr>
            <p:cNvSpPr txBox="1"/>
            <p:nvPr/>
          </p:nvSpPr>
          <p:spPr>
            <a:xfrm>
              <a:off x="4839627" y="251316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D514885-F037-FD4C-B02D-91F454F9BFF4}"/>
                </a:ext>
              </a:extLst>
            </p:cNvPr>
            <p:cNvSpPr txBox="1"/>
            <p:nvPr/>
          </p:nvSpPr>
          <p:spPr>
            <a:xfrm>
              <a:off x="4991486" y="251103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32D0F10-7BAF-3B49-9183-76C54A83DA61}"/>
                </a:ext>
              </a:extLst>
            </p:cNvPr>
            <p:cNvSpPr txBox="1"/>
            <p:nvPr/>
          </p:nvSpPr>
          <p:spPr>
            <a:xfrm>
              <a:off x="5150866" y="2508897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AC68438-D397-634C-88CC-AD9B4A3E182C}"/>
                </a:ext>
              </a:extLst>
            </p:cNvPr>
            <p:cNvSpPr txBox="1"/>
            <p:nvPr/>
          </p:nvSpPr>
          <p:spPr>
            <a:xfrm>
              <a:off x="5308746" y="251316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BD8B3D6-E9CB-B64E-B304-46D13F759873}"/>
                </a:ext>
              </a:extLst>
            </p:cNvPr>
            <p:cNvSpPr txBox="1"/>
            <p:nvPr/>
          </p:nvSpPr>
          <p:spPr>
            <a:xfrm>
              <a:off x="5458907" y="2513710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4A02B0F-C57B-CD40-8DC1-4EF765794EB4}"/>
                </a:ext>
              </a:extLst>
            </p:cNvPr>
            <p:cNvSpPr txBox="1"/>
            <p:nvPr/>
          </p:nvSpPr>
          <p:spPr>
            <a:xfrm>
              <a:off x="5617746" y="251103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2E74566-0F5E-C64E-A13E-7FDB44F4F700}"/>
                </a:ext>
              </a:extLst>
            </p:cNvPr>
            <p:cNvSpPr txBox="1"/>
            <p:nvPr/>
          </p:nvSpPr>
          <p:spPr>
            <a:xfrm>
              <a:off x="5776585" y="2508897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ADA395A-4B69-D04C-91AF-CC3EBE93A752}"/>
                </a:ext>
              </a:extLst>
            </p:cNvPr>
            <p:cNvSpPr txBox="1"/>
            <p:nvPr/>
          </p:nvSpPr>
          <p:spPr>
            <a:xfrm>
              <a:off x="5875849" y="2513200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F57FAE8-7A3E-9746-8F4E-5B5C46ACD3D9}"/>
                </a:ext>
              </a:extLst>
            </p:cNvPr>
            <p:cNvSpPr txBox="1"/>
            <p:nvPr/>
          </p:nvSpPr>
          <p:spPr>
            <a:xfrm>
              <a:off x="6035647" y="2513710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C5263C2-C359-104E-A3DC-599343FD18DC}"/>
                </a:ext>
              </a:extLst>
            </p:cNvPr>
            <p:cNvSpPr txBox="1"/>
            <p:nvPr/>
          </p:nvSpPr>
          <p:spPr>
            <a:xfrm>
              <a:off x="6197850" y="2513710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796171E-CFD4-774C-A822-CEC2B1C47ECA}"/>
                </a:ext>
              </a:extLst>
            </p:cNvPr>
            <p:cNvSpPr txBox="1"/>
            <p:nvPr/>
          </p:nvSpPr>
          <p:spPr>
            <a:xfrm>
              <a:off x="5278144" y="2805003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dentity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C542DD6-755A-8740-8A75-E0753BB26ED8}"/>
                </a:ext>
              </a:extLst>
            </p:cNvPr>
            <p:cNvSpPr txBox="1"/>
            <p:nvPr/>
          </p:nvSpPr>
          <p:spPr>
            <a:xfrm>
              <a:off x="4060947" y="2369914"/>
              <a:ext cx="390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85820FB-575B-A049-A5FD-A133F4469DD7}"/>
                </a:ext>
              </a:extLst>
            </p:cNvPr>
            <p:cNvSpPr txBox="1"/>
            <p:nvPr/>
          </p:nvSpPr>
          <p:spPr>
            <a:xfrm>
              <a:off x="4060947" y="1833294"/>
              <a:ext cx="390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DF064DE-A75C-D44C-A06C-47B6B1522E4F}"/>
                </a:ext>
              </a:extLst>
            </p:cNvPr>
            <p:cNvSpPr txBox="1"/>
            <p:nvPr/>
          </p:nvSpPr>
          <p:spPr>
            <a:xfrm>
              <a:off x="4127625" y="1274264"/>
              <a:ext cx="390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B2467DC-3D00-4E4D-9D65-1A4613DDB2A0}"/>
                </a:ext>
              </a:extLst>
            </p:cNvPr>
            <p:cNvSpPr txBox="1"/>
            <p:nvPr/>
          </p:nvSpPr>
          <p:spPr>
            <a:xfrm>
              <a:off x="4065118" y="728790"/>
              <a:ext cx="390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15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290D9D7-0A74-7746-B919-9A213EEECAB4}"/>
                </a:ext>
              </a:extLst>
            </p:cNvPr>
            <p:cNvSpPr txBox="1"/>
            <p:nvPr/>
          </p:nvSpPr>
          <p:spPr>
            <a:xfrm>
              <a:off x="1183399" y="2385294"/>
              <a:ext cx="390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CC48B31-24C3-6349-86A1-D8B17E8A2E6E}"/>
                </a:ext>
              </a:extLst>
            </p:cNvPr>
            <p:cNvSpPr txBox="1"/>
            <p:nvPr/>
          </p:nvSpPr>
          <p:spPr>
            <a:xfrm>
              <a:off x="1183399" y="1841417"/>
              <a:ext cx="390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05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4AC8D56-CC9D-7D4F-9AE3-DE5DE6FA7D07}"/>
                </a:ext>
              </a:extLst>
            </p:cNvPr>
            <p:cNvSpPr txBox="1"/>
            <p:nvPr/>
          </p:nvSpPr>
          <p:spPr>
            <a:xfrm>
              <a:off x="1250077" y="1311415"/>
              <a:ext cx="390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1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4B2ED217-851A-714E-AD1C-EA099307F4D5}"/>
                </a:ext>
              </a:extLst>
            </p:cNvPr>
            <p:cNvSpPr txBox="1"/>
            <p:nvPr/>
          </p:nvSpPr>
          <p:spPr>
            <a:xfrm>
              <a:off x="1187570" y="765941"/>
              <a:ext cx="390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15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C49DEC0-62AD-0C45-9AE6-9FA2D8BEEB8D}"/>
                </a:ext>
              </a:extLst>
            </p:cNvPr>
            <p:cNvSpPr txBox="1"/>
            <p:nvPr/>
          </p:nvSpPr>
          <p:spPr>
            <a:xfrm rot="16200000">
              <a:off x="3262556" y="1145642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Cell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core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04BD267-6615-2647-85DA-C5C05C4418B4}"/>
                </a:ext>
              </a:extLst>
            </p:cNvPr>
            <p:cNvSpPr txBox="1"/>
            <p:nvPr/>
          </p:nvSpPr>
          <p:spPr>
            <a:xfrm rot="16200000">
              <a:off x="398815" y="1155645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Cell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core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F3A69970-54DC-0B4D-A6A4-17A98637A040}"/>
                </a:ext>
              </a:extLst>
            </p:cNvPr>
            <p:cNvSpPr/>
            <p:nvPr/>
          </p:nvSpPr>
          <p:spPr>
            <a:xfrm>
              <a:off x="5641069" y="1014901"/>
              <a:ext cx="158839" cy="110450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8E54B678-C9E5-CF41-8748-07CFB4EEAFF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72866" y="1403042"/>
              <a:ext cx="5029200" cy="1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5AC5C7E-993F-0F4D-8E3D-72318BBC83C5}"/>
                </a:ext>
              </a:extLst>
            </p:cNvPr>
            <p:cNvSpPr txBox="1"/>
            <p:nvPr/>
          </p:nvSpPr>
          <p:spPr>
            <a:xfrm>
              <a:off x="1481696" y="2526732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06B9970-824A-CE47-9646-DC7079C314B1}"/>
                </a:ext>
              </a:extLst>
            </p:cNvPr>
            <p:cNvSpPr txBox="1"/>
            <p:nvPr/>
          </p:nvSpPr>
          <p:spPr>
            <a:xfrm>
              <a:off x="1637357" y="252677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0C66FBD-79B3-8C4E-A8A6-12A1962B6D19}"/>
                </a:ext>
              </a:extLst>
            </p:cNvPr>
            <p:cNvSpPr txBox="1"/>
            <p:nvPr/>
          </p:nvSpPr>
          <p:spPr>
            <a:xfrm>
              <a:off x="1785339" y="2526732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252D37E-38B9-E445-AEBF-9356A692A410}"/>
                </a:ext>
              </a:extLst>
            </p:cNvPr>
            <p:cNvSpPr txBox="1"/>
            <p:nvPr/>
          </p:nvSpPr>
          <p:spPr>
            <a:xfrm>
              <a:off x="1951699" y="2524055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903233A0-3CAC-9147-B0B5-927E9C6D35DF}"/>
                </a:ext>
              </a:extLst>
            </p:cNvPr>
            <p:cNvSpPr txBox="1"/>
            <p:nvPr/>
          </p:nvSpPr>
          <p:spPr>
            <a:xfrm>
              <a:off x="2103558" y="252191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FA00944-E6A0-034F-81CA-CD62FA7E991E}"/>
                </a:ext>
              </a:extLst>
            </p:cNvPr>
            <p:cNvSpPr txBox="1"/>
            <p:nvPr/>
          </p:nvSpPr>
          <p:spPr>
            <a:xfrm>
              <a:off x="2262938" y="251978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F95EC887-337D-364C-8213-82721E085B97}"/>
                </a:ext>
              </a:extLst>
            </p:cNvPr>
            <p:cNvSpPr txBox="1"/>
            <p:nvPr/>
          </p:nvSpPr>
          <p:spPr>
            <a:xfrm>
              <a:off x="2420818" y="2524055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B12FCEF-AB17-2A4C-AEC1-153525B1C3F7}"/>
                </a:ext>
              </a:extLst>
            </p:cNvPr>
            <p:cNvSpPr txBox="1"/>
            <p:nvPr/>
          </p:nvSpPr>
          <p:spPr>
            <a:xfrm>
              <a:off x="2570979" y="2524596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6E8AF93C-2AF6-E847-99CF-DEAFC05D15A3}"/>
                </a:ext>
              </a:extLst>
            </p:cNvPr>
            <p:cNvSpPr txBox="1"/>
            <p:nvPr/>
          </p:nvSpPr>
          <p:spPr>
            <a:xfrm>
              <a:off x="2729818" y="252191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AD4D85D-557E-F542-A2BF-F2696156070D}"/>
                </a:ext>
              </a:extLst>
            </p:cNvPr>
            <p:cNvSpPr txBox="1"/>
            <p:nvPr/>
          </p:nvSpPr>
          <p:spPr>
            <a:xfrm>
              <a:off x="2888657" y="251978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B0BDB90-52EF-7741-8E4F-D275C1D3D6F9}"/>
                </a:ext>
              </a:extLst>
            </p:cNvPr>
            <p:cNvSpPr txBox="1"/>
            <p:nvPr/>
          </p:nvSpPr>
          <p:spPr>
            <a:xfrm>
              <a:off x="2987921" y="2524086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3988732-A79D-5F44-BB84-C8C2096818ED}"/>
                </a:ext>
              </a:extLst>
            </p:cNvPr>
            <p:cNvSpPr txBox="1"/>
            <p:nvPr/>
          </p:nvSpPr>
          <p:spPr>
            <a:xfrm>
              <a:off x="3147719" y="2524596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0DAB3FC-C084-F148-9F30-449602050E2E}"/>
                </a:ext>
              </a:extLst>
            </p:cNvPr>
            <p:cNvSpPr txBox="1"/>
            <p:nvPr/>
          </p:nvSpPr>
          <p:spPr>
            <a:xfrm>
              <a:off x="3309922" y="2524596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B914191-1FFF-9C40-B1E4-588453DF8B94}"/>
                </a:ext>
              </a:extLst>
            </p:cNvPr>
            <p:cNvSpPr txBox="1"/>
            <p:nvPr/>
          </p:nvSpPr>
          <p:spPr>
            <a:xfrm>
              <a:off x="2390216" y="2792443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dentity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E50106CE-3BEE-E845-B601-E03C133AC1E8}"/>
                </a:ext>
              </a:extLst>
            </p:cNvPr>
            <p:cNvSpPr txBox="1"/>
            <p:nvPr/>
          </p:nvSpPr>
          <p:spPr>
            <a:xfrm>
              <a:off x="913532" y="543545"/>
              <a:ext cx="4086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2D16CE1A-F473-304A-90F9-A479BC87A5BF}"/>
                </a:ext>
              </a:extLst>
            </p:cNvPr>
            <p:cNvSpPr txBox="1"/>
            <p:nvPr/>
          </p:nvSpPr>
          <p:spPr>
            <a:xfrm>
              <a:off x="918423" y="3295482"/>
              <a:ext cx="4086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C0140FAA-083A-204D-BE13-72D1C3B3F150}"/>
                </a:ext>
              </a:extLst>
            </p:cNvPr>
            <p:cNvSpPr txBox="1"/>
            <p:nvPr/>
          </p:nvSpPr>
          <p:spPr>
            <a:xfrm>
              <a:off x="4835209" y="608042"/>
              <a:ext cx="1429555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LP_BALB/c Glycolysis</a:t>
              </a:r>
            </a:p>
            <a:p>
              <a:endParaRPr lang="en-US" dirty="0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15EFD40-6330-7D43-BC98-F574F7F5C728}"/>
                </a:ext>
              </a:extLst>
            </p:cNvPr>
            <p:cNvSpPr txBox="1"/>
            <p:nvPr/>
          </p:nvSpPr>
          <p:spPr>
            <a:xfrm>
              <a:off x="1986854" y="606580"/>
              <a:ext cx="1704055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ham_BALB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/c Glycolysis</a:t>
              </a:r>
            </a:p>
            <a:p>
              <a:endParaRPr lang="en-US" dirty="0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D62B522-2241-754A-98EC-D65DCB2F21DF}"/>
                </a:ext>
              </a:extLst>
            </p:cNvPr>
            <p:cNvSpPr txBox="1"/>
            <p:nvPr/>
          </p:nvSpPr>
          <p:spPr>
            <a:xfrm>
              <a:off x="925255" y="5599595"/>
              <a:ext cx="4086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EBD54E2-6151-664E-B164-DA5D99028D8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865388" y="5600090"/>
              <a:ext cx="1422400" cy="16129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FB7A041-0331-B144-A14A-94CE8744CD4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792734" y="5600090"/>
              <a:ext cx="1435100" cy="16129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515041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9D1395C-E5A8-F54C-9AE2-0903BE530B55}"/>
              </a:ext>
            </a:extLst>
          </p:cNvPr>
          <p:cNvSpPr txBox="1"/>
          <p:nvPr/>
        </p:nvSpPr>
        <p:spPr>
          <a:xfrm>
            <a:off x="121088" y="118060"/>
            <a:ext cx="18504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4C11357-CF58-865E-598C-F5F5F9CDA2F4}"/>
              </a:ext>
            </a:extLst>
          </p:cNvPr>
          <p:cNvGrpSpPr/>
          <p:nvPr/>
        </p:nvGrpSpPr>
        <p:grpSpPr>
          <a:xfrm>
            <a:off x="17636" y="485532"/>
            <a:ext cx="9225584" cy="6519801"/>
            <a:chOff x="17636" y="485532"/>
            <a:chExt cx="9225584" cy="6519801"/>
          </a:xfrm>
        </p:grpSpPr>
        <p:pic>
          <p:nvPicPr>
            <p:cNvPr id="139" name="Picture 138">
              <a:extLst>
                <a:ext uri="{FF2B5EF4-FFF2-40B4-BE49-F238E27FC236}">
                  <a16:creationId xmlns:a16="http://schemas.microsoft.com/office/drawing/2014/main" id="{3549060B-3E96-5A4B-ADE8-CA086EB07C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53644" y="5379061"/>
              <a:ext cx="1308100" cy="1612900"/>
            </a:xfrm>
            <a:prstGeom prst="rect">
              <a:avLst/>
            </a:prstGeom>
          </p:spPr>
        </p:pic>
        <p:pic>
          <p:nvPicPr>
            <p:cNvPr id="136" name="Picture 135">
              <a:extLst>
                <a:ext uri="{FF2B5EF4-FFF2-40B4-BE49-F238E27FC236}">
                  <a16:creationId xmlns:a16="http://schemas.microsoft.com/office/drawing/2014/main" id="{E1A884BA-BC71-9F44-B10E-AF7BD32DAC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282" y="5385569"/>
              <a:ext cx="1206500" cy="1612900"/>
            </a:xfrm>
            <a:prstGeom prst="rect">
              <a:avLst/>
            </a:prstGeom>
          </p:spPr>
        </p:pic>
        <p:pic>
          <p:nvPicPr>
            <p:cNvPr id="135" name="Picture 134">
              <a:extLst>
                <a:ext uri="{FF2B5EF4-FFF2-40B4-BE49-F238E27FC236}">
                  <a16:creationId xmlns:a16="http://schemas.microsoft.com/office/drawing/2014/main" id="{8570735E-9657-EE4E-BEDC-BAA21A2A94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66611" y="3079113"/>
              <a:ext cx="4622800" cy="1993900"/>
            </a:xfrm>
            <a:prstGeom prst="rect">
              <a:avLst/>
            </a:prstGeom>
          </p:spPr>
        </p:pic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id="{2E23411E-6CAE-BA4C-938E-9A2C9965796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038" y="3083549"/>
              <a:ext cx="4635500" cy="19939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B98EDBF-E9D0-EA41-B27D-65D7D97645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5128" t="11378" b="8173"/>
            <a:stretch/>
          </p:blipFill>
          <p:spPr>
            <a:xfrm>
              <a:off x="2602911" y="723900"/>
              <a:ext cx="1941006" cy="164592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1C520A8-2B48-A14B-8080-2A953C2381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128" t="11538" b="8013"/>
            <a:stretch/>
          </p:blipFill>
          <p:spPr>
            <a:xfrm>
              <a:off x="370239" y="723900"/>
              <a:ext cx="1941006" cy="164592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FE99F01E-48DB-E14B-A199-AE5E2B0F27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5192" t="11539" b="7691"/>
            <a:stretch/>
          </p:blipFill>
          <p:spPr>
            <a:xfrm>
              <a:off x="7136340" y="723900"/>
              <a:ext cx="1931997" cy="164592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E27EDCB-CAD5-414B-82DC-B631A9F5B5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5131" t="11258" b="7780"/>
            <a:stretch/>
          </p:blipFill>
          <p:spPr>
            <a:xfrm>
              <a:off x="4927049" y="723900"/>
              <a:ext cx="1928651" cy="1645920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57929A3-F77D-F243-A8BA-FDA23BE88BD0}"/>
                </a:ext>
              </a:extLst>
            </p:cNvPr>
            <p:cNvSpPr txBox="1"/>
            <p:nvPr/>
          </p:nvSpPr>
          <p:spPr>
            <a:xfrm>
              <a:off x="3363602" y="2476654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dentity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3726643-1E35-8445-AA8B-59DA3E052324}"/>
                </a:ext>
              </a:extLst>
            </p:cNvPr>
            <p:cNvSpPr txBox="1"/>
            <p:nvPr/>
          </p:nvSpPr>
          <p:spPr>
            <a:xfrm>
              <a:off x="367466" y="2311668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65AC044-D9E4-3349-BCBA-3EA220F1225A}"/>
                </a:ext>
              </a:extLst>
            </p:cNvPr>
            <p:cNvSpPr txBox="1"/>
            <p:nvPr/>
          </p:nvSpPr>
          <p:spPr>
            <a:xfrm>
              <a:off x="503031" y="231170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25D91F7-CD0E-6B49-8C86-8F71154C73D8}"/>
                </a:ext>
              </a:extLst>
            </p:cNvPr>
            <p:cNvSpPr txBox="1"/>
            <p:nvPr/>
          </p:nvSpPr>
          <p:spPr>
            <a:xfrm>
              <a:off x="651013" y="2311668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D1AD7D63-6821-2D43-817C-DF61DBAE01DB}"/>
                </a:ext>
              </a:extLst>
            </p:cNvPr>
            <p:cNvSpPr txBox="1"/>
            <p:nvPr/>
          </p:nvSpPr>
          <p:spPr>
            <a:xfrm>
              <a:off x="797277" y="2308991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2AAE964-F086-F84A-8D92-E2FC954E7727}"/>
                </a:ext>
              </a:extLst>
            </p:cNvPr>
            <p:cNvSpPr txBox="1"/>
            <p:nvPr/>
          </p:nvSpPr>
          <p:spPr>
            <a:xfrm>
              <a:off x="939088" y="2306855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9A2742AD-FD53-D748-B59C-7F0E677B8471}"/>
                </a:ext>
              </a:extLst>
            </p:cNvPr>
            <p:cNvSpPr txBox="1"/>
            <p:nvPr/>
          </p:nvSpPr>
          <p:spPr>
            <a:xfrm>
              <a:off x="1078372" y="230471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2B2B703E-680A-5845-9962-E95A8FE12B7B}"/>
                </a:ext>
              </a:extLst>
            </p:cNvPr>
            <p:cNvSpPr txBox="1"/>
            <p:nvPr/>
          </p:nvSpPr>
          <p:spPr>
            <a:xfrm>
              <a:off x="1226204" y="2308991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16BA90C-9539-4848-A0AC-EA0B77F7E678}"/>
                </a:ext>
              </a:extLst>
            </p:cNvPr>
            <p:cNvSpPr txBox="1"/>
            <p:nvPr/>
          </p:nvSpPr>
          <p:spPr>
            <a:xfrm>
              <a:off x="1366317" y="2309532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4CACB2B-11EA-3541-ADFE-5BD1A40BD180}"/>
                </a:ext>
              </a:extLst>
            </p:cNvPr>
            <p:cNvSpPr txBox="1"/>
            <p:nvPr/>
          </p:nvSpPr>
          <p:spPr>
            <a:xfrm>
              <a:off x="1505060" y="2306855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F83BDAEC-3FF6-F949-89EB-664B7AA2E253}"/>
                </a:ext>
              </a:extLst>
            </p:cNvPr>
            <p:cNvSpPr txBox="1"/>
            <p:nvPr/>
          </p:nvSpPr>
          <p:spPr>
            <a:xfrm>
              <a:off x="1653851" y="230471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283B029D-3335-4E44-9AFE-007E12B7B098}"/>
                </a:ext>
              </a:extLst>
            </p:cNvPr>
            <p:cNvSpPr txBox="1"/>
            <p:nvPr/>
          </p:nvSpPr>
          <p:spPr>
            <a:xfrm>
              <a:off x="1743067" y="2298974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F4908F7-A750-0E45-9C7D-8EE24164FC8F}"/>
                </a:ext>
              </a:extLst>
            </p:cNvPr>
            <p:cNvSpPr txBox="1"/>
            <p:nvPr/>
          </p:nvSpPr>
          <p:spPr>
            <a:xfrm>
              <a:off x="1902865" y="2299484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A5C7FAA-CB3F-7540-A34E-1DE0A48EFB06}"/>
                </a:ext>
              </a:extLst>
            </p:cNvPr>
            <p:cNvSpPr txBox="1"/>
            <p:nvPr/>
          </p:nvSpPr>
          <p:spPr>
            <a:xfrm>
              <a:off x="2044972" y="2299484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15A8682-5DB1-4843-9446-6D7D06E30D0C}"/>
                </a:ext>
              </a:extLst>
            </p:cNvPr>
            <p:cNvSpPr txBox="1"/>
            <p:nvPr/>
          </p:nvSpPr>
          <p:spPr>
            <a:xfrm>
              <a:off x="1095394" y="2478669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dentity</a:t>
              </a:r>
            </a:p>
          </p:txBody>
        </p: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A0634D98-A431-E448-8329-01BD231B7754}"/>
                </a:ext>
              </a:extLst>
            </p:cNvPr>
            <p:cNvGrpSpPr/>
            <p:nvPr/>
          </p:nvGrpSpPr>
          <p:grpSpPr>
            <a:xfrm>
              <a:off x="138161" y="702147"/>
              <a:ext cx="402854" cy="1682399"/>
              <a:chOff x="138161" y="702147"/>
              <a:chExt cx="402854" cy="1682399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3F1A0C19-39ED-5C41-BC49-EC9822FE51D9}"/>
                  </a:ext>
                </a:extLst>
              </p:cNvPr>
              <p:cNvSpPr txBox="1"/>
              <p:nvPr/>
            </p:nvSpPr>
            <p:spPr>
              <a:xfrm>
                <a:off x="138161" y="2169102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CB71D728-794F-8E46-A7D4-DFB7FA3E9B67}"/>
                  </a:ext>
                </a:extLst>
              </p:cNvPr>
              <p:cNvSpPr txBox="1"/>
              <p:nvPr/>
            </p:nvSpPr>
            <p:spPr>
              <a:xfrm>
                <a:off x="144985" y="1795825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566003C-716D-D44F-90D6-956E394AF685}"/>
                  </a:ext>
                </a:extLst>
              </p:cNvPr>
              <p:cNvSpPr txBox="1"/>
              <p:nvPr/>
            </p:nvSpPr>
            <p:spPr>
              <a:xfrm>
                <a:off x="150247" y="1450071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8E2FA613-1D55-5049-9F46-0675D8205EA9}"/>
                  </a:ext>
                </a:extLst>
              </p:cNvPr>
              <p:cNvSpPr txBox="1"/>
              <p:nvPr/>
            </p:nvSpPr>
            <p:spPr>
              <a:xfrm>
                <a:off x="142332" y="1068373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D9D1CD17-033B-2740-BC97-3CA9682A9DA3}"/>
                  </a:ext>
                </a:extLst>
              </p:cNvPr>
              <p:cNvSpPr txBox="1"/>
              <p:nvPr/>
            </p:nvSpPr>
            <p:spPr>
              <a:xfrm>
                <a:off x="144985" y="702147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</p:txBody>
          </p: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4D5038E5-6E45-944F-9A66-740C7A7C3889}"/>
                </a:ext>
              </a:extLst>
            </p:cNvPr>
            <p:cNvGrpSpPr/>
            <p:nvPr/>
          </p:nvGrpSpPr>
          <p:grpSpPr>
            <a:xfrm>
              <a:off x="2363396" y="695323"/>
              <a:ext cx="402854" cy="1682399"/>
              <a:chOff x="138161" y="702147"/>
              <a:chExt cx="402854" cy="1682399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57E0DCF6-A436-0846-AEA1-54721B6412D8}"/>
                  </a:ext>
                </a:extLst>
              </p:cNvPr>
              <p:cNvSpPr txBox="1"/>
              <p:nvPr/>
            </p:nvSpPr>
            <p:spPr>
              <a:xfrm>
                <a:off x="138161" y="2169102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48E34B9D-FCB9-F741-A8B7-D0B4330CDF7F}"/>
                  </a:ext>
                </a:extLst>
              </p:cNvPr>
              <p:cNvSpPr txBox="1"/>
              <p:nvPr/>
            </p:nvSpPr>
            <p:spPr>
              <a:xfrm>
                <a:off x="144985" y="1795825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FD7132D5-0636-C849-8532-1D3AD6F306F7}"/>
                  </a:ext>
                </a:extLst>
              </p:cNvPr>
              <p:cNvSpPr txBox="1"/>
              <p:nvPr/>
            </p:nvSpPr>
            <p:spPr>
              <a:xfrm>
                <a:off x="150247" y="1450071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C9B52079-E472-3A43-9516-6B96BD955503}"/>
                  </a:ext>
                </a:extLst>
              </p:cNvPr>
              <p:cNvSpPr txBox="1"/>
              <p:nvPr/>
            </p:nvSpPr>
            <p:spPr>
              <a:xfrm>
                <a:off x="142332" y="1068373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7496195C-1031-F048-A3A8-C4EF0C878EAF}"/>
                  </a:ext>
                </a:extLst>
              </p:cNvPr>
              <p:cNvSpPr txBox="1"/>
              <p:nvPr/>
            </p:nvSpPr>
            <p:spPr>
              <a:xfrm>
                <a:off x="144985" y="702147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</p:txBody>
          </p:sp>
        </p:grp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45E911AD-6112-C445-84DE-3627C9F0DD05}"/>
                </a:ext>
              </a:extLst>
            </p:cNvPr>
            <p:cNvSpPr txBox="1"/>
            <p:nvPr/>
          </p:nvSpPr>
          <p:spPr>
            <a:xfrm>
              <a:off x="2618396" y="2323022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039CC9C-ED3F-0D4D-A6C5-9A209884E538}"/>
                </a:ext>
              </a:extLst>
            </p:cNvPr>
            <p:cNvSpPr txBox="1"/>
            <p:nvPr/>
          </p:nvSpPr>
          <p:spPr>
            <a:xfrm>
              <a:off x="2753961" y="232306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85C72B5C-65B2-F744-AD2D-4E3B6EBEC470}"/>
                </a:ext>
              </a:extLst>
            </p:cNvPr>
            <p:cNvSpPr txBox="1"/>
            <p:nvPr/>
          </p:nvSpPr>
          <p:spPr>
            <a:xfrm>
              <a:off x="2901943" y="2323022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E9C8B99-737A-8647-BCE7-30549398EE0B}"/>
                </a:ext>
              </a:extLst>
            </p:cNvPr>
            <p:cNvSpPr txBox="1"/>
            <p:nvPr/>
          </p:nvSpPr>
          <p:spPr>
            <a:xfrm>
              <a:off x="3048207" y="2320345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7632989-8621-D04F-B0FE-B88FCC1E09ED}"/>
                </a:ext>
              </a:extLst>
            </p:cNvPr>
            <p:cNvSpPr txBox="1"/>
            <p:nvPr/>
          </p:nvSpPr>
          <p:spPr>
            <a:xfrm>
              <a:off x="3190018" y="231820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43450E0-D0C3-3E45-B407-E8A0A852080C}"/>
                </a:ext>
              </a:extLst>
            </p:cNvPr>
            <p:cNvSpPr txBox="1"/>
            <p:nvPr/>
          </p:nvSpPr>
          <p:spPr>
            <a:xfrm>
              <a:off x="3329302" y="231607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B46F8D4-4EB6-6444-B436-D7C02061CA16}"/>
                </a:ext>
              </a:extLst>
            </p:cNvPr>
            <p:cNvSpPr txBox="1"/>
            <p:nvPr/>
          </p:nvSpPr>
          <p:spPr>
            <a:xfrm>
              <a:off x="3477134" y="2320345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4B8E876-4640-0248-AC85-13A7ADAE51F7}"/>
                </a:ext>
              </a:extLst>
            </p:cNvPr>
            <p:cNvSpPr txBox="1"/>
            <p:nvPr/>
          </p:nvSpPr>
          <p:spPr>
            <a:xfrm>
              <a:off x="3617247" y="2320886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89D7674-BF3D-744B-A872-67DE3C359963}"/>
                </a:ext>
              </a:extLst>
            </p:cNvPr>
            <p:cNvSpPr txBox="1"/>
            <p:nvPr/>
          </p:nvSpPr>
          <p:spPr>
            <a:xfrm>
              <a:off x="3755990" y="231820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7176B93-F693-5243-AC16-02CB033AE336}"/>
                </a:ext>
              </a:extLst>
            </p:cNvPr>
            <p:cNvSpPr txBox="1"/>
            <p:nvPr/>
          </p:nvSpPr>
          <p:spPr>
            <a:xfrm>
              <a:off x="3904781" y="231607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2F621FE6-5022-CA40-93F4-2697932E85AF}"/>
                </a:ext>
              </a:extLst>
            </p:cNvPr>
            <p:cNvSpPr txBox="1"/>
            <p:nvPr/>
          </p:nvSpPr>
          <p:spPr>
            <a:xfrm>
              <a:off x="3993997" y="2310328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7EBC29FE-7363-2D4F-81DE-739C8674F75A}"/>
                </a:ext>
              </a:extLst>
            </p:cNvPr>
            <p:cNvSpPr txBox="1"/>
            <p:nvPr/>
          </p:nvSpPr>
          <p:spPr>
            <a:xfrm>
              <a:off x="4153795" y="2310838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525C69DE-08ED-9145-B8C7-1587CFE1778F}"/>
                </a:ext>
              </a:extLst>
            </p:cNvPr>
            <p:cNvSpPr txBox="1"/>
            <p:nvPr/>
          </p:nvSpPr>
          <p:spPr>
            <a:xfrm>
              <a:off x="4295902" y="2310838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0B78DF4-A5BC-A44C-AB81-0386FD5C6DFF}"/>
                </a:ext>
              </a:extLst>
            </p:cNvPr>
            <p:cNvSpPr txBox="1"/>
            <p:nvPr/>
          </p:nvSpPr>
          <p:spPr>
            <a:xfrm rot="16200000">
              <a:off x="-525011" y="1084775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Cell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core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736DFBE0-885B-DC4C-BDB4-00D0B72FA3D0}"/>
                </a:ext>
              </a:extLst>
            </p:cNvPr>
            <p:cNvSpPr txBox="1"/>
            <p:nvPr/>
          </p:nvSpPr>
          <p:spPr>
            <a:xfrm rot="16200000">
              <a:off x="1658072" y="1071988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Cell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core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5AF04CB7-2921-1446-8090-5A27DC68950F}"/>
                </a:ext>
              </a:extLst>
            </p:cNvPr>
            <p:cNvSpPr txBox="1"/>
            <p:nvPr/>
          </p:nvSpPr>
          <p:spPr>
            <a:xfrm>
              <a:off x="5664848" y="2480768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dentity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0808A49F-F79F-7E4D-B7F5-8C3089C236A5}"/>
                </a:ext>
              </a:extLst>
            </p:cNvPr>
            <p:cNvSpPr txBox="1"/>
            <p:nvPr/>
          </p:nvSpPr>
          <p:spPr>
            <a:xfrm>
              <a:off x="4919642" y="2317088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8E3177C-B693-D747-B19F-B6DFA1E09832}"/>
                </a:ext>
              </a:extLst>
            </p:cNvPr>
            <p:cNvSpPr txBox="1"/>
            <p:nvPr/>
          </p:nvSpPr>
          <p:spPr>
            <a:xfrm>
              <a:off x="5055207" y="231712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87610E9-F1A0-B448-8C79-7653688FA4D0}"/>
                </a:ext>
              </a:extLst>
            </p:cNvPr>
            <p:cNvSpPr txBox="1"/>
            <p:nvPr/>
          </p:nvSpPr>
          <p:spPr>
            <a:xfrm>
              <a:off x="5203189" y="2317088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EBF026C0-FA3B-6D4B-AD88-783F7B8D54F5}"/>
                </a:ext>
              </a:extLst>
            </p:cNvPr>
            <p:cNvSpPr txBox="1"/>
            <p:nvPr/>
          </p:nvSpPr>
          <p:spPr>
            <a:xfrm>
              <a:off x="5349453" y="2314411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C9B2BE7E-98D2-724E-8130-9B97C48092DF}"/>
                </a:ext>
              </a:extLst>
            </p:cNvPr>
            <p:cNvSpPr txBox="1"/>
            <p:nvPr/>
          </p:nvSpPr>
          <p:spPr>
            <a:xfrm>
              <a:off x="5491264" y="2312275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DEE968A-E022-AE45-8F1F-4682E6C8D48F}"/>
                </a:ext>
              </a:extLst>
            </p:cNvPr>
            <p:cNvSpPr txBox="1"/>
            <p:nvPr/>
          </p:nvSpPr>
          <p:spPr>
            <a:xfrm>
              <a:off x="5630548" y="231013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7F438E18-C234-9347-86E5-F949B630668C}"/>
                </a:ext>
              </a:extLst>
            </p:cNvPr>
            <p:cNvSpPr txBox="1"/>
            <p:nvPr/>
          </p:nvSpPr>
          <p:spPr>
            <a:xfrm>
              <a:off x="5778380" y="2314411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2E60CD5E-9FF4-6F41-99C5-096CADCAF695}"/>
                </a:ext>
              </a:extLst>
            </p:cNvPr>
            <p:cNvSpPr txBox="1"/>
            <p:nvPr/>
          </p:nvSpPr>
          <p:spPr>
            <a:xfrm>
              <a:off x="5918493" y="2314952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38B6C157-3D92-5343-AA5A-BFE8EBBF0506}"/>
                </a:ext>
              </a:extLst>
            </p:cNvPr>
            <p:cNvSpPr txBox="1"/>
            <p:nvPr/>
          </p:nvSpPr>
          <p:spPr>
            <a:xfrm>
              <a:off x="6057236" y="2312275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5A8F4F04-4BE6-C04E-BBBF-E11C1A0402BA}"/>
                </a:ext>
              </a:extLst>
            </p:cNvPr>
            <p:cNvSpPr txBox="1"/>
            <p:nvPr/>
          </p:nvSpPr>
          <p:spPr>
            <a:xfrm>
              <a:off x="6206027" y="231013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5E21D7CD-64A9-DD44-B02E-ED66C9906956}"/>
                </a:ext>
              </a:extLst>
            </p:cNvPr>
            <p:cNvSpPr txBox="1"/>
            <p:nvPr/>
          </p:nvSpPr>
          <p:spPr>
            <a:xfrm>
              <a:off x="6295243" y="2304394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0BFEE9E7-488E-1D48-98F3-8ED0CA36E2A6}"/>
                </a:ext>
              </a:extLst>
            </p:cNvPr>
            <p:cNvSpPr txBox="1"/>
            <p:nvPr/>
          </p:nvSpPr>
          <p:spPr>
            <a:xfrm>
              <a:off x="6434945" y="2304904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72D8B3B1-983E-284F-B4F4-B1A18D74810C}"/>
                </a:ext>
              </a:extLst>
            </p:cNvPr>
            <p:cNvSpPr txBox="1"/>
            <p:nvPr/>
          </p:nvSpPr>
          <p:spPr>
            <a:xfrm>
              <a:off x="6577052" y="2304904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68AF4C9B-523E-D149-B0C8-06E2BB8F5A7F}"/>
                </a:ext>
              </a:extLst>
            </p:cNvPr>
            <p:cNvGrpSpPr/>
            <p:nvPr/>
          </p:nvGrpSpPr>
          <p:grpSpPr>
            <a:xfrm>
              <a:off x="4686497" y="697469"/>
              <a:ext cx="402854" cy="1682399"/>
              <a:chOff x="138161" y="702147"/>
              <a:chExt cx="402854" cy="1682399"/>
            </a:xfrm>
          </p:grpSpPr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7F5E5D5B-C6E2-8F46-B199-24ADEC3069CC}"/>
                  </a:ext>
                </a:extLst>
              </p:cNvPr>
              <p:cNvSpPr txBox="1"/>
              <p:nvPr/>
            </p:nvSpPr>
            <p:spPr>
              <a:xfrm>
                <a:off x="138161" y="2169102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1948B631-890A-4541-B70F-40D947046DD3}"/>
                  </a:ext>
                </a:extLst>
              </p:cNvPr>
              <p:cNvSpPr txBox="1"/>
              <p:nvPr/>
            </p:nvSpPr>
            <p:spPr>
              <a:xfrm>
                <a:off x="144985" y="1795825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60B30407-13E0-6145-BEAD-B6CCD76163F3}"/>
                  </a:ext>
                </a:extLst>
              </p:cNvPr>
              <p:cNvSpPr txBox="1"/>
              <p:nvPr/>
            </p:nvSpPr>
            <p:spPr>
              <a:xfrm>
                <a:off x="150247" y="1450071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FA046480-290D-FF48-89CB-30A7EFA74018}"/>
                  </a:ext>
                </a:extLst>
              </p:cNvPr>
              <p:cNvSpPr txBox="1"/>
              <p:nvPr/>
            </p:nvSpPr>
            <p:spPr>
              <a:xfrm>
                <a:off x="142332" y="1068373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6404071F-2589-6D41-8072-08EF72B2C05B}"/>
                  </a:ext>
                </a:extLst>
              </p:cNvPr>
              <p:cNvSpPr txBox="1"/>
              <p:nvPr/>
            </p:nvSpPr>
            <p:spPr>
              <a:xfrm>
                <a:off x="144985" y="702147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</p:txBody>
          </p:sp>
        </p:grp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BF8B0392-FDD7-C440-BB00-3E5D20D1EC17}"/>
                </a:ext>
              </a:extLst>
            </p:cNvPr>
            <p:cNvSpPr txBox="1"/>
            <p:nvPr/>
          </p:nvSpPr>
          <p:spPr>
            <a:xfrm rot="16200000">
              <a:off x="3990782" y="1083678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Cell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core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B35857EC-F2B2-7742-841A-BEB5A4590CB8}"/>
                </a:ext>
              </a:extLst>
            </p:cNvPr>
            <p:cNvSpPr txBox="1"/>
            <p:nvPr/>
          </p:nvSpPr>
          <p:spPr>
            <a:xfrm>
              <a:off x="7871677" y="2474684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dentity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69B78AD-FEE7-B444-A4AA-32C8FEB45AD7}"/>
                </a:ext>
              </a:extLst>
            </p:cNvPr>
            <p:cNvSpPr txBox="1"/>
            <p:nvPr/>
          </p:nvSpPr>
          <p:spPr>
            <a:xfrm>
              <a:off x="7126471" y="2300956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3E06C242-41B2-4D45-B72E-7F606BFEFAD6}"/>
                </a:ext>
              </a:extLst>
            </p:cNvPr>
            <p:cNvSpPr txBox="1"/>
            <p:nvPr/>
          </p:nvSpPr>
          <p:spPr>
            <a:xfrm>
              <a:off x="7262036" y="2300997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739B337A-D905-5B4C-8DBB-F646E42D1216}"/>
                </a:ext>
              </a:extLst>
            </p:cNvPr>
            <p:cNvSpPr txBox="1"/>
            <p:nvPr/>
          </p:nvSpPr>
          <p:spPr>
            <a:xfrm>
              <a:off x="7410018" y="2300956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209E3793-EFE4-3B4A-B09B-00726CD4D470}"/>
                </a:ext>
              </a:extLst>
            </p:cNvPr>
            <p:cNvSpPr txBox="1"/>
            <p:nvPr/>
          </p:nvSpPr>
          <p:spPr>
            <a:xfrm>
              <a:off x="7556282" y="229827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A08E0A9-864F-EE48-851A-889A9E620662}"/>
                </a:ext>
              </a:extLst>
            </p:cNvPr>
            <p:cNvSpPr txBox="1"/>
            <p:nvPr/>
          </p:nvSpPr>
          <p:spPr>
            <a:xfrm>
              <a:off x="7698093" y="229614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443F7FED-21CF-1545-AF73-6B9F169ABEAB}"/>
                </a:ext>
              </a:extLst>
            </p:cNvPr>
            <p:cNvSpPr txBox="1"/>
            <p:nvPr/>
          </p:nvSpPr>
          <p:spPr>
            <a:xfrm>
              <a:off x="7837377" y="2294007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2FEFDCAF-E07C-8844-8073-9C5CE23704BA}"/>
                </a:ext>
              </a:extLst>
            </p:cNvPr>
            <p:cNvSpPr txBox="1"/>
            <p:nvPr/>
          </p:nvSpPr>
          <p:spPr>
            <a:xfrm>
              <a:off x="7985209" y="2298279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34401E5A-CF6E-BE4A-8834-8A69459E24C9}"/>
                </a:ext>
              </a:extLst>
            </p:cNvPr>
            <p:cNvSpPr txBox="1"/>
            <p:nvPr/>
          </p:nvSpPr>
          <p:spPr>
            <a:xfrm>
              <a:off x="8125322" y="2298820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B9F503D2-F6D9-044E-BED1-5C2DB51876B9}"/>
                </a:ext>
              </a:extLst>
            </p:cNvPr>
            <p:cNvSpPr txBox="1"/>
            <p:nvPr/>
          </p:nvSpPr>
          <p:spPr>
            <a:xfrm>
              <a:off x="8264065" y="2296143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0A6D0500-9286-6D48-B42D-B72D70B31068}"/>
                </a:ext>
              </a:extLst>
            </p:cNvPr>
            <p:cNvSpPr txBox="1"/>
            <p:nvPr/>
          </p:nvSpPr>
          <p:spPr>
            <a:xfrm>
              <a:off x="8412856" y="2294007"/>
              <a:ext cx="161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CD741708-D53D-2F4C-AA51-F9008FC2C1E1}"/>
                </a:ext>
              </a:extLst>
            </p:cNvPr>
            <p:cNvSpPr txBox="1"/>
            <p:nvPr/>
          </p:nvSpPr>
          <p:spPr>
            <a:xfrm>
              <a:off x="8502072" y="2288262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0EF006AB-0CD5-5545-8DC7-0E16F756DA51}"/>
                </a:ext>
              </a:extLst>
            </p:cNvPr>
            <p:cNvSpPr txBox="1"/>
            <p:nvPr/>
          </p:nvSpPr>
          <p:spPr>
            <a:xfrm>
              <a:off x="8661870" y="2288772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55066141-E236-3446-9B3E-2B529543C422}"/>
                </a:ext>
              </a:extLst>
            </p:cNvPr>
            <p:cNvSpPr txBox="1"/>
            <p:nvPr/>
          </p:nvSpPr>
          <p:spPr>
            <a:xfrm>
              <a:off x="8803977" y="2288772"/>
              <a:ext cx="3203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DE0F5477-638C-5248-933F-E8A38260B8E9}"/>
                </a:ext>
              </a:extLst>
            </p:cNvPr>
            <p:cNvGrpSpPr/>
            <p:nvPr/>
          </p:nvGrpSpPr>
          <p:grpSpPr>
            <a:xfrm>
              <a:off x="6898059" y="692099"/>
              <a:ext cx="402854" cy="1682399"/>
              <a:chOff x="138161" y="702147"/>
              <a:chExt cx="402854" cy="1682399"/>
            </a:xfrm>
          </p:grpSpPr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45F1406C-3C89-3E48-8A4B-304800AAF0C7}"/>
                  </a:ext>
                </a:extLst>
              </p:cNvPr>
              <p:cNvSpPr txBox="1"/>
              <p:nvPr/>
            </p:nvSpPr>
            <p:spPr>
              <a:xfrm>
                <a:off x="138161" y="2169102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8F2A63F6-D3A8-A74A-A3D6-071C0A22F975}"/>
                  </a:ext>
                </a:extLst>
              </p:cNvPr>
              <p:cNvSpPr txBox="1"/>
              <p:nvPr/>
            </p:nvSpPr>
            <p:spPr>
              <a:xfrm>
                <a:off x="144985" y="1795825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3AE0CBAC-0A8C-384F-8D0E-4E92AFFE1DC5}"/>
                  </a:ext>
                </a:extLst>
              </p:cNvPr>
              <p:cNvSpPr txBox="1"/>
              <p:nvPr/>
            </p:nvSpPr>
            <p:spPr>
              <a:xfrm>
                <a:off x="150247" y="1450071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</a:p>
            </p:txBody>
          </p: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D4394CD2-CD78-8C4E-B2A3-69FD20D72E35}"/>
                  </a:ext>
                </a:extLst>
              </p:cNvPr>
              <p:cNvSpPr txBox="1"/>
              <p:nvPr/>
            </p:nvSpPr>
            <p:spPr>
              <a:xfrm>
                <a:off x="142332" y="1068373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5CA918EE-D2DE-8F4B-AC7C-048A4B1FD32F}"/>
                  </a:ext>
                </a:extLst>
              </p:cNvPr>
              <p:cNvSpPr txBox="1"/>
              <p:nvPr/>
            </p:nvSpPr>
            <p:spPr>
              <a:xfrm>
                <a:off x="144985" y="702147"/>
                <a:ext cx="390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4</a:t>
                </a:r>
              </a:p>
            </p:txBody>
          </p:sp>
        </p:grp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C2870931-ABCD-A74F-8680-54EE94BBCFAD}"/>
                </a:ext>
              </a:extLst>
            </p:cNvPr>
            <p:cNvSpPr txBox="1"/>
            <p:nvPr/>
          </p:nvSpPr>
          <p:spPr>
            <a:xfrm rot="16200000">
              <a:off x="6165504" y="1063582"/>
              <a:ext cx="13715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Cell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Score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D1D3084B-A311-4D49-B0AF-3CAED7240CB6}"/>
                </a:ext>
              </a:extLst>
            </p:cNvPr>
            <p:cNvSpPr txBox="1"/>
            <p:nvPr/>
          </p:nvSpPr>
          <p:spPr>
            <a:xfrm>
              <a:off x="2977249" y="561746"/>
              <a:ext cx="1429555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LP_C57BL/6J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OxPho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/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7AA2B50A-BA46-2641-B2B9-3F1D81FCF7D9}"/>
                </a:ext>
              </a:extLst>
            </p:cNvPr>
            <p:cNvSpPr txBox="1"/>
            <p:nvPr/>
          </p:nvSpPr>
          <p:spPr>
            <a:xfrm>
              <a:off x="740565" y="561149"/>
              <a:ext cx="1704055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ham_C57BL/6J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OxPho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/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BF6965F2-9BEA-0347-8941-6926465DCFB9}"/>
                </a:ext>
              </a:extLst>
            </p:cNvPr>
            <p:cNvSpPr txBox="1"/>
            <p:nvPr/>
          </p:nvSpPr>
          <p:spPr>
            <a:xfrm>
              <a:off x="7496117" y="554246"/>
              <a:ext cx="1429555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LP_BALB/c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OxPho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/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8161839B-F492-EC48-A496-498C86CD77D5}"/>
                </a:ext>
              </a:extLst>
            </p:cNvPr>
            <p:cNvSpPr txBox="1"/>
            <p:nvPr/>
          </p:nvSpPr>
          <p:spPr>
            <a:xfrm>
              <a:off x="5259433" y="543601"/>
              <a:ext cx="1704055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ham_BALB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/c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OxPho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dirty="0"/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A7784C35-132E-1241-84F5-5CA9205E54B6}"/>
                </a:ext>
              </a:extLst>
            </p:cNvPr>
            <p:cNvSpPr txBox="1"/>
            <p:nvPr/>
          </p:nvSpPr>
          <p:spPr>
            <a:xfrm>
              <a:off x="25266" y="557197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FFB8024D-FEFB-4F43-967F-F286160B3879}"/>
                </a:ext>
              </a:extLst>
            </p:cNvPr>
            <p:cNvSpPr txBox="1"/>
            <p:nvPr/>
          </p:nvSpPr>
          <p:spPr>
            <a:xfrm>
              <a:off x="17636" y="3104369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B81DE3CD-E9A4-FD4E-AF91-941AE5382472}"/>
                </a:ext>
              </a:extLst>
            </p:cNvPr>
            <p:cNvSpPr txBox="1"/>
            <p:nvPr/>
          </p:nvSpPr>
          <p:spPr>
            <a:xfrm>
              <a:off x="24516" y="5396484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A93FCDCD-273B-4A4C-9F1E-89E94BC7DF94}"/>
                </a:ext>
              </a:extLst>
            </p:cNvPr>
            <p:cNvSpPr txBox="1"/>
            <p:nvPr/>
          </p:nvSpPr>
          <p:spPr>
            <a:xfrm>
              <a:off x="4548038" y="544666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278A4AAC-4D3A-6D49-9139-B8786FA7434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8420" y="1179152"/>
              <a:ext cx="4114800" cy="1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2D9B59B3-A081-814A-AF6C-34B88DA723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94438" y="1163343"/>
              <a:ext cx="4114800" cy="1"/>
            </a:xfrm>
            <a:prstGeom prst="line">
              <a:avLst/>
            </a:prstGeom>
            <a:ln w="952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7" name="Picture 136">
              <a:extLst>
                <a:ext uri="{FF2B5EF4-FFF2-40B4-BE49-F238E27FC236}">
                  <a16:creationId xmlns:a16="http://schemas.microsoft.com/office/drawing/2014/main" id="{49A13D35-A51A-4146-9BC3-73C9384BEE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352162" y="5390136"/>
              <a:ext cx="1231900" cy="1612900"/>
            </a:xfrm>
            <a:prstGeom prst="rect">
              <a:avLst/>
            </a:prstGeom>
          </p:spPr>
        </p:pic>
        <p:pic>
          <p:nvPicPr>
            <p:cNvPr id="138" name="Picture 137">
              <a:extLst>
                <a:ext uri="{FF2B5EF4-FFF2-40B4-BE49-F238E27FC236}">
                  <a16:creationId xmlns:a16="http://schemas.microsoft.com/office/drawing/2014/main" id="{3AC98B1A-C769-DC49-89CD-6756E6D1A2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652356" y="5392433"/>
              <a:ext cx="1231900" cy="1612900"/>
            </a:xfrm>
            <a:prstGeom prst="rect">
              <a:avLst/>
            </a:prstGeom>
          </p:spPr>
        </p:pic>
        <p:pic>
          <p:nvPicPr>
            <p:cNvPr id="140" name="Picture 139">
              <a:extLst>
                <a:ext uri="{FF2B5EF4-FFF2-40B4-BE49-F238E27FC236}">
                  <a16:creationId xmlns:a16="http://schemas.microsoft.com/office/drawing/2014/main" id="{488C60B9-E886-0F46-BCDB-38109BA3E5B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897423" y="5385569"/>
              <a:ext cx="1333500" cy="1612900"/>
            </a:xfrm>
            <a:prstGeom prst="rect">
              <a:avLst/>
            </a:prstGeom>
          </p:spPr>
        </p:pic>
        <p:pic>
          <p:nvPicPr>
            <p:cNvPr id="141" name="Picture 140">
              <a:extLst>
                <a:ext uri="{FF2B5EF4-FFF2-40B4-BE49-F238E27FC236}">
                  <a16:creationId xmlns:a16="http://schemas.microsoft.com/office/drawing/2014/main" id="{D7408B69-DC3D-0D4B-8070-3A89B309118C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192882" y="5383039"/>
              <a:ext cx="1333500" cy="1612900"/>
            </a:xfrm>
            <a:prstGeom prst="rect">
              <a:avLst/>
            </a:prstGeom>
          </p:spPr>
        </p:pic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778FFAB1-4EFE-9349-B913-3593480E5D74}"/>
                </a:ext>
              </a:extLst>
            </p:cNvPr>
            <p:cNvSpPr txBox="1"/>
            <p:nvPr/>
          </p:nvSpPr>
          <p:spPr>
            <a:xfrm>
              <a:off x="4538687" y="3097739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899C7DB2-B815-E645-8210-280BD7DA9105}"/>
                </a:ext>
              </a:extLst>
            </p:cNvPr>
            <p:cNvSpPr txBox="1"/>
            <p:nvPr/>
          </p:nvSpPr>
          <p:spPr>
            <a:xfrm>
              <a:off x="4529899" y="5390738"/>
              <a:ext cx="408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44" name="Rectangle 143">
              <a:extLst>
                <a:ext uri="{FF2B5EF4-FFF2-40B4-BE49-F238E27FC236}">
                  <a16:creationId xmlns:a16="http://schemas.microsoft.com/office/drawing/2014/main" id="{63D0D12B-BBFE-E94C-B6C1-AAEE975E3419}"/>
                </a:ext>
              </a:extLst>
            </p:cNvPr>
            <p:cNvSpPr/>
            <p:nvPr/>
          </p:nvSpPr>
          <p:spPr>
            <a:xfrm>
              <a:off x="4324096" y="774709"/>
              <a:ext cx="158839" cy="110450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5" name="Rectangle 144">
              <a:extLst>
                <a:ext uri="{FF2B5EF4-FFF2-40B4-BE49-F238E27FC236}">
                  <a16:creationId xmlns:a16="http://schemas.microsoft.com/office/drawing/2014/main" id="{4DCC1C83-D673-0E4C-BCAE-54AE33B94AA3}"/>
                </a:ext>
              </a:extLst>
            </p:cNvPr>
            <p:cNvSpPr/>
            <p:nvPr/>
          </p:nvSpPr>
          <p:spPr>
            <a:xfrm>
              <a:off x="3762493" y="776286"/>
              <a:ext cx="158839" cy="110450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E47C1583-23BC-914A-9B00-6C5B5BCAAB41}"/>
                </a:ext>
              </a:extLst>
            </p:cNvPr>
            <p:cNvSpPr/>
            <p:nvPr/>
          </p:nvSpPr>
          <p:spPr>
            <a:xfrm>
              <a:off x="4185101" y="776389"/>
              <a:ext cx="158839" cy="110450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4F70D0F2-4D5C-9849-A266-650A6B71D354}"/>
                </a:ext>
              </a:extLst>
            </p:cNvPr>
            <p:cNvSpPr/>
            <p:nvPr/>
          </p:nvSpPr>
          <p:spPr>
            <a:xfrm>
              <a:off x="8857405" y="706548"/>
              <a:ext cx="158839" cy="110450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8" name="Rectangle 147">
              <a:extLst>
                <a:ext uri="{FF2B5EF4-FFF2-40B4-BE49-F238E27FC236}">
                  <a16:creationId xmlns:a16="http://schemas.microsoft.com/office/drawing/2014/main" id="{360ED803-7812-9D49-B741-F1F566E50275}"/>
                </a:ext>
              </a:extLst>
            </p:cNvPr>
            <p:cNvSpPr/>
            <p:nvPr/>
          </p:nvSpPr>
          <p:spPr>
            <a:xfrm>
              <a:off x="8287264" y="719222"/>
              <a:ext cx="158839" cy="110450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CDE3978B-0B5D-8F46-B528-67EF6FCC7934}"/>
                </a:ext>
              </a:extLst>
            </p:cNvPr>
            <p:cNvSpPr/>
            <p:nvPr/>
          </p:nvSpPr>
          <p:spPr>
            <a:xfrm>
              <a:off x="8711423" y="706548"/>
              <a:ext cx="158839" cy="110450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91105023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C3E8660-BB8A-2087-A630-DCEC802DC734}"/>
              </a:ext>
            </a:extLst>
          </p:cNvPr>
          <p:cNvSpPr txBox="1"/>
          <p:nvPr/>
        </p:nvSpPr>
        <p:spPr>
          <a:xfrm>
            <a:off x="121088" y="118060"/>
            <a:ext cx="18504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4327B6B-2082-004F-D26F-82D10C4336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584" y="643890"/>
            <a:ext cx="7418832" cy="60274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31622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C3E8660-BB8A-2087-A630-DCEC802DC734}"/>
              </a:ext>
            </a:extLst>
          </p:cNvPr>
          <p:cNvSpPr txBox="1"/>
          <p:nvPr/>
        </p:nvSpPr>
        <p:spPr>
          <a:xfrm>
            <a:off x="121088" y="118060"/>
            <a:ext cx="18504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</a:p>
        </p:txBody>
      </p:sp>
      <p:pic>
        <p:nvPicPr>
          <p:cNvPr id="3" name="図 8">
            <a:extLst>
              <a:ext uri="{FF2B5EF4-FFF2-40B4-BE49-F238E27FC236}">
                <a16:creationId xmlns:a16="http://schemas.microsoft.com/office/drawing/2014/main" id="{DFABEE9B-9963-98BB-470E-6AA8A7CA81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5620" y="1225124"/>
            <a:ext cx="6438900" cy="5842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13698A3-A6C2-6E5D-7F5F-6207508F0156}"/>
              </a:ext>
            </a:extLst>
          </p:cNvPr>
          <p:cNvSpPr txBox="1"/>
          <p:nvPr/>
        </p:nvSpPr>
        <p:spPr>
          <a:xfrm>
            <a:off x="958149" y="1836279"/>
            <a:ext cx="827471" cy="39857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luster 8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luster 11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luster 1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790E254-11BD-F403-23AE-F14D9654A4BB}"/>
              </a:ext>
            </a:extLst>
          </p:cNvPr>
          <p:cNvSpPr txBox="1"/>
          <p:nvPr/>
        </p:nvSpPr>
        <p:spPr>
          <a:xfrm>
            <a:off x="2318878" y="874340"/>
            <a:ext cx="57403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err="1"/>
              <a:t>Elane</a:t>
            </a:r>
            <a:r>
              <a:rPr lang="en-US" sz="1200" b="1" i="1" dirty="0"/>
              <a:t>                                         Prtn3                                        Lcn2                                       </a:t>
            </a:r>
            <a:r>
              <a:rPr lang="en-US" sz="1200" b="1" i="1" dirty="0" err="1"/>
              <a:t>Fcnb</a:t>
            </a:r>
            <a:endParaRPr lang="en-US" sz="1200" b="1" i="1" dirty="0"/>
          </a:p>
        </p:txBody>
      </p:sp>
    </p:spTree>
    <p:extLst>
      <p:ext uri="{BB962C8B-B14F-4D97-AF65-F5344CB8AC3E}">
        <p14:creationId xmlns:p14="http://schemas.microsoft.com/office/powerpoint/2010/main" val="1401199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69</TotalTime>
  <Words>700</Words>
  <Application>Microsoft Office PowerPoint</Application>
  <PresentationFormat>Custom</PresentationFormat>
  <Paragraphs>490</Paragraphs>
  <Slides>9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3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Office Theme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akshi Rana</dc:creator>
  <cp:lastModifiedBy>Sherry, Barbara</cp:lastModifiedBy>
  <cp:revision>78</cp:revision>
  <cp:lastPrinted>2024-07-17T17:51:39Z</cp:lastPrinted>
  <dcterms:created xsi:type="dcterms:W3CDTF">2021-03-05T19:16:09Z</dcterms:created>
  <dcterms:modified xsi:type="dcterms:W3CDTF">2024-07-22T19:09:44Z</dcterms:modified>
</cp:coreProperties>
</file>